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416" r:id="rId2"/>
    <p:sldId id="419" r:id="rId3"/>
    <p:sldId id="420" r:id="rId4"/>
    <p:sldId id="417" r:id="rId5"/>
    <p:sldId id="418" r:id="rId6"/>
    <p:sldId id="421" r:id="rId7"/>
  </p:sldIdLst>
  <p:sldSz cx="7581900" cy="99361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4" userDrawn="1">
          <p15:clr>
            <a:srgbClr val="A4A3A4"/>
          </p15:clr>
        </p15:guide>
        <p15:guide id="2" pos="236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initha Ragavan" initials="VR" lastIdx="1" clrIdx="0">
    <p:extLst>
      <p:ext uri="{19B8F6BF-5375-455C-9EA6-DF929625EA0E}">
        <p15:presenceInfo xmlns:p15="http://schemas.microsoft.com/office/powerpoint/2012/main" userId="ef420ed241107ea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F5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06" autoAdjust="0"/>
    <p:restoredTop sz="95226" autoAdjust="0"/>
  </p:normalViewPr>
  <p:slideViewPr>
    <p:cSldViewPr snapToGrid="0">
      <p:cViewPr>
        <p:scale>
          <a:sx n="157" d="100"/>
          <a:sy n="157" d="100"/>
        </p:scale>
        <p:origin x="-408" y="-3333"/>
      </p:cViewPr>
      <p:guideLst>
        <p:guide orient="horz" pos="2494"/>
        <p:guide pos="236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453"/>
    </p:cViewPr>
  </p:sorter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95F7EF-F145-433B-94C1-CE92DE1A3FF7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2252663" y="1143000"/>
            <a:ext cx="23526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AD6C21-52C1-45F7-81FE-7680BFA2F64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67180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45363" rtl="0" eaLnBrk="1" latinLnBrk="0" hangingPunct="1">
      <a:defRPr sz="1109" kern="1200">
        <a:solidFill>
          <a:schemeClr val="tx1"/>
        </a:solidFill>
        <a:latin typeface="+mn-lt"/>
        <a:ea typeface="+mn-ea"/>
        <a:cs typeface="+mn-cs"/>
      </a:defRPr>
    </a:lvl1pPr>
    <a:lvl2pPr marL="422681" algn="l" defTabSz="845363" rtl="0" eaLnBrk="1" latinLnBrk="0" hangingPunct="1">
      <a:defRPr sz="1109" kern="1200">
        <a:solidFill>
          <a:schemeClr val="tx1"/>
        </a:solidFill>
        <a:latin typeface="+mn-lt"/>
        <a:ea typeface="+mn-ea"/>
        <a:cs typeface="+mn-cs"/>
      </a:defRPr>
    </a:lvl2pPr>
    <a:lvl3pPr marL="845363" algn="l" defTabSz="845363" rtl="0" eaLnBrk="1" latinLnBrk="0" hangingPunct="1">
      <a:defRPr sz="1109" kern="1200">
        <a:solidFill>
          <a:schemeClr val="tx1"/>
        </a:solidFill>
        <a:latin typeface="+mn-lt"/>
        <a:ea typeface="+mn-ea"/>
        <a:cs typeface="+mn-cs"/>
      </a:defRPr>
    </a:lvl3pPr>
    <a:lvl4pPr marL="1268044" algn="l" defTabSz="845363" rtl="0" eaLnBrk="1" latinLnBrk="0" hangingPunct="1">
      <a:defRPr sz="1109" kern="1200">
        <a:solidFill>
          <a:schemeClr val="tx1"/>
        </a:solidFill>
        <a:latin typeface="+mn-lt"/>
        <a:ea typeface="+mn-ea"/>
        <a:cs typeface="+mn-cs"/>
      </a:defRPr>
    </a:lvl4pPr>
    <a:lvl5pPr marL="1690726" algn="l" defTabSz="845363" rtl="0" eaLnBrk="1" latinLnBrk="0" hangingPunct="1">
      <a:defRPr sz="1109" kern="1200">
        <a:solidFill>
          <a:schemeClr val="tx1"/>
        </a:solidFill>
        <a:latin typeface="+mn-lt"/>
        <a:ea typeface="+mn-ea"/>
        <a:cs typeface="+mn-cs"/>
      </a:defRPr>
    </a:lvl5pPr>
    <a:lvl6pPr marL="2113407" algn="l" defTabSz="845363" rtl="0" eaLnBrk="1" latinLnBrk="0" hangingPunct="1">
      <a:defRPr sz="1109" kern="1200">
        <a:solidFill>
          <a:schemeClr val="tx1"/>
        </a:solidFill>
        <a:latin typeface="+mn-lt"/>
        <a:ea typeface="+mn-ea"/>
        <a:cs typeface="+mn-cs"/>
      </a:defRPr>
    </a:lvl6pPr>
    <a:lvl7pPr marL="2536088" algn="l" defTabSz="845363" rtl="0" eaLnBrk="1" latinLnBrk="0" hangingPunct="1">
      <a:defRPr sz="1109" kern="1200">
        <a:solidFill>
          <a:schemeClr val="tx1"/>
        </a:solidFill>
        <a:latin typeface="+mn-lt"/>
        <a:ea typeface="+mn-ea"/>
        <a:cs typeface="+mn-cs"/>
      </a:defRPr>
    </a:lvl7pPr>
    <a:lvl8pPr marL="2958770" algn="l" defTabSz="845363" rtl="0" eaLnBrk="1" latinLnBrk="0" hangingPunct="1">
      <a:defRPr sz="1109" kern="1200">
        <a:solidFill>
          <a:schemeClr val="tx1"/>
        </a:solidFill>
        <a:latin typeface="+mn-lt"/>
        <a:ea typeface="+mn-ea"/>
        <a:cs typeface="+mn-cs"/>
      </a:defRPr>
    </a:lvl8pPr>
    <a:lvl9pPr marL="3381451" algn="l" defTabSz="845363" rtl="0" eaLnBrk="1" latinLnBrk="0" hangingPunct="1">
      <a:defRPr sz="110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8643" y="1626127"/>
            <a:ext cx="6444615" cy="3459257"/>
          </a:xfrm>
        </p:spPr>
        <p:txBody>
          <a:bodyPr anchor="b"/>
          <a:lstStyle>
            <a:lvl1pPr algn="ctr">
              <a:defRPr sz="49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7738" y="5218786"/>
            <a:ext cx="5686425" cy="2398939"/>
          </a:xfrm>
        </p:spPr>
        <p:txBody>
          <a:bodyPr/>
          <a:lstStyle>
            <a:lvl1pPr marL="0" indent="0" algn="ctr">
              <a:buNone/>
              <a:defRPr sz="1990"/>
            </a:lvl1pPr>
            <a:lvl2pPr marL="379110" indent="0" algn="ctr">
              <a:buNone/>
              <a:defRPr sz="1658"/>
            </a:lvl2pPr>
            <a:lvl3pPr marL="758220" indent="0" algn="ctr">
              <a:buNone/>
              <a:defRPr sz="1493"/>
            </a:lvl3pPr>
            <a:lvl4pPr marL="1137331" indent="0" algn="ctr">
              <a:buNone/>
              <a:defRPr sz="1327"/>
            </a:lvl4pPr>
            <a:lvl5pPr marL="1516441" indent="0" algn="ctr">
              <a:buNone/>
              <a:defRPr sz="1327"/>
            </a:lvl5pPr>
            <a:lvl6pPr marL="1895551" indent="0" algn="ctr">
              <a:buNone/>
              <a:defRPr sz="1327"/>
            </a:lvl6pPr>
            <a:lvl7pPr marL="2274661" indent="0" algn="ctr">
              <a:buNone/>
              <a:defRPr sz="1327"/>
            </a:lvl7pPr>
            <a:lvl8pPr marL="2653772" indent="0" algn="ctr">
              <a:buNone/>
              <a:defRPr sz="1327"/>
            </a:lvl8pPr>
            <a:lvl9pPr marL="3032882" indent="0" algn="ctr">
              <a:buNone/>
              <a:defRPr sz="132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82544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86695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25798" y="529009"/>
            <a:ext cx="1634847" cy="842043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256" y="529009"/>
            <a:ext cx="4809768" cy="842043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24044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4343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307" y="2477144"/>
            <a:ext cx="6539389" cy="4133167"/>
          </a:xfrm>
        </p:spPr>
        <p:txBody>
          <a:bodyPr anchor="b"/>
          <a:lstStyle>
            <a:lvl1pPr>
              <a:defRPr sz="49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307" y="6649412"/>
            <a:ext cx="6539389" cy="2173535"/>
          </a:xfrm>
        </p:spPr>
        <p:txBody>
          <a:bodyPr/>
          <a:lstStyle>
            <a:lvl1pPr marL="0" indent="0">
              <a:buNone/>
              <a:defRPr sz="1990">
                <a:solidFill>
                  <a:schemeClr val="tx1"/>
                </a:solidFill>
              </a:defRPr>
            </a:lvl1pPr>
            <a:lvl2pPr marL="379110" indent="0">
              <a:buNone/>
              <a:defRPr sz="1658">
                <a:solidFill>
                  <a:schemeClr val="tx1">
                    <a:tint val="75000"/>
                  </a:schemeClr>
                </a:solidFill>
              </a:defRPr>
            </a:lvl2pPr>
            <a:lvl3pPr marL="758220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3pPr>
            <a:lvl4pPr marL="1137331" indent="0">
              <a:buNone/>
              <a:defRPr sz="1327">
                <a:solidFill>
                  <a:schemeClr val="tx1">
                    <a:tint val="75000"/>
                  </a:schemeClr>
                </a:solidFill>
              </a:defRPr>
            </a:lvl4pPr>
            <a:lvl5pPr marL="1516441" indent="0">
              <a:buNone/>
              <a:defRPr sz="1327">
                <a:solidFill>
                  <a:schemeClr val="tx1">
                    <a:tint val="75000"/>
                  </a:schemeClr>
                </a:solidFill>
              </a:defRPr>
            </a:lvl5pPr>
            <a:lvl6pPr marL="1895551" indent="0">
              <a:buNone/>
              <a:defRPr sz="1327">
                <a:solidFill>
                  <a:schemeClr val="tx1">
                    <a:tint val="75000"/>
                  </a:schemeClr>
                </a:solidFill>
              </a:defRPr>
            </a:lvl6pPr>
            <a:lvl7pPr marL="2274661" indent="0">
              <a:buNone/>
              <a:defRPr sz="1327">
                <a:solidFill>
                  <a:schemeClr val="tx1">
                    <a:tint val="75000"/>
                  </a:schemeClr>
                </a:solidFill>
              </a:defRPr>
            </a:lvl7pPr>
            <a:lvl8pPr marL="2653772" indent="0">
              <a:buNone/>
              <a:defRPr sz="1327">
                <a:solidFill>
                  <a:schemeClr val="tx1">
                    <a:tint val="75000"/>
                  </a:schemeClr>
                </a:solidFill>
              </a:defRPr>
            </a:lvl8pPr>
            <a:lvl9pPr marL="3032882" indent="0">
              <a:buNone/>
              <a:defRPr sz="132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2176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255" y="2645043"/>
            <a:ext cx="3222308" cy="63044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8337" y="2645043"/>
            <a:ext cx="3222308" cy="63044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26022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243" y="529011"/>
            <a:ext cx="6539389" cy="19205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244" y="2435741"/>
            <a:ext cx="3207499" cy="1193719"/>
          </a:xfrm>
        </p:spPr>
        <p:txBody>
          <a:bodyPr anchor="b"/>
          <a:lstStyle>
            <a:lvl1pPr marL="0" indent="0">
              <a:buNone/>
              <a:defRPr sz="1990" b="1"/>
            </a:lvl1pPr>
            <a:lvl2pPr marL="379110" indent="0">
              <a:buNone/>
              <a:defRPr sz="1658" b="1"/>
            </a:lvl2pPr>
            <a:lvl3pPr marL="758220" indent="0">
              <a:buNone/>
              <a:defRPr sz="1493" b="1"/>
            </a:lvl3pPr>
            <a:lvl4pPr marL="1137331" indent="0">
              <a:buNone/>
              <a:defRPr sz="1327" b="1"/>
            </a:lvl4pPr>
            <a:lvl5pPr marL="1516441" indent="0">
              <a:buNone/>
              <a:defRPr sz="1327" b="1"/>
            </a:lvl5pPr>
            <a:lvl6pPr marL="1895551" indent="0">
              <a:buNone/>
              <a:defRPr sz="1327" b="1"/>
            </a:lvl6pPr>
            <a:lvl7pPr marL="2274661" indent="0">
              <a:buNone/>
              <a:defRPr sz="1327" b="1"/>
            </a:lvl7pPr>
            <a:lvl8pPr marL="2653772" indent="0">
              <a:buNone/>
              <a:defRPr sz="1327" b="1"/>
            </a:lvl8pPr>
            <a:lvl9pPr marL="3032882" indent="0">
              <a:buNone/>
              <a:defRPr sz="132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244" y="3629460"/>
            <a:ext cx="3207499" cy="53383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38337" y="2435741"/>
            <a:ext cx="3223295" cy="1193719"/>
          </a:xfrm>
        </p:spPr>
        <p:txBody>
          <a:bodyPr anchor="b"/>
          <a:lstStyle>
            <a:lvl1pPr marL="0" indent="0">
              <a:buNone/>
              <a:defRPr sz="1990" b="1"/>
            </a:lvl1pPr>
            <a:lvl2pPr marL="379110" indent="0">
              <a:buNone/>
              <a:defRPr sz="1658" b="1"/>
            </a:lvl2pPr>
            <a:lvl3pPr marL="758220" indent="0">
              <a:buNone/>
              <a:defRPr sz="1493" b="1"/>
            </a:lvl3pPr>
            <a:lvl4pPr marL="1137331" indent="0">
              <a:buNone/>
              <a:defRPr sz="1327" b="1"/>
            </a:lvl4pPr>
            <a:lvl5pPr marL="1516441" indent="0">
              <a:buNone/>
              <a:defRPr sz="1327" b="1"/>
            </a:lvl5pPr>
            <a:lvl6pPr marL="1895551" indent="0">
              <a:buNone/>
              <a:defRPr sz="1327" b="1"/>
            </a:lvl6pPr>
            <a:lvl7pPr marL="2274661" indent="0">
              <a:buNone/>
              <a:defRPr sz="1327" b="1"/>
            </a:lvl7pPr>
            <a:lvl8pPr marL="2653772" indent="0">
              <a:buNone/>
              <a:defRPr sz="1327" b="1"/>
            </a:lvl8pPr>
            <a:lvl9pPr marL="3032882" indent="0">
              <a:buNone/>
              <a:defRPr sz="132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38337" y="3629460"/>
            <a:ext cx="3223295" cy="53383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23936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37002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23605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243" y="662411"/>
            <a:ext cx="2445360" cy="2318438"/>
          </a:xfrm>
        </p:spPr>
        <p:txBody>
          <a:bodyPr anchor="b"/>
          <a:lstStyle>
            <a:lvl1pPr>
              <a:defRPr sz="26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3295" y="1430626"/>
            <a:ext cx="3838337" cy="7061116"/>
          </a:xfrm>
        </p:spPr>
        <p:txBody>
          <a:bodyPr/>
          <a:lstStyle>
            <a:lvl1pPr>
              <a:defRPr sz="2653"/>
            </a:lvl1pPr>
            <a:lvl2pPr>
              <a:defRPr sz="2322"/>
            </a:lvl2pPr>
            <a:lvl3pPr>
              <a:defRPr sz="1990"/>
            </a:lvl3pPr>
            <a:lvl4pPr>
              <a:defRPr sz="1658"/>
            </a:lvl4pPr>
            <a:lvl5pPr>
              <a:defRPr sz="1658"/>
            </a:lvl5pPr>
            <a:lvl6pPr>
              <a:defRPr sz="1658"/>
            </a:lvl6pPr>
            <a:lvl7pPr>
              <a:defRPr sz="1658"/>
            </a:lvl7pPr>
            <a:lvl8pPr>
              <a:defRPr sz="1658"/>
            </a:lvl8pPr>
            <a:lvl9pPr>
              <a:defRPr sz="165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243" y="2980849"/>
            <a:ext cx="2445360" cy="5522391"/>
          </a:xfrm>
        </p:spPr>
        <p:txBody>
          <a:bodyPr/>
          <a:lstStyle>
            <a:lvl1pPr marL="0" indent="0">
              <a:buNone/>
              <a:defRPr sz="1327"/>
            </a:lvl1pPr>
            <a:lvl2pPr marL="379110" indent="0">
              <a:buNone/>
              <a:defRPr sz="1161"/>
            </a:lvl2pPr>
            <a:lvl3pPr marL="758220" indent="0">
              <a:buNone/>
              <a:defRPr sz="995"/>
            </a:lvl3pPr>
            <a:lvl4pPr marL="1137331" indent="0">
              <a:buNone/>
              <a:defRPr sz="829"/>
            </a:lvl4pPr>
            <a:lvl5pPr marL="1516441" indent="0">
              <a:buNone/>
              <a:defRPr sz="829"/>
            </a:lvl5pPr>
            <a:lvl6pPr marL="1895551" indent="0">
              <a:buNone/>
              <a:defRPr sz="829"/>
            </a:lvl6pPr>
            <a:lvl7pPr marL="2274661" indent="0">
              <a:buNone/>
              <a:defRPr sz="829"/>
            </a:lvl7pPr>
            <a:lvl8pPr marL="2653772" indent="0">
              <a:buNone/>
              <a:defRPr sz="829"/>
            </a:lvl8pPr>
            <a:lvl9pPr marL="3032882" indent="0">
              <a:buNone/>
              <a:defRPr sz="82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33736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243" y="662411"/>
            <a:ext cx="2445360" cy="2318438"/>
          </a:xfrm>
        </p:spPr>
        <p:txBody>
          <a:bodyPr anchor="b"/>
          <a:lstStyle>
            <a:lvl1pPr>
              <a:defRPr sz="26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3295" y="1430626"/>
            <a:ext cx="3838337" cy="7061116"/>
          </a:xfrm>
        </p:spPr>
        <p:txBody>
          <a:bodyPr anchor="t"/>
          <a:lstStyle>
            <a:lvl1pPr marL="0" indent="0">
              <a:buNone/>
              <a:defRPr sz="2653"/>
            </a:lvl1pPr>
            <a:lvl2pPr marL="379110" indent="0">
              <a:buNone/>
              <a:defRPr sz="2322"/>
            </a:lvl2pPr>
            <a:lvl3pPr marL="758220" indent="0">
              <a:buNone/>
              <a:defRPr sz="1990"/>
            </a:lvl3pPr>
            <a:lvl4pPr marL="1137331" indent="0">
              <a:buNone/>
              <a:defRPr sz="1658"/>
            </a:lvl4pPr>
            <a:lvl5pPr marL="1516441" indent="0">
              <a:buNone/>
              <a:defRPr sz="1658"/>
            </a:lvl5pPr>
            <a:lvl6pPr marL="1895551" indent="0">
              <a:buNone/>
              <a:defRPr sz="1658"/>
            </a:lvl6pPr>
            <a:lvl7pPr marL="2274661" indent="0">
              <a:buNone/>
              <a:defRPr sz="1658"/>
            </a:lvl7pPr>
            <a:lvl8pPr marL="2653772" indent="0">
              <a:buNone/>
              <a:defRPr sz="1658"/>
            </a:lvl8pPr>
            <a:lvl9pPr marL="3032882" indent="0">
              <a:buNone/>
              <a:defRPr sz="165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243" y="2980849"/>
            <a:ext cx="2445360" cy="5522391"/>
          </a:xfrm>
        </p:spPr>
        <p:txBody>
          <a:bodyPr/>
          <a:lstStyle>
            <a:lvl1pPr marL="0" indent="0">
              <a:buNone/>
              <a:defRPr sz="1327"/>
            </a:lvl1pPr>
            <a:lvl2pPr marL="379110" indent="0">
              <a:buNone/>
              <a:defRPr sz="1161"/>
            </a:lvl2pPr>
            <a:lvl3pPr marL="758220" indent="0">
              <a:buNone/>
              <a:defRPr sz="995"/>
            </a:lvl3pPr>
            <a:lvl4pPr marL="1137331" indent="0">
              <a:buNone/>
              <a:defRPr sz="829"/>
            </a:lvl4pPr>
            <a:lvl5pPr marL="1516441" indent="0">
              <a:buNone/>
              <a:defRPr sz="829"/>
            </a:lvl5pPr>
            <a:lvl6pPr marL="1895551" indent="0">
              <a:buNone/>
              <a:defRPr sz="829"/>
            </a:lvl6pPr>
            <a:lvl7pPr marL="2274661" indent="0">
              <a:buNone/>
              <a:defRPr sz="829"/>
            </a:lvl7pPr>
            <a:lvl8pPr marL="2653772" indent="0">
              <a:buNone/>
              <a:defRPr sz="829"/>
            </a:lvl8pPr>
            <a:lvl9pPr marL="3032882" indent="0">
              <a:buNone/>
              <a:defRPr sz="82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86327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256" y="529011"/>
            <a:ext cx="6539389" cy="1920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256" y="2645043"/>
            <a:ext cx="6539389" cy="63044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255" y="9209353"/>
            <a:ext cx="1705928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54F8B-A46D-457A-81F2-A38F01BDB65B}" type="datetimeFigureOut">
              <a:rPr lang="ru-RU" smtClean="0"/>
              <a:t>13.04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1505" y="9209353"/>
            <a:ext cx="2558891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54717" y="9209353"/>
            <a:ext cx="1705928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A9F28-277A-4DF2-AC1E-E9B97A9DD74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69811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8220" rtl="0" eaLnBrk="1" latinLnBrk="0" hangingPunct="1">
        <a:lnSpc>
          <a:spcPct val="90000"/>
        </a:lnSpc>
        <a:spcBef>
          <a:spcPct val="0"/>
        </a:spcBef>
        <a:buNone/>
        <a:defRPr sz="364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555" indent="-189555" algn="l" defTabSz="758220" rtl="0" eaLnBrk="1" latinLnBrk="0" hangingPunct="1">
        <a:lnSpc>
          <a:spcPct val="90000"/>
        </a:lnSpc>
        <a:spcBef>
          <a:spcPts val="829"/>
        </a:spcBef>
        <a:buFont typeface="Arial" panose="020B0604020202020204" pitchFamily="34" charset="0"/>
        <a:buChar char="•"/>
        <a:defRPr sz="2322" kern="1200">
          <a:solidFill>
            <a:schemeClr val="tx1"/>
          </a:solidFill>
          <a:latin typeface="+mn-lt"/>
          <a:ea typeface="+mn-ea"/>
          <a:cs typeface="+mn-cs"/>
        </a:defRPr>
      </a:lvl1pPr>
      <a:lvl2pPr marL="568665" indent="-189555" algn="l" defTabSz="75822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90" kern="1200">
          <a:solidFill>
            <a:schemeClr val="tx1"/>
          </a:solidFill>
          <a:latin typeface="+mn-lt"/>
          <a:ea typeface="+mn-ea"/>
          <a:cs typeface="+mn-cs"/>
        </a:defRPr>
      </a:lvl2pPr>
      <a:lvl3pPr marL="947776" indent="-189555" algn="l" defTabSz="75822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58" kern="1200">
          <a:solidFill>
            <a:schemeClr val="tx1"/>
          </a:solidFill>
          <a:latin typeface="+mn-lt"/>
          <a:ea typeface="+mn-ea"/>
          <a:cs typeface="+mn-cs"/>
        </a:defRPr>
      </a:lvl3pPr>
      <a:lvl4pPr marL="1326886" indent="-189555" algn="l" defTabSz="75822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3" kern="1200">
          <a:solidFill>
            <a:schemeClr val="tx1"/>
          </a:solidFill>
          <a:latin typeface="+mn-lt"/>
          <a:ea typeface="+mn-ea"/>
          <a:cs typeface="+mn-cs"/>
        </a:defRPr>
      </a:lvl4pPr>
      <a:lvl5pPr marL="1705996" indent="-189555" algn="l" defTabSz="75822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3" kern="1200">
          <a:solidFill>
            <a:schemeClr val="tx1"/>
          </a:solidFill>
          <a:latin typeface="+mn-lt"/>
          <a:ea typeface="+mn-ea"/>
          <a:cs typeface="+mn-cs"/>
        </a:defRPr>
      </a:lvl5pPr>
      <a:lvl6pPr marL="2085106" indent="-189555" algn="l" defTabSz="75822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3" kern="1200">
          <a:solidFill>
            <a:schemeClr val="tx1"/>
          </a:solidFill>
          <a:latin typeface="+mn-lt"/>
          <a:ea typeface="+mn-ea"/>
          <a:cs typeface="+mn-cs"/>
        </a:defRPr>
      </a:lvl6pPr>
      <a:lvl7pPr marL="2464217" indent="-189555" algn="l" defTabSz="75822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3" kern="1200">
          <a:solidFill>
            <a:schemeClr val="tx1"/>
          </a:solidFill>
          <a:latin typeface="+mn-lt"/>
          <a:ea typeface="+mn-ea"/>
          <a:cs typeface="+mn-cs"/>
        </a:defRPr>
      </a:lvl7pPr>
      <a:lvl8pPr marL="2843327" indent="-189555" algn="l" defTabSz="75822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3" kern="1200">
          <a:solidFill>
            <a:schemeClr val="tx1"/>
          </a:solidFill>
          <a:latin typeface="+mn-lt"/>
          <a:ea typeface="+mn-ea"/>
          <a:cs typeface="+mn-cs"/>
        </a:defRPr>
      </a:lvl8pPr>
      <a:lvl9pPr marL="3222437" indent="-189555" algn="l" defTabSz="75822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8220" rtl="0" eaLnBrk="1" latinLnBrk="0" hangingPunct="1">
        <a:defRPr sz="1493" kern="1200">
          <a:solidFill>
            <a:schemeClr val="tx1"/>
          </a:solidFill>
          <a:latin typeface="+mn-lt"/>
          <a:ea typeface="+mn-ea"/>
          <a:cs typeface="+mn-cs"/>
        </a:defRPr>
      </a:lvl1pPr>
      <a:lvl2pPr marL="379110" algn="l" defTabSz="758220" rtl="0" eaLnBrk="1" latinLnBrk="0" hangingPunct="1">
        <a:defRPr sz="1493" kern="1200">
          <a:solidFill>
            <a:schemeClr val="tx1"/>
          </a:solidFill>
          <a:latin typeface="+mn-lt"/>
          <a:ea typeface="+mn-ea"/>
          <a:cs typeface="+mn-cs"/>
        </a:defRPr>
      </a:lvl2pPr>
      <a:lvl3pPr marL="758220" algn="l" defTabSz="758220" rtl="0" eaLnBrk="1" latinLnBrk="0" hangingPunct="1">
        <a:defRPr sz="1493" kern="1200">
          <a:solidFill>
            <a:schemeClr val="tx1"/>
          </a:solidFill>
          <a:latin typeface="+mn-lt"/>
          <a:ea typeface="+mn-ea"/>
          <a:cs typeface="+mn-cs"/>
        </a:defRPr>
      </a:lvl3pPr>
      <a:lvl4pPr marL="1137331" algn="l" defTabSz="758220" rtl="0" eaLnBrk="1" latinLnBrk="0" hangingPunct="1">
        <a:defRPr sz="1493" kern="1200">
          <a:solidFill>
            <a:schemeClr val="tx1"/>
          </a:solidFill>
          <a:latin typeface="+mn-lt"/>
          <a:ea typeface="+mn-ea"/>
          <a:cs typeface="+mn-cs"/>
        </a:defRPr>
      </a:lvl4pPr>
      <a:lvl5pPr marL="1516441" algn="l" defTabSz="758220" rtl="0" eaLnBrk="1" latinLnBrk="0" hangingPunct="1">
        <a:defRPr sz="1493" kern="1200">
          <a:solidFill>
            <a:schemeClr val="tx1"/>
          </a:solidFill>
          <a:latin typeface="+mn-lt"/>
          <a:ea typeface="+mn-ea"/>
          <a:cs typeface="+mn-cs"/>
        </a:defRPr>
      </a:lvl5pPr>
      <a:lvl6pPr marL="1895551" algn="l" defTabSz="758220" rtl="0" eaLnBrk="1" latinLnBrk="0" hangingPunct="1">
        <a:defRPr sz="1493" kern="1200">
          <a:solidFill>
            <a:schemeClr val="tx1"/>
          </a:solidFill>
          <a:latin typeface="+mn-lt"/>
          <a:ea typeface="+mn-ea"/>
          <a:cs typeface="+mn-cs"/>
        </a:defRPr>
      </a:lvl6pPr>
      <a:lvl7pPr marL="2274661" algn="l" defTabSz="758220" rtl="0" eaLnBrk="1" latinLnBrk="0" hangingPunct="1">
        <a:defRPr sz="1493" kern="1200">
          <a:solidFill>
            <a:schemeClr val="tx1"/>
          </a:solidFill>
          <a:latin typeface="+mn-lt"/>
          <a:ea typeface="+mn-ea"/>
          <a:cs typeface="+mn-cs"/>
        </a:defRPr>
      </a:lvl7pPr>
      <a:lvl8pPr marL="2653772" algn="l" defTabSz="758220" rtl="0" eaLnBrk="1" latinLnBrk="0" hangingPunct="1">
        <a:defRPr sz="1493" kern="1200">
          <a:solidFill>
            <a:schemeClr val="tx1"/>
          </a:solidFill>
          <a:latin typeface="+mn-lt"/>
          <a:ea typeface="+mn-ea"/>
          <a:cs typeface="+mn-cs"/>
        </a:defRPr>
      </a:lvl8pPr>
      <a:lvl9pPr marL="3032882" algn="l" defTabSz="758220" rtl="0" eaLnBrk="1" latinLnBrk="0" hangingPunct="1">
        <a:defRPr sz="149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tiff"/><Relationship Id="rId4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1.wmf"/><Relationship Id="rId7" Type="http://schemas.openxmlformats.org/officeDocument/2006/relationships/image" Target="../media/image13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2.w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14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7" Type="http://schemas.openxmlformats.org/officeDocument/2006/relationships/image" Target="../media/image24.jpeg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tiff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TextBox 148">
            <a:extLst>
              <a:ext uri="{FF2B5EF4-FFF2-40B4-BE49-F238E27FC236}">
                <a16:creationId xmlns:a16="http://schemas.microsoft.com/office/drawing/2014/main" id="{26CC4A47-1DDA-ECFF-4620-2CCABD9D31F5}"/>
              </a:ext>
            </a:extLst>
          </p:cNvPr>
          <p:cNvSpPr txBox="1"/>
          <p:nvPr/>
        </p:nvSpPr>
        <p:spPr>
          <a:xfrm>
            <a:off x="3149789" y="1679774"/>
            <a:ext cx="1282323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93465" indent="-193465">
              <a:buAutoNum type="arabicPeriod"/>
            </a:pP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5 µg </a:t>
            </a:r>
            <a:r>
              <a:rPr lang="en-GB" sz="7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Hek</a:t>
            </a: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 WT</a:t>
            </a:r>
          </a:p>
          <a:p>
            <a:pPr marL="193465" indent="-193465">
              <a:buAutoNum type="arabicPeriod"/>
            </a:pP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50 µg </a:t>
            </a:r>
            <a:r>
              <a:rPr lang="en-GB" sz="7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Hek</a:t>
            </a: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 WT</a:t>
            </a:r>
          </a:p>
          <a:p>
            <a:pPr marL="193465" indent="-193465">
              <a:buAutoNum type="arabicPeriod"/>
            </a:pP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5 µg </a:t>
            </a:r>
            <a:r>
              <a:rPr lang="en-GB" sz="7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Hek</a:t>
            </a: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 DDAH2 Flag</a:t>
            </a:r>
          </a:p>
          <a:p>
            <a:pPr marL="193465" indent="-193465">
              <a:buAutoNum type="arabicPeriod"/>
            </a:pP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50 µg </a:t>
            </a:r>
            <a:r>
              <a:rPr lang="en-GB" sz="7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Hek</a:t>
            </a: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 DDAH2 Flag</a:t>
            </a:r>
          </a:p>
          <a:p>
            <a:pPr marL="193465" indent="-193465">
              <a:buAutoNum type="arabicPeriod"/>
            </a:pP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5 µg </a:t>
            </a:r>
            <a:r>
              <a:rPr lang="en-GB" sz="7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Hek</a:t>
            </a: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 DDAH1 Flag</a:t>
            </a:r>
          </a:p>
          <a:p>
            <a:pPr marL="193465" indent="-193465">
              <a:buAutoNum type="arabicPeriod"/>
            </a:pP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50 µg </a:t>
            </a:r>
            <a:r>
              <a:rPr lang="en-GB" sz="7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Hek</a:t>
            </a:r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 DDAH1 Fla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1585291-A228-87AD-2D6A-1F4BD9E1FCB0}"/>
              </a:ext>
            </a:extLst>
          </p:cNvPr>
          <p:cNvSpPr txBox="1"/>
          <p:nvPr/>
        </p:nvSpPr>
        <p:spPr>
          <a:xfrm>
            <a:off x="584068" y="956912"/>
            <a:ext cx="6443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EFCD1E3-D5D5-7A8A-C087-62A162E8AD02}"/>
              </a:ext>
            </a:extLst>
          </p:cNvPr>
          <p:cNvSpPr txBox="1"/>
          <p:nvPr/>
        </p:nvSpPr>
        <p:spPr>
          <a:xfrm>
            <a:off x="935036" y="7528743"/>
            <a:ext cx="39567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bodies: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α-tubulin, T5168 – Sigma Aldrich, 1:5000 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1, monoclonal antibody previously described in Reference 89, 1:5000 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2, STJ28540 - St. John’s Laboratory, 1:100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" name="Group 58">
            <a:extLst>
              <a:ext uri="{FF2B5EF4-FFF2-40B4-BE49-F238E27FC236}">
                <a16:creationId xmlns:a16="http://schemas.microsoft.com/office/drawing/2014/main" id="{7026E130-EEBF-5888-5E8A-E7F4ACDB086B}"/>
              </a:ext>
            </a:extLst>
          </p:cNvPr>
          <p:cNvGrpSpPr/>
          <p:nvPr/>
        </p:nvGrpSpPr>
        <p:grpSpPr>
          <a:xfrm>
            <a:off x="530257" y="3188195"/>
            <a:ext cx="6521387" cy="3559773"/>
            <a:chOff x="529684" y="2830808"/>
            <a:chExt cx="6521387" cy="3559773"/>
          </a:xfrm>
        </p:grpSpPr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D133E205-ED9D-16FC-FF52-5F9EA6315E5E}"/>
                </a:ext>
              </a:extLst>
            </p:cNvPr>
            <p:cNvGrpSpPr/>
            <p:nvPr/>
          </p:nvGrpSpPr>
          <p:grpSpPr>
            <a:xfrm>
              <a:off x="3830180" y="2905723"/>
              <a:ext cx="3220891" cy="3190106"/>
              <a:chOff x="3830180" y="2905723"/>
              <a:chExt cx="3220891" cy="3190106"/>
            </a:xfrm>
          </p:grpSpPr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12C8D4AA-3F4D-4555-665D-0F3DC9B85D52}"/>
                  </a:ext>
                </a:extLst>
              </p:cNvPr>
              <p:cNvGrpSpPr/>
              <p:nvPr/>
            </p:nvGrpSpPr>
            <p:grpSpPr>
              <a:xfrm>
                <a:off x="3830180" y="2905723"/>
                <a:ext cx="3220891" cy="3190106"/>
                <a:chOff x="3695540" y="2905723"/>
                <a:chExt cx="3220891" cy="3190106"/>
              </a:xfrm>
            </p:grpSpPr>
            <p:grpSp>
              <p:nvGrpSpPr>
                <p:cNvPr id="6" name="Group 5">
                  <a:extLst>
                    <a:ext uri="{FF2B5EF4-FFF2-40B4-BE49-F238E27FC236}">
                      <a16:creationId xmlns:a16="http://schemas.microsoft.com/office/drawing/2014/main" id="{AEC06735-5159-3D87-6504-DAADE23257DB}"/>
                    </a:ext>
                  </a:extLst>
                </p:cNvPr>
                <p:cNvGrpSpPr/>
                <p:nvPr/>
              </p:nvGrpSpPr>
              <p:grpSpPr>
                <a:xfrm>
                  <a:off x="3960179" y="2905723"/>
                  <a:ext cx="2956252" cy="3190106"/>
                  <a:chOff x="3777384" y="3263471"/>
                  <a:chExt cx="2956252" cy="3190106"/>
                </a:xfrm>
              </p:grpSpPr>
              <p:grpSp>
                <p:nvGrpSpPr>
                  <p:cNvPr id="4" name="Group 3">
                    <a:extLst>
                      <a:ext uri="{FF2B5EF4-FFF2-40B4-BE49-F238E27FC236}">
                        <a16:creationId xmlns:a16="http://schemas.microsoft.com/office/drawing/2014/main" id="{13DC0D81-8C15-0FAE-9E98-1CE7AB8ECF43}"/>
                      </a:ext>
                    </a:extLst>
                  </p:cNvPr>
                  <p:cNvGrpSpPr/>
                  <p:nvPr/>
                </p:nvGrpSpPr>
                <p:grpSpPr>
                  <a:xfrm>
                    <a:off x="3777384" y="3473155"/>
                    <a:ext cx="2499831" cy="2980422"/>
                    <a:chOff x="3777384" y="3473155"/>
                    <a:chExt cx="2499831" cy="2980422"/>
                  </a:xfrm>
                </p:grpSpPr>
                <p:pic>
                  <p:nvPicPr>
                    <p:cNvPr id="76" name="Picture 75" descr="A picture containing electronics, jack&#10;&#10;Description automatically generated">
                      <a:extLst>
                        <a:ext uri="{FF2B5EF4-FFF2-40B4-BE49-F238E27FC236}">
                          <a16:creationId xmlns:a16="http://schemas.microsoft.com/office/drawing/2014/main" id="{6B452F54-A35F-0D91-8E6D-56E78EE11E5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3201" t="18388" r="18180" b="31622"/>
                    <a:stretch/>
                  </p:blipFill>
                  <p:spPr>
                    <a:xfrm>
                      <a:off x="3777384" y="4962847"/>
                      <a:ext cx="2499831" cy="149073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77" name="Picture 76">
                      <a:extLst>
                        <a:ext uri="{FF2B5EF4-FFF2-40B4-BE49-F238E27FC236}">
                          <a16:creationId xmlns:a16="http://schemas.microsoft.com/office/drawing/2014/main" id="{A7A03ABA-9CD2-42F2-6155-74598AD1637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0246" t="14094" r="22146" b="38264"/>
                    <a:stretch/>
                  </p:blipFill>
                  <p:spPr>
                    <a:xfrm>
                      <a:off x="3777384" y="3473155"/>
                      <a:ext cx="2499831" cy="1441561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  <p:grpSp>
                <p:nvGrpSpPr>
                  <p:cNvPr id="5" name="Group 4">
                    <a:extLst>
                      <a:ext uri="{FF2B5EF4-FFF2-40B4-BE49-F238E27FC236}">
                        <a16:creationId xmlns:a16="http://schemas.microsoft.com/office/drawing/2014/main" id="{AEF920EF-23DC-B699-2B67-1C2BCC955E52}"/>
                      </a:ext>
                    </a:extLst>
                  </p:cNvPr>
                  <p:cNvGrpSpPr/>
                  <p:nvPr/>
                </p:nvGrpSpPr>
                <p:grpSpPr>
                  <a:xfrm>
                    <a:off x="4071866" y="3263471"/>
                    <a:ext cx="2661770" cy="2712699"/>
                    <a:chOff x="4071866" y="3263471"/>
                    <a:chExt cx="2661770" cy="2712699"/>
                  </a:xfrm>
                </p:grpSpPr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1DEFB7D3-4B4F-B9B9-0D9B-57B34D56FF6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29184" y="5776115"/>
                      <a:ext cx="5044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2</a:t>
                      </a:r>
                    </a:p>
                  </p:txBody>
                </p:sp>
                <p:sp>
                  <p:nvSpPr>
                    <p:cNvPr id="51" name="TextBox 50">
                      <a:extLst>
                        <a:ext uri="{FF2B5EF4-FFF2-40B4-BE49-F238E27FC236}">
                          <a16:creationId xmlns:a16="http://schemas.microsoft.com/office/drawing/2014/main" id="{6F9CDB08-2E8A-C118-347E-3EF0B215E07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29184" y="4060467"/>
                      <a:ext cx="5044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l-GR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-tubulin</a:t>
                      </a:r>
                    </a:p>
                  </p:txBody>
                </p:sp>
                <p:sp>
                  <p:nvSpPr>
                    <p:cNvPr id="95" name="TextBox 94">
                      <a:extLst>
                        <a:ext uri="{FF2B5EF4-FFF2-40B4-BE49-F238E27FC236}">
                          <a16:creationId xmlns:a16="http://schemas.microsoft.com/office/drawing/2014/main" id="{712652EB-C63D-CE54-CC45-DF82F00F923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71866" y="3263471"/>
                      <a:ext cx="2409544" cy="200055"/>
                    </a:xfrm>
                    <a:prstGeom prst="rect">
                      <a:avLst/>
                    </a:prstGeom>
                    <a:noFill/>
                  </p:spPr>
                  <p:txBody>
                    <a:bodyPr vert="horz"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1          2	                 5         6		      3</a:t>
                      </a:r>
                    </a:p>
                  </p:txBody>
                </p:sp>
              </p:grpSp>
            </p:grpSp>
            <p:grpSp>
              <p:nvGrpSpPr>
                <p:cNvPr id="27" name="Group 26">
                  <a:extLst>
                    <a:ext uri="{FF2B5EF4-FFF2-40B4-BE49-F238E27FC236}">
                      <a16:creationId xmlns:a16="http://schemas.microsoft.com/office/drawing/2014/main" id="{A0AA12A4-826F-B6B9-1380-4B86EEDDEE39}"/>
                    </a:ext>
                  </a:extLst>
                </p:cNvPr>
                <p:cNvGrpSpPr/>
                <p:nvPr/>
              </p:nvGrpSpPr>
              <p:grpSpPr>
                <a:xfrm>
                  <a:off x="3695540" y="5048882"/>
                  <a:ext cx="287783" cy="1006132"/>
                  <a:chOff x="540299" y="5343634"/>
                  <a:chExt cx="287783" cy="1006132"/>
                </a:xfrm>
              </p:grpSpPr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2732EF2A-289E-1C58-931B-FF920151DECF}"/>
                      </a:ext>
                    </a:extLst>
                  </p:cNvPr>
                  <p:cNvSpPr txBox="1"/>
                  <p:nvPr/>
                </p:nvSpPr>
                <p:spPr>
                  <a:xfrm>
                    <a:off x="541103" y="5343634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" name="TextBox 28">
                    <a:extLst>
                      <a:ext uri="{FF2B5EF4-FFF2-40B4-BE49-F238E27FC236}">
                        <a16:creationId xmlns:a16="http://schemas.microsoft.com/office/drawing/2014/main" id="{62545855-F9F5-93D2-0B11-DBD59D356A35}"/>
                      </a:ext>
                    </a:extLst>
                  </p:cNvPr>
                  <p:cNvSpPr txBox="1"/>
                  <p:nvPr/>
                </p:nvSpPr>
                <p:spPr>
                  <a:xfrm>
                    <a:off x="540299" y="5508882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4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5B50DF89-B412-5A08-7063-B3618AE03034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647441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id="{0BC3146D-A948-DA60-2FFC-7D7066B987EF}"/>
                      </a:ext>
                    </a:extLst>
                  </p:cNvPr>
                  <p:cNvSpPr txBox="1"/>
                  <p:nvPr/>
                </p:nvSpPr>
                <p:spPr>
                  <a:xfrm>
                    <a:off x="540300" y="6145465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6DB956F1-E57D-1F0E-F405-C7B8A0F236D0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855990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6" name="Group 35">
                  <a:extLst>
                    <a:ext uri="{FF2B5EF4-FFF2-40B4-BE49-F238E27FC236}">
                      <a16:creationId xmlns:a16="http://schemas.microsoft.com/office/drawing/2014/main" id="{1FAAA9D4-FC96-B528-E8B3-C48E07F67E23}"/>
                    </a:ext>
                  </a:extLst>
                </p:cNvPr>
                <p:cNvGrpSpPr/>
                <p:nvPr/>
              </p:nvGrpSpPr>
              <p:grpSpPr>
                <a:xfrm>
                  <a:off x="3743031" y="3759230"/>
                  <a:ext cx="277993" cy="500579"/>
                  <a:chOff x="540299" y="5316292"/>
                  <a:chExt cx="277993" cy="500579"/>
                </a:xfrm>
              </p:grpSpPr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1CC4E041-D036-C169-9A48-D7D56CBE41CE}"/>
                      </a:ext>
                    </a:extLst>
                  </p:cNvPr>
                  <p:cNvSpPr txBox="1"/>
                  <p:nvPr/>
                </p:nvSpPr>
                <p:spPr>
                  <a:xfrm>
                    <a:off x="541103" y="5316292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ACB8F511-0F4B-134D-8C7D-35BD2A6DAD23}"/>
                      </a:ext>
                    </a:extLst>
                  </p:cNvPr>
                  <p:cNvSpPr txBox="1"/>
                  <p:nvPr/>
                </p:nvSpPr>
                <p:spPr>
                  <a:xfrm>
                    <a:off x="540299" y="5483125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4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" name="TextBox 39">
                    <a:extLst>
                      <a:ext uri="{FF2B5EF4-FFF2-40B4-BE49-F238E27FC236}">
                        <a16:creationId xmlns:a16="http://schemas.microsoft.com/office/drawing/2014/main" id="{754CFDD3-3158-800A-5586-72A8D5894340}"/>
                      </a:ext>
                    </a:extLst>
                  </p:cNvPr>
                  <p:cNvSpPr txBox="1"/>
                  <p:nvPr/>
                </p:nvSpPr>
                <p:spPr>
                  <a:xfrm>
                    <a:off x="541103" y="5612570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4DEB4E56-24D1-1A3C-3F76-6E3C49D133AA}"/>
                  </a:ext>
                </a:extLst>
              </p:cNvPr>
              <p:cNvSpPr txBox="1"/>
              <p:nvPr/>
            </p:nvSpPr>
            <p:spPr>
              <a:xfrm>
                <a:off x="3847120" y="3534565"/>
                <a:ext cx="31960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7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kDa</a:t>
                </a:r>
                <a:endParaRPr lang="en-GB" sz="7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7D8886D6-936E-780E-4872-19BC8617B1E7}"/>
                </a:ext>
              </a:extLst>
            </p:cNvPr>
            <p:cNvGrpSpPr/>
            <p:nvPr/>
          </p:nvGrpSpPr>
          <p:grpSpPr>
            <a:xfrm>
              <a:off x="529684" y="2830808"/>
              <a:ext cx="3449344" cy="3559773"/>
              <a:chOff x="529684" y="2830808"/>
              <a:chExt cx="3449344" cy="3559773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0AAEA49C-8D6F-7EA8-A364-B73F9B969437}"/>
                  </a:ext>
                </a:extLst>
              </p:cNvPr>
              <p:cNvGrpSpPr/>
              <p:nvPr/>
            </p:nvGrpSpPr>
            <p:grpSpPr>
              <a:xfrm>
                <a:off x="835152" y="2830808"/>
                <a:ext cx="3143876" cy="3559773"/>
                <a:chOff x="835152" y="2830808"/>
                <a:chExt cx="3143876" cy="3559773"/>
              </a:xfrm>
            </p:grpSpPr>
            <p:grpSp>
              <p:nvGrpSpPr>
                <p:cNvPr id="24" name="Group 23">
                  <a:extLst>
                    <a:ext uri="{FF2B5EF4-FFF2-40B4-BE49-F238E27FC236}">
                      <a16:creationId xmlns:a16="http://schemas.microsoft.com/office/drawing/2014/main" id="{BB034FF6-C45D-1679-80BE-DD5D0418F8AE}"/>
                    </a:ext>
                  </a:extLst>
                </p:cNvPr>
                <p:cNvGrpSpPr/>
                <p:nvPr/>
              </p:nvGrpSpPr>
              <p:grpSpPr>
                <a:xfrm>
                  <a:off x="835152" y="2830808"/>
                  <a:ext cx="3097911" cy="3559773"/>
                  <a:chOff x="835152" y="2830808"/>
                  <a:chExt cx="3097911" cy="3559773"/>
                </a:xfrm>
              </p:grpSpPr>
              <p:grpSp>
                <p:nvGrpSpPr>
                  <p:cNvPr id="3" name="Group 2">
                    <a:extLst>
                      <a:ext uri="{FF2B5EF4-FFF2-40B4-BE49-F238E27FC236}">
                        <a16:creationId xmlns:a16="http://schemas.microsoft.com/office/drawing/2014/main" id="{DEC2BD8F-8E75-643F-CF28-3552EE0544B7}"/>
                      </a:ext>
                    </a:extLst>
                  </p:cNvPr>
                  <p:cNvGrpSpPr/>
                  <p:nvPr/>
                </p:nvGrpSpPr>
                <p:grpSpPr>
                  <a:xfrm>
                    <a:off x="1049196" y="2830808"/>
                    <a:ext cx="2883867" cy="3033272"/>
                    <a:chOff x="584068" y="3215245"/>
                    <a:chExt cx="2883867" cy="3033272"/>
                  </a:xfrm>
                </p:grpSpPr>
                <p:pic>
                  <p:nvPicPr>
                    <p:cNvPr id="79" name="Picture 78" descr="A picture containing text&#10;&#10;Description automatically generated">
                      <a:extLst>
                        <a:ext uri="{FF2B5EF4-FFF2-40B4-BE49-F238E27FC236}">
                          <a16:creationId xmlns:a16="http://schemas.microsoft.com/office/drawing/2014/main" id="{02A20DF5-D1D1-71CA-939D-B8E1F5DE8C4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9662" t="39802" r="18670" b="35970"/>
                    <a:stretch/>
                  </p:blipFill>
                  <p:spPr>
                    <a:xfrm>
                      <a:off x="584068" y="3473855"/>
                      <a:ext cx="2257038" cy="725854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80" name="Picture 79">
                      <a:extLst>
                        <a:ext uri="{FF2B5EF4-FFF2-40B4-BE49-F238E27FC236}">
                          <a16:creationId xmlns:a16="http://schemas.microsoft.com/office/drawing/2014/main" id="{7614B200-4255-FB3F-D966-76D400D4272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0694" t="36529" r="17638" b="34044"/>
                    <a:stretch/>
                  </p:blipFill>
                  <p:spPr>
                    <a:xfrm>
                      <a:off x="584068" y="4237686"/>
                      <a:ext cx="2257038" cy="881699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grpSp>
                  <p:nvGrpSpPr>
                    <p:cNvPr id="2" name="Group 1">
                      <a:extLst>
                        <a:ext uri="{FF2B5EF4-FFF2-40B4-BE49-F238E27FC236}">
                          <a16:creationId xmlns:a16="http://schemas.microsoft.com/office/drawing/2014/main" id="{D041F1BC-8663-6E87-1CA0-5AC5A888990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8985" y="3215245"/>
                      <a:ext cx="2778950" cy="3033272"/>
                      <a:chOff x="688985" y="3215245"/>
                      <a:chExt cx="2778950" cy="3033272"/>
                    </a:xfrm>
                  </p:grpSpPr>
                  <p:sp>
                    <p:nvSpPr>
                      <p:cNvPr id="54" name="TextBox 53">
                        <a:extLst>
                          <a:ext uri="{FF2B5EF4-FFF2-40B4-BE49-F238E27FC236}">
                            <a16:creationId xmlns:a16="http://schemas.microsoft.com/office/drawing/2014/main" id="{C1E0E1AE-26F4-9FC5-C935-6BB12A1F57C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88985" y="3215245"/>
                        <a:ext cx="2409544" cy="2000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horz" wrap="square" rtlCol="0">
                        <a:spAutoFit/>
                      </a:bodyPr>
                      <a:lstStyle/>
                      <a:p>
                        <a:r>
                          <a:rPr lang="en-GB" sz="700" b="1" dirty="0">
                            <a:latin typeface="Arial Narrow" panose="020B0606020202030204" pitchFamily="34" charset="0"/>
                            <a:cs typeface="Arial" panose="020B0604020202020204" pitchFamily="34" charset="0"/>
                          </a:rPr>
                          <a:t>1          2	                 3         4		   5</a:t>
                        </a:r>
                      </a:p>
                    </p:txBody>
                  </p:sp>
                  <p:sp>
                    <p:nvSpPr>
                      <p:cNvPr id="49" name="TextBox 48">
                        <a:extLst>
                          <a:ext uri="{FF2B5EF4-FFF2-40B4-BE49-F238E27FC236}">
                            <a16:creationId xmlns:a16="http://schemas.microsoft.com/office/drawing/2014/main" id="{2E06EFD3-0114-EC2B-8731-E98FC9CDF47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957722" y="6044216"/>
                        <a:ext cx="510213" cy="204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700" b="1" dirty="0">
                            <a:latin typeface="Arial Narrow" panose="020B0606020202030204" pitchFamily="34" charset="0"/>
                            <a:cs typeface="Arial" panose="020B0604020202020204" pitchFamily="34" charset="0"/>
                          </a:rPr>
                          <a:t>DDAH1</a:t>
                        </a:r>
                      </a:p>
                    </p:txBody>
                  </p:sp>
                  <p:sp>
                    <p:nvSpPr>
                      <p:cNvPr id="50" name="TextBox 49">
                        <a:extLst>
                          <a:ext uri="{FF2B5EF4-FFF2-40B4-BE49-F238E27FC236}">
                            <a16:creationId xmlns:a16="http://schemas.microsoft.com/office/drawing/2014/main" id="{B4FBE754-6F45-FC17-1765-9A06C781573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43965" y="3965030"/>
                        <a:ext cx="562110" cy="204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l-GR" sz="700" b="1" dirty="0">
                            <a:latin typeface="Arial Narrow" panose="020B0606020202030204" pitchFamily="34" charset="0"/>
                            <a:cs typeface="Arial" panose="020B0604020202020204" pitchFamily="34" charset="0"/>
                          </a:rPr>
                          <a:t>α</a:t>
                        </a:r>
                        <a:r>
                          <a:rPr lang="en-GB" sz="700" b="1" dirty="0">
                            <a:latin typeface="Arial Narrow" panose="020B0606020202030204" pitchFamily="34" charset="0"/>
                            <a:cs typeface="Arial" panose="020B0604020202020204" pitchFamily="34" charset="0"/>
                          </a:rPr>
                          <a:t>-tubulin</a:t>
                        </a:r>
                      </a:p>
                    </p:txBody>
                  </p:sp>
                </p:grpSp>
              </p:grpSp>
              <p:grpSp>
                <p:nvGrpSpPr>
                  <p:cNvPr id="23" name="Group 22">
                    <a:extLst>
                      <a:ext uri="{FF2B5EF4-FFF2-40B4-BE49-F238E27FC236}">
                        <a16:creationId xmlns:a16="http://schemas.microsoft.com/office/drawing/2014/main" id="{08D5B345-282D-33DB-C9F1-136ECEB1EF24}"/>
                      </a:ext>
                    </a:extLst>
                  </p:cNvPr>
                  <p:cNvGrpSpPr/>
                  <p:nvPr/>
                </p:nvGrpSpPr>
                <p:grpSpPr>
                  <a:xfrm>
                    <a:off x="835152" y="4772925"/>
                    <a:ext cx="2656850" cy="1617656"/>
                    <a:chOff x="638388" y="3156225"/>
                    <a:chExt cx="2656850" cy="1617656"/>
                  </a:xfrm>
                </p:grpSpPr>
                <p:pic>
                  <p:nvPicPr>
                    <p:cNvPr id="18" name="Picture 17" descr="A picture containing text, electronics, cement&#10;&#10;Description automatically generated">
                      <a:extLst>
                        <a:ext uri="{FF2B5EF4-FFF2-40B4-BE49-F238E27FC236}">
                          <a16:creationId xmlns:a16="http://schemas.microsoft.com/office/drawing/2014/main" id="{2A2FC140-2ED4-2896-C5AB-7E0447332B3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3750" t="39704" r="14349" b="36174"/>
                    <a:stretch/>
                  </p:blipFill>
                  <p:spPr>
                    <a:xfrm rot="60000">
                      <a:off x="672939" y="3156225"/>
                      <a:ext cx="2616025" cy="74175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14" name="Picture 13" descr="Graphical user interface&#10;&#10;Description automatically generated">
                      <a:extLst>
                        <a:ext uri="{FF2B5EF4-FFF2-40B4-BE49-F238E27FC236}">
                          <a16:creationId xmlns:a16="http://schemas.microsoft.com/office/drawing/2014/main" id="{2BAB6AAE-40AD-21DE-23C4-186421DA821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5013" t="38188" r="14752" b="32244"/>
                    <a:stretch/>
                  </p:blipFill>
                  <p:spPr>
                    <a:xfrm>
                      <a:off x="638388" y="3892182"/>
                      <a:ext cx="2656850" cy="881699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</p:grp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02911776-1FF9-9215-B213-ADE46BBC567D}"/>
                    </a:ext>
                  </a:extLst>
                </p:cNvPr>
                <p:cNvSpPr txBox="1"/>
                <p:nvPr/>
              </p:nvSpPr>
              <p:spPr>
                <a:xfrm>
                  <a:off x="3416918" y="5304581"/>
                  <a:ext cx="562110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-tubulin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81507C86-B635-7918-AB32-7D0BC9C7972F}"/>
                    </a:ext>
                  </a:extLst>
                </p:cNvPr>
                <p:cNvSpPr txBox="1"/>
                <p:nvPr/>
              </p:nvSpPr>
              <p:spPr>
                <a:xfrm>
                  <a:off x="3308550" y="4044554"/>
                  <a:ext cx="510213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DDAH1</a:t>
                  </a:r>
                </a:p>
              </p:txBody>
            </p:sp>
          </p:grp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8F44D63C-EC7B-0EF6-C707-9F9E0F88CC4F}"/>
                  </a:ext>
                </a:extLst>
              </p:cNvPr>
              <p:cNvGrpSpPr/>
              <p:nvPr/>
            </p:nvGrpSpPr>
            <p:grpSpPr>
              <a:xfrm>
                <a:off x="529684" y="4831708"/>
                <a:ext cx="322628" cy="1558873"/>
                <a:chOff x="529684" y="4831708"/>
                <a:chExt cx="322628" cy="1558873"/>
              </a:xfrm>
            </p:grpSpPr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540F16CF-6759-D689-E729-E0BC8DE22099}"/>
                    </a:ext>
                  </a:extLst>
                </p:cNvPr>
                <p:cNvSpPr txBox="1"/>
                <p:nvPr/>
              </p:nvSpPr>
              <p:spPr>
                <a:xfrm>
                  <a:off x="532706" y="4831708"/>
                  <a:ext cx="31960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kDa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B0F8EFC2-949C-8F2E-FED3-13AA62E129DE}"/>
                    </a:ext>
                  </a:extLst>
                </p:cNvPr>
                <p:cNvGrpSpPr/>
                <p:nvPr/>
              </p:nvGrpSpPr>
              <p:grpSpPr>
                <a:xfrm>
                  <a:off x="529684" y="4992435"/>
                  <a:ext cx="319606" cy="1398146"/>
                  <a:chOff x="529684" y="4992435"/>
                  <a:chExt cx="319606" cy="1398146"/>
                </a:xfrm>
              </p:grpSpPr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26D655E6-53AF-1EBF-C7F9-39AAC9C0E482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316424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F25AB96C-CE45-2FAA-2028-076C8A24C71D}"/>
                      </a:ext>
                    </a:extLst>
                  </p:cNvPr>
                  <p:cNvSpPr txBox="1"/>
                  <p:nvPr/>
                </p:nvSpPr>
                <p:spPr>
                  <a:xfrm>
                    <a:off x="540299" y="5508882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4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098A5A2D-2C83-8C46-F998-6ECA6B656CA3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685535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6934C9BC-4FF1-9D32-B981-7B8FFE686CA1}"/>
                      </a:ext>
                    </a:extLst>
                  </p:cNvPr>
                  <p:cNvSpPr txBox="1"/>
                  <p:nvPr/>
                </p:nvSpPr>
                <p:spPr>
                  <a:xfrm>
                    <a:off x="540300" y="6186280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A0F15828-0375-1A55-BEBD-AB7341A88225}"/>
                      </a:ext>
                    </a:extLst>
                  </p:cNvPr>
                  <p:cNvSpPr txBox="1"/>
                  <p:nvPr/>
                </p:nvSpPr>
                <p:spPr>
                  <a:xfrm>
                    <a:off x="540300" y="5104874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7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0686E3A5-6DF5-745E-3C16-741F7681B9F2}"/>
                      </a:ext>
                    </a:extLst>
                  </p:cNvPr>
                  <p:cNvSpPr txBox="1"/>
                  <p:nvPr/>
                </p:nvSpPr>
                <p:spPr>
                  <a:xfrm>
                    <a:off x="529684" y="4992435"/>
                    <a:ext cx="319606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0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" name="TextBox 19">
                    <a:extLst>
                      <a:ext uri="{FF2B5EF4-FFF2-40B4-BE49-F238E27FC236}">
                        <a16:creationId xmlns:a16="http://schemas.microsoft.com/office/drawing/2014/main" id="{19437FE5-0F36-EE2B-5523-9F0BA7FDB2B8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902247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30F8F3BE-A3A9-D0C5-FDA3-BD52E4AE0E72}"/>
                  </a:ext>
                </a:extLst>
              </p:cNvPr>
              <p:cNvGrpSpPr/>
              <p:nvPr/>
            </p:nvGrpSpPr>
            <p:grpSpPr>
              <a:xfrm>
                <a:off x="757882" y="3234455"/>
                <a:ext cx="319606" cy="1558873"/>
                <a:chOff x="532706" y="4831708"/>
                <a:chExt cx="319606" cy="1558873"/>
              </a:xfrm>
            </p:grpSpPr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A2B3A5BF-1130-50C2-E075-82CAB782CD60}"/>
                    </a:ext>
                  </a:extLst>
                </p:cNvPr>
                <p:cNvSpPr txBox="1"/>
                <p:nvPr/>
              </p:nvSpPr>
              <p:spPr>
                <a:xfrm>
                  <a:off x="532706" y="4831708"/>
                  <a:ext cx="31960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kDa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6" name="Group 25">
                  <a:extLst>
                    <a:ext uri="{FF2B5EF4-FFF2-40B4-BE49-F238E27FC236}">
                      <a16:creationId xmlns:a16="http://schemas.microsoft.com/office/drawing/2014/main" id="{6391031C-C9F4-6AD0-CA00-7D89D4EE4689}"/>
                    </a:ext>
                  </a:extLst>
                </p:cNvPr>
                <p:cNvGrpSpPr/>
                <p:nvPr/>
              </p:nvGrpSpPr>
              <p:grpSpPr>
                <a:xfrm>
                  <a:off x="540299" y="4989432"/>
                  <a:ext cx="287783" cy="1401149"/>
                  <a:chOff x="540299" y="4989432"/>
                  <a:chExt cx="287783" cy="1401149"/>
                </a:xfrm>
              </p:grpSpPr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id="{4DAAE27D-1B17-FED6-50CB-D4E87E96F4B5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200984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BA3531D8-4EC5-7257-6381-E02F5E8B1472}"/>
                      </a:ext>
                    </a:extLst>
                  </p:cNvPr>
                  <p:cNvSpPr txBox="1"/>
                  <p:nvPr/>
                </p:nvSpPr>
                <p:spPr>
                  <a:xfrm>
                    <a:off x="540299" y="5508882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4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699B0122-34D2-E23B-69B5-92A47954BD5A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685535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58C127BF-6924-CCE9-2669-5BC7E7E9FCFE}"/>
                      </a:ext>
                    </a:extLst>
                  </p:cNvPr>
                  <p:cNvSpPr txBox="1"/>
                  <p:nvPr/>
                </p:nvSpPr>
                <p:spPr>
                  <a:xfrm>
                    <a:off x="540300" y="6186280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4B48DEF3-239F-FFDE-7EBC-86CEEDBA8FD2}"/>
                      </a:ext>
                    </a:extLst>
                  </p:cNvPr>
                  <p:cNvSpPr txBox="1"/>
                  <p:nvPr/>
                </p:nvSpPr>
                <p:spPr>
                  <a:xfrm>
                    <a:off x="540300" y="4989432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7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9434AF21-E6E1-749D-7E81-F25EF1438E92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902247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842471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>
            <a:extLst>
              <a:ext uri="{FF2B5EF4-FFF2-40B4-BE49-F238E27FC236}">
                <a16:creationId xmlns:a16="http://schemas.microsoft.com/office/drawing/2014/main" id="{07B39CCE-6456-7DA7-F2F3-F3CD515A7F6F}"/>
              </a:ext>
            </a:extLst>
          </p:cNvPr>
          <p:cNvSpPr txBox="1"/>
          <p:nvPr/>
        </p:nvSpPr>
        <p:spPr>
          <a:xfrm>
            <a:off x="584068" y="956912"/>
            <a:ext cx="6443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AF82281-1F28-1ED5-3F90-55A02F1D4867}"/>
              </a:ext>
            </a:extLst>
          </p:cNvPr>
          <p:cNvSpPr txBox="1"/>
          <p:nvPr/>
        </p:nvSpPr>
        <p:spPr>
          <a:xfrm>
            <a:off x="935036" y="7528743"/>
            <a:ext cx="4063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bodies: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-actin-HRP, ab49900 – Abcam, 1:30000 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1, monoclonal antibody previously described in Reference 89, 1:5000 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2, ab232694 – Abcam, 1:100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4BB333DD-BD11-42DE-2E10-029F241B61F9}"/>
              </a:ext>
            </a:extLst>
          </p:cNvPr>
          <p:cNvGrpSpPr/>
          <p:nvPr/>
        </p:nvGrpSpPr>
        <p:grpSpPr>
          <a:xfrm>
            <a:off x="918359" y="2955168"/>
            <a:ext cx="5745182" cy="3826579"/>
            <a:chOff x="918359" y="2955168"/>
            <a:chExt cx="5745182" cy="3826579"/>
          </a:xfrm>
        </p:grpSpPr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D6A89D44-736E-E841-51F3-4EC4426743B4}"/>
                </a:ext>
              </a:extLst>
            </p:cNvPr>
            <p:cNvGrpSpPr/>
            <p:nvPr/>
          </p:nvGrpSpPr>
          <p:grpSpPr>
            <a:xfrm>
              <a:off x="1204611" y="3154415"/>
              <a:ext cx="5458930" cy="3627332"/>
              <a:chOff x="-279060" y="3068116"/>
              <a:chExt cx="5458930" cy="3627332"/>
            </a:xfrm>
          </p:grpSpPr>
          <p:grpSp>
            <p:nvGrpSpPr>
              <p:cNvPr id="106" name="Group 105">
                <a:extLst>
                  <a:ext uri="{FF2B5EF4-FFF2-40B4-BE49-F238E27FC236}">
                    <a16:creationId xmlns:a16="http://schemas.microsoft.com/office/drawing/2014/main" id="{6E8649E6-B14E-B9D7-6E48-E77BCD120A32}"/>
                  </a:ext>
                </a:extLst>
              </p:cNvPr>
              <p:cNvGrpSpPr/>
              <p:nvPr/>
            </p:nvGrpSpPr>
            <p:grpSpPr>
              <a:xfrm>
                <a:off x="4507452" y="3164367"/>
                <a:ext cx="672418" cy="2354137"/>
                <a:chOff x="4507452" y="3164367"/>
                <a:chExt cx="672418" cy="2354137"/>
              </a:xfrm>
            </p:grpSpPr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5164BF80-1D6C-4A47-A74C-40BEA69BA17E}"/>
                    </a:ext>
                  </a:extLst>
                </p:cNvPr>
                <p:cNvSpPr txBox="1"/>
                <p:nvPr/>
              </p:nvSpPr>
              <p:spPr>
                <a:xfrm>
                  <a:off x="4507452" y="3164367"/>
                  <a:ext cx="64178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DDAH1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71023F72-36E9-45FF-9B0E-5CBE03349FD9}"/>
                    </a:ext>
                  </a:extLst>
                </p:cNvPr>
                <p:cNvSpPr txBox="1"/>
                <p:nvPr/>
              </p:nvSpPr>
              <p:spPr>
                <a:xfrm>
                  <a:off x="4538085" y="4923497"/>
                  <a:ext cx="64178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-actin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7FF121C3-002B-443B-BAE1-1A9499BC6131}"/>
                    </a:ext>
                  </a:extLst>
                </p:cNvPr>
                <p:cNvSpPr txBox="1"/>
                <p:nvPr/>
              </p:nvSpPr>
              <p:spPr>
                <a:xfrm>
                  <a:off x="4533117" y="5318449"/>
                  <a:ext cx="59045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DDAH2</a:t>
                  </a:r>
                </a:p>
              </p:txBody>
            </p:sp>
          </p:grpSp>
          <p:grpSp>
            <p:nvGrpSpPr>
              <p:cNvPr id="105" name="Group 104">
                <a:extLst>
                  <a:ext uri="{FF2B5EF4-FFF2-40B4-BE49-F238E27FC236}">
                    <a16:creationId xmlns:a16="http://schemas.microsoft.com/office/drawing/2014/main" id="{A10E025D-186A-C501-68FE-1472FA60C38A}"/>
                  </a:ext>
                </a:extLst>
              </p:cNvPr>
              <p:cNvGrpSpPr/>
              <p:nvPr/>
            </p:nvGrpSpPr>
            <p:grpSpPr>
              <a:xfrm>
                <a:off x="-279060" y="3068116"/>
                <a:ext cx="4814661" cy="3627332"/>
                <a:chOff x="-279060" y="3068116"/>
                <a:chExt cx="4814661" cy="3627332"/>
              </a:xfrm>
            </p:grpSpPr>
            <p:grpSp>
              <p:nvGrpSpPr>
                <p:cNvPr id="73" name="Group 72">
                  <a:extLst>
                    <a:ext uri="{FF2B5EF4-FFF2-40B4-BE49-F238E27FC236}">
                      <a16:creationId xmlns:a16="http://schemas.microsoft.com/office/drawing/2014/main" id="{A5285405-6CF6-D315-31F7-965254D45D39}"/>
                    </a:ext>
                  </a:extLst>
                </p:cNvPr>
                <p:cNvGrpSpPr/>
                <p:nvPr/>
              </p:nvGrpSpPr>
              <p:grpSpPr>
                <a:xfrm>
                  <a:off x="-145920" y="5886649"/>
                  <a:ext cx="1936393" cy="801851"/>
                  <a:chOff x="-137606" y="5931572"/>
                  <a:chExt cx="1936393" cy="801851"/>
                </a:xfrm>
              </p:grpSpPr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0B6D8D71-7E3E-36EA-137F-C8A4C5437CA4}"/>
                      </a:ext>
                    </a:extLst>
                  </p:cNvPr>
                  <p:cNvSpPr txBox="1"/>
                  <p:nvPr/>
                </p:nvSpPr>
                <p:spPr>
                  <a:xfrm rot="2477009">
                    <a:off x="-137606" y="6149349"/>
                    <a:ext cx="292388" cy="423613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ild type</a:t>
                    </a: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6465AD9F-59A0-B7F2-2F3D-020B94AA1CE9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136831" y="6103758"/>
                    <a:ext cx="292388" cy="546046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 KO 1</a:t>
                    </a:r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768853CA-CE91-659C-D167-71BCDE083F74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502625" y="5932219"/>
                    <a:ext cx="292388" cy="744997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 KO 2</a:t>
                    </a:r>
                  </a:p>
                </p:txBody>
              </p:sp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A1D6E811-C948-99C0-FC66-12E185420D9C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753165" y="5931572"/>
                    <a:ext cx="292388" cy="742219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2 KO 1</a:t>
                    </a:r>
                  </a:p>
                </p:txBody>
              </p:sp>
              <p:sp>
                <p:nvSpPr>
                  <p:cNvPr id="68" name="TextBox 67">
                    <a:extLst>
                      <a:ext uri="{FF2B5EF4-FFF2-40B4-BE49-F238E27FC236}">
                        <a16:creationId xmlns:a16="http://schemas.microsoft.com/office/drawing/2014/main" id="{16B4A884-A798-B057-31A2-F68AF77F5F2E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928649" y="6106524"/>
                    <a:ext cx="292388" cy="546045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2 KO 2</a:t>
                    </a:r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CEFFBCD2-77C2-94BC-EE2A-0EF85DD2794F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1227562" y="5988426"/>
                    <a:ext cx="292388" cy="744997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+2 KO 1</a:t>
                    </a:r>
                  </a:p>
                </p:txBody>
              </p:sp>
              <p:sp>
                <p:nvSpPr>
                  <p:cNvPr id="70" name="TextBox 69">
                    <a:extLst>
                      <a:ext uri="{FF2B5EF4-FFF2-40B4-BE49-F238E27FC236}">
                        <a16:creationId xmlns:a16="http://schemas.microsoft.com/office/drawing/2014/main" id="{F235420D-38B9-ACA2-1AC6-8FD0A087286B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1506399" y="5987652"/>
                    <a:ext cx="292388" cy="742219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+2 KO 2</a:t>
                    </a:r>
                  </a:p>
                </p:txBody>
              </p:sp>
            </p:grpSp>
            <p:grpSp>
              <p:nvGrpSpPr>
                <p:cNvPr id="88" name="Group 87">
                  <a:extLst>
                    <a:ext uri="{FF2B5EF4-FFF2-40B4-BE49-F238E27FC236}">
                      <a16:creationId xmlns:a16="http://schemas.microsoft.com/office/drawing/2014/main" id="{75825906-B83F-BB00-1E19-F69A9D4B3FBE}"/>
                    </a:ext>
                  </a:extLst>
                </p:cNvPr>
                <p:cNvGrpSpPr/>
                <p:nvPr/>
              </p:nvGrpSpPr>
              <p:grpSpPr>
                <a:xfrm>
                  <a:off x="2297834" y="5893597"/>
                  <a:ext cx="1936393" cy="801851"/>
                  <a:chOff x="-137606" y="5931572"/>
                  <a:chExt cx="1936393" cy="801851"/>
                </a:xfrm>
              </p:grpSpPr>
              <p:sp>
                <p:nvSpPr>
                  <p:cNvPr id="89" name="TextBox 88">
                    <a:extLst>
                      <a:ext uri="{FF2B5EF4-FFF2-40B4-BE49-F238E27FC236}">
                        <a16:creationId xmlns:a16="http://schemas.microsoft.com/office/drawing/2014/main" id="{FDD13B98-6BE3-C469-844A-BFC4E0916C9C}"/>
                      </a:ext>
                    </a:extLst>
                  </p:cNvPr>
                  <p:cNvSpPr txBox="1"/>
                  <p:nvPr/>
                </p:nvSpPr>
                <p:spPr>
                  <a:xfrm rot="2477009">
                    <a:off x="-137606" y="6149349"/>
                    <a:ext cx="292388" cy="423613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ild type</a:t>
                    </a:r>
                  </a:p>
                </p:txBody>
              </p:sp>
              <p:sp>
                <p:nvSpPr>
                  <p:cNvPr id="90" name="TextBox 89">
                    <a:extLst>
                      <a:ext uri="{FF2B5EF4-FFF2-40B4-BE49-F238E27FC236}">
                        <a16:creationId xmlns:a16="http://schemas.microsoft.com/office/drawing/2014/main" id="{A04E7CA2-3205-3F83-4E00-A6302A79E34D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136831" y="6103758"/>
                    <a:ext cx="292388" cy="546046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 KO 1</a:t>
                    </a:r>
                  </a:p>
                </p:txBody>
              </p:sp>
              <p:sp>
                <p:nvSpPr>
                  <p:cNvPr id="91" name="TextBox 90">
                    <a:extLst>
                      <a:ext uri="{FF2B5EF4-FFF2-40B4-BE49-F238E27FC236}">
                        <a16:creationId xmlns:a16="http://schemas.microsoft.com/office/drawing/2014/main" id="{171C9617-E5D0-DDAA-DA5B-0955CA93D095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502625" y="5932219"/>
                    <a:ext cx="292388" cy="744997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 KO 2</a:t>
                    </a:r>
                  </a:p>
                </p:txBody>
              </p:sp>
              <p:sp>
                <p:nvSpPr>
                  <p:cNvPr id="92" name="TextBox 91">
                    <a:extLst>
                      <a:ext uri="{FF2B5EF4-FFF2-40B4-BE49-F238E27FC236}">
                        <a16:creationId xmlns:a16="http://schemas.microsoft.com/office/drawing/2014/main" id="{5E41E068-2436-DD85-38F1-01A7AD579DAB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753165" y="5931572"/>
                    <a:ext cx="292388" cy="742219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2 KO 1</a:t>
                    </a:r>
                  </a:p>
                </p:txBody>
              </p:sp>
              <p:sp>
                <p:nvSpPr>
                  <p:cNvPr id="93" name="TextBox 92">
                    <a:extLst>
                      <a:ext uri="{FF2B5EF4-FFF2-40B4-BE49-F238E27FC236}">
                        <a16:creationId xmlns:a16="http://schemas.microsoft.com/office/drawing/2014/main" id="{F16BE7EB-C4A1-C3DA-666D-C8E9DAA5266E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928649" y="6106524"/>
                    <a:ext cx="292388" cy="546045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2 KO 2</a:t>
                    </a:r>
                  </a:p>
                </p:txBody>
              </p:sp>
              <p:sp>
                <p:nvSpPr>
                  <p:cNvPr id="94" name="TextBox 93">
                    <a:extLst>
                      <a:ext uri="{FF2B5EF4-FFF2-40B4-BE49-F238E27FC236}">
                        <a16:creationId xmlns:a16="http://schemas.microsoft.com/office/drawing/2014/main" id="{8601D3A2-D2C4-08B2-0C89-AC85B9894D1D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1227562" y="5988426"/>
                    <a:ext cx="292388" cy="744997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+2 KO 1</a:t>
                    </a:r>
                  </a:p>
                </p:txBody>
              </p:sp>
              <p:sp>
                <p:nvSpPr>
                  <p:cNvPr id="95" name="TextBox 94">
                    <a:extLst>
                      <a:ext uri="{FF2B5EF4-FFF2-40B4-BE49-F238E27FC236}">
                        <a16:creationId xmlns:a16="http://schemas.microsoft.com/office/drawing/2014/main" id="{35A512C3-A68F-DBA1-EBFB-0B00E44BF5A8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1506399" y="5987652"/>
                    <a:ext cx="292388" cy="742219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+2 KO 2</a:t>
                    </a:r>
                  </a:p>
                </p:txBody>
              </p:sp>
            </p:grpSp>
            <p:grpSp>
              <p:nvGrpSpPr>
                <p:cNvPr id="104" name="Group 103">
                  <a:extLst>
                    <a:ext uri="{FF2B5EF4-FFF2-40B4-BE49-F238E27FC236}">
                      <a16:creationId xmlns:a16="http://schemas.microsoft.com/office/drawing/2014/main" id="{3490FE82-7D8A-1CEC-4DB2-907B926B9849}"/>
                    </a:ext>
                  </a:extLst>
                </p:cNvPr>
                <p:cNvGrpSpPr/>
                <p:nvPr/>
              </p:nvGrpSpPr>
              <p:grpSpPr>
                <a:xfrm>
                  <a:off x="-279060" y="3068116"/>
                  <a:ext cx="4814661" cy="3064931"/>
                  <a:chOff x="-279060" y="3068116"/>
                  <a:chExt cx="4814661" cy="3064931"/>
                </a:xfrm>
              </p:grpSpPr>
              <p:grpSp>
                <p:nvGrpSpPr>
                  <p:cNvPr id="102" name="Group 101">
                    <a:extLst>
                      <a:ext uri="{FF2B5EF4-FFF2-40B4-BE49-F238E27FC236}">
                        <a16:creationId xmlns:a16="http://schemas.microsoft.com/office/drawing/2014/main" id="{B304DE89-85D6-4BC9-AAB6-B5D5D161941D}"/>
                      </a:ext>
                    </a:extLst>
                  </p:cNvPr>
                  <p:cNvGrpSpPr/>
                  <p:nvPr/>
                </p:nvGrpSpPr>
                <p:grpSpPr>
                  <a:xfrm>
                    <a:off x="-279060" y="4236278"/>
                    <a:ext cx="4814661" cy="1896769"/>
                    <a:chOff x="-279060" y="4236278"/>
                    <a:chExt cx="4814661" cy="1896769"/>
                  </a:xfrm>
                </p:grpSpPr>
                <p:pic>
                  <p:nvPicPr>
                    <p:cNvPr id="54" name="Picture 53" descr="A picture containing text, appliance, white goods&#10;&#10;Description automatically generated">
                      <a:extLst>
                        <a:ext uri="{FF2B5EF4-FFF2-40B4-BE49-F238E27FC236}">
                          <a16:creationId xmlns:a16="http://schemas.microsoft.com/office/drawing/2014/main" id="{E0029BB8-158F-E73B-AD16-6134D7B19B5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6332" t="16909" r="16252" b="17906"/>
                    <a:stretch/>
                  </p:blipFill>
                  <p:spPr>
                    <a:xfrm>
                      <a:off x="2143448" y="4236278"/>
                      <a:ext cx="2392153" cy="189304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52" name="Picture 51" descr="A picture containing text, electronics&#10;&#10;Description automatically generated">
                      <a:extLst>
                        <a:ext uri="{FF2B5EF4-FFF2-40B4-BE49-F238E27FC236}">
                          <a16:creationId xmlns:a16="http://schemas.microsoft.com/office/drawing/2014/main" id="{A5DB2863-FD9A-7C1B-3B82-FF7D7A6D6E9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6461" t="17830" r="16122" b="16986"/>
                    <a:stretch/>
                  </p:blipFill>
                  <p:spPr>
                    <a:xfrm>
                      <a:off x="-279060" y="4240006"/>
                      <a:ext cx="2392153" cy="1893041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  <p:grpSp>
                <p:nvGrpSpPr>
                  <p:cNvPr id="103" name="Group 102">
                    <a:extLst>
                      <a:ext uri="{FF2B5EF4-FFF2-40B4-BE49-F238E27FC236}">
                        <a16:creationId xmlns:a16="http://schemas.microsoft.com/office/drawing/2014/main" id="{4319799C-66DB-336D-BBF1-1159B0F6532E}"/>
                      </a:ext>
                    </a:extLst>
                  </p:cNvPr>
                  <p:cNvGrpSpPr/>
                  <p:nvPr/>
                </p:nvGrpSpPr>
                <p:grpSpPr>
                  <a:xfrm>
                    <a:off x="-275584" y="3068116"/>
                    <a:ext cx="4799475" cy="1135526"/>
                    <a:chOff x="-275584" y="3068116"/>
                    <a:chExt cx="4799475" cy="1135526"/>
                  </a:xfrm>
                </p:grpSpPr>
                <p:pic>
                  <p:nvPicPr>
                    <p:cNvPr id="98" name="Picture 97" descr="A picture containing text, ramp, trick, concrete&#10;&#10;Description automatically generated">
                      <a:extLst>
                        <a:ext uri="{FF2B5EF4-FFF2-40B4-BE49-F238E27FC236}">
                          <a16:creationId xmlns:a16="http://schemas.microsoft.com/office/drawing/2014/main" id="{8EAAE6D6-CC0B-8958-E52C-AD5A4B3F855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1987" t="31735" r="21647" b="29684"/>
                    <a:stretch/>
                  </p:blipFill>
                  <p:spPr>
                    <a:xfrm>
                      <a:off x="-275584" y="3068116"/>
                      <a:ext cx="2386532" cy="1135526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100" name="Picture 99" descr="A picture containing text, refrigerator&#10;&#10;Description automatically generated">
                      <a:extLst>
                        <a:ext uri="{FF2B5EF4-FFF2-40B4-BE49-F238E27FC236}">
                          <a16:creationId xmlns:a16="http://schemas.microsoft.com/office/drawing/2014/main" id="{AEF6B54C-538C-2905-DD5E-377347560DF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1540" t="30812" r="21798" b="30298"/>
                    <a:stretch/>
                  </p:blipFill>
                  <p:spPr>
                    <a:xfrm>
                      <a:off x="2145707" y="3068116"/>
                      <a:ext cx="2378184" cy="1135526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</p:grpSp>
          </p:grpSp>
        </p:grpSp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C3D73776-3424-7919-0805-54BB6E706683}"/>
                </a:ext>
              </a:extLst>
            </p:cNvPr>
            <p:cNvGrpSpPr/>
            <p:nvPr/>
          </p:nvGrpSpPr>
          <p:grpSpPr>
            <a:xfrm>
              <a:off x="918359" y="4391778"/>
              <a:ext cx="319606" cy="1476116"/>
              <a:chOff x="918359" y="4391778"/>
              <a:chExt cx="319606" cy="1476116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D31C92DF-E0E7-B873-8800-228ED473660A}"/>
                  </a:ext>
                </a:extLst>
              </p:cNvPr>
              <p:cNvGrpSpPr/>
              <p:nvPr/>
            </p:nvGrpSpPr>
            <p:grpSpPr>
              <a:xfrm>
                <a:off x="918359" y="4575719"/>
                <a:ext cx="319606" cy="1292175"/>
                <a:chOff x="529684" y="5043635"/>
                <a:chExt cx="319606" cy="1292175"/>
              </a:xfrm>
            </p:grpSpPr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74E168EC-DFEE-9BEC-BE50-19FFF836CBAE}"/>
                    </a:ext>
                  </a:extLst>
                </p:cNvPr>
                <p:cNvSpPr txBox="1"/>
                <p:nvPr/>
              </p:nvSpPr>
              <p:spPr>
                <a:xfrm>
                  <a:off x="543824" y="5321188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F062A9E8-5BB8-9627-AD29-E772F3DD96C3}"/>
                    </a:ext>
                  </a:extLst>
                </p:cNvPr>
                <p:cNvSpPr txBox="1"/>
                <p:nvPr/>
              </p:nvSpPr>
              <p:spPr>
                <a:xfrm>
                  <a:off x="540299" y="5516028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40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F4EF59DE-FCE6-B02B-DC06-AE9A6EDA8CF4}"/>
                    </a:ext>
                  </a:extLst>
                </p:cNvPr>
                <p:cNvSpPr txBox="1"/>
                <p:nvPr/>
              </p:nvSpPr>
              <p:spPr>
                <a:xfrm>
                  <a:off x="543824" y="5685535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35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E3975A54-3124-1945-6F3D-3AAA1E6EBA53}"/>
                    </a:ext>
                  </a:extLst>
                </p:cNvPr>
                <p:cNvSpPr txBox="1"/>
                <p:nvPr/>
              </p:nvSpPr>
              <p:spPr>
                <a:xfrm>
                  <a:off x="540300" y="6131509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15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9E8DA7A8-C2C2-9D2F-4C12-87CFA9118993}"/>
                    </a:ext>
                  </a:extLst>
                </p:cNvPr>
                <p:cNvSpPr txBox="1"/>
                <p:nvPr/>
              </p:nvSpPr>
              <p:spPr>
                <a:xfrm>
                  <a:off x="540300" y="5166789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70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1497EF5-D2D8-4614-73A6-51758A81EE38}"/>
                    </a:ext>
                  </a:extLst>
                </p:cNvPr>
                <p:cNvSpPr txBox="1"/>
                <p:nvPr/>
              </p:nvSpPr>
              <p:spPr>
                <a:xfrm>
                  <a:off x="529684" y="5043635"/>
                  <a:ext cx="31960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7050B909-B31F-E1A3-229A-6063F2EB14B9}"/>
                    </a:ext>
                  </a:extLst>
                </p:cNvPr>
                <p:cNvSpPr txBox="1"/>
                <p:nvPr/>
              </p:nvSpPr>
              <p:spPr>
                <a:xfrm>
                  <a:off x="550893" y="5847476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929170F-8F0E-6274-2ADE-6D4866728873}"/>
                  </a:ext>
                </a:extLst>
              </p:cNvPr>
              <p:cNvSpPr txBox="1"/>
              <p:nvPr/>
            </p:nvSpPr>
            <p:spPr>
              <a:xfrm>
                <a:off x="918359" y="4391778"/>
                <a:ext cx="31960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kDa</a:t>
                </a: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6DE799F4-D06B-F38D-39E8-F7603B530D82}"/>
                </a:ext>
              </a:extLst>
            </p:cNvPr>
            <p:cNvGrpSpPr/>
            <p:nvPr/>
          </p:nvGrpSpPr>
          <p:grpSpPr>
            <a:xfrm>
              <a:off x="948997" y="2955168"/>
              <a:ext cx="319606" cy="975807"/>
              <a:chOff x="918359" y="4892087"/>
              <a:chExt cx="319606" cy="975807"/>
            </a:xfrm>
          </p:grpSpPr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36CFE27C-3E09-FD6B-2C43-47BC98EA6603}"/>
                  </a:ext>
                </a:extLst>
              </p:cNvPr>
              <p:cNvGrpSpPr/>
              <p:nvPr/>
            </p:nvGrpSpPr>
            <p:grpSpPr>
              <a:xfrm>
                <a:off x="928974" y="5048112"/>
                <a:ext cx="287783" cy="819782"/>
                <a:chOff x="540299" y="5516028"/>
                <a:chExt cx="287783" cy="819782"/>
              </a:xfrm>
            </p:grpSpPr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B5456C3C-A150-9DB4-C5B2-9815FF2B09BF}"/>
                    </a:ext>
                  </a:extLst>
                </p:cNvPr>
                <p:cNvSpPr txBox="1"/>
                <p:nvPr/>
              </p:nvSpPr>
              <p:spPr>
                <a:xfrm>
                  <a:off x="540299" y="5516028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40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D5C74AC4-6C7B-7F84-AD85-DF8B39E923E3}"/>
                    </a:ext>
                  </a:extLst>
                </p:cNvPr>
                <p:cNvSpPr txBox="1"/>
                <p:nvPr/>
              </p:nvSpPr>
              <p:spPr>
                <a:xfrm>
                  <a:off x="543824" y="5685535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35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3887F89B-D524-1A2F-78EF-052206308715}"/>
                    </a:ext>
                  </a:extLst>
                </p:cNvPr>
                <p:cNvSpPr txBox="1"/>
                <p:nvPr/>
              </p:nvSpPr>
              <p:spPr>
                <a:xfrm>
                  <a:off x="540300" y="6131509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15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9951B57F-05BE-2D05-1942-AA7E81CFAB8F}"/>
                    </a:ext>
                  </a:extLst>
                </p:cNvPr>
                <p:cNvSpPr txBox="1"/>
                <p:nvPr/>
              </p:nvSpPr>
              <p:spPr>
                <a:xfrm>
                  <a:off x="550893" y="5847476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0DDDBF94-599C-4B4C-5E86-A47D6DC60AB6}"/>
                  </a:ext>
                </a:extLst>
              </p:cNvPr>
              <p:cNvSpPr txBox="1"/>
              <p:nvPr/>
            </p:nvSpPr>
            <p:spPr>
              <a:xfrm>
                <a:off x="918359" y="4892087"/>
                <a:ext cx="31960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kDa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451055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>
            <a:extLst>
              <a:ext uri="{FF2B5EF4-FFF2-40B4-BE49-F238E27FC236}">
                <a16:creationId xmlns:a16="http://schemas.microsoft.com/office/drawing/2014/main" id="{BFD325E2-E65C-2D57-E618-F0C1A0B81C3C}"/>
              </a:ext>
            </a:extLst>
          </p:cNvPr>
          <p:cNvSpPr txBox="1"/>
          <p:nvPr/>
        </p:nvSpPr>
        <p:spPr>
          <a:xfrm>
            <a:off x="584068" y="956912"/>
            <a:ext cx="6443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7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FD8698F-FFC4-C6D3-8B5D-680549CDB1D8}"/>
              </a:ext>
            </a:extLst>
          </p:cNvPr>
          <p:cNvSpPr txBox="1"/>
          <p:nvPr/>
        </p:nvSpPr>
        <p:spPr>
          <a:xfrm>
            <a:off x="935036" y="7528743"/>
            <a:ext cx="32427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bodies: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-Actin, 3700S – </a:t>
            </a:r>
            <a:r>
              <a:rPr lang="en-AU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Cel</a:t>
            </a:r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 Technology, 1:1000 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1, ab180599 – Abcam, 1:1000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2, 14966-1-AP – Proteintech, 1:100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3CDAE5B6-3FD7-7B8F-499A-97BEE58368EA}"/>
              </a:ext>
            </a:extLst>
          </p:cNvPr>
          <p:cNvGrpSpPr/>
          <p:nvPr/>
        </p:nvGrpSpPr>
        <p:grpSpPr>
          <a:xfrm>
            <a:off x="2142581" y="6639826"/>
            <a:ext cx="872942" cy="707236"/>
            <a:chOff x="2137339" y="6026741"/>
            <a:chExt cx="872942" cy="707236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012DB14-5E1C-AE83-BBAC-6F8C5828F7D0}"/>
                </a:ext>
              </a:extLst>
            </p:cNvPr>
            <p:cNvSpPr txBox="1"/>
            <p:nvPr/>
          </p:nvSpPr>
          <p:spPr>
            <a:xfrm rot="2496685">
              <a:off x="2137339" y="6026741"/>
              <a:ext cx="292388" cy="660725"/>
            </a:xfrm>
            <a:prstGeom prst="rect">
              <a:avLst/>
            </a:prstGeom>
            <a:noFill/>
          </p:spPr>
          <p:txBody>
            <a:bodyPr vert="vert270" wrap="square" rtlCol="0" anchor="b">
              <a:spAutoFit/>
            </a:bodyPr>
            <a:lstStyle/>
            <a:p>
              <a:r>
                <a:rPr lang="en-GB" sz="7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Control shRN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C173A08-24DF-5BFA-B92D-FFB01B3B13D6}"/>
                </a:ext>
              </a:extLst>
            </p:cNvPr>
            <p:cNvSpPr txBox="1"/>
            <p:nvPr/>
          </p:nvSpPr>
          <p:spPr>
            <a:xfrm rot="2496685">
              <a:off x="2347590" y="6034155"/>
              <a:ext cx="292388" cy="660725"/>
            </a:xfrm>
            <a:prstGeom prst="rect">
              <a:avLst/>
            </a:prstGeom>
            <a:noFill/>
          </p:spPr>
          <p:txBody>
            <a:bodyPr vert="vert270" wrap="square" rtlCol="0" anchor="b">
              <a:spAutoFit/>
            </a:bodyPr>
            <a:lstStyle/>
            <a:p>
              <a:r>
                <a:rPr lang="en-GB" sz="7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DDAH1 shRNA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DCBFDCE-769C-2757-63EF-2D45B6A134FA}"/>
                </a:ext>
              </a:extLst>
            </p:cNvPr>
            <p:cNvSpPr txBox="1"/>
            <p:nvPr/>
          </p:nvSpPr>
          <p:spPr>
            <a:xfrm rot="2496685">
              <a:off x="2526979" y="6055210"/>
              <a:ext cx="292388" cy="678744"/>
            </a:xfrm>
            <a:prstGeom prst="rect">
              <a:avLst/>
            </a:prstGeom>
            <a:noFill/>
          </p:spPr>
          <p:txBody>
            <a:bodyPr vert="vert270" wrap="square" rtlCol="0" anchor="b">
              <a:spAutoFit/>
            </a:bodyPr>
            <a:lstStyle/>
            <a:p>
              <a:r>
                <a:rPr lang="en-GB" sz="7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DDAH2 shRNA 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5259D3A-19A8-B788-A41B-76F3D8FBF6A7}"/>
                </a:ext>
              </a:extLst>
            </p:cNvPr>
            <p:cNvSpPr txBox="1"/>
            <p:nvPr/>
          </p:nvSpPr>
          <p:spPr>
            <a:xfrm rot="2496685">
              <a:off x="2717893" y="6055233"/>
              <a:ext cx="292388" cy="678744"/>
            </a:xfrm>
            <a:prstGeom prst="rect">
              <a:avLst/>
            </a:prstGeom>
            <a:noFill/>
          </p:spPr>
          <p:txBody>
            <a:bodyPr vert="vert270" wrap="square" rtlCol="0" anchor="b">
              <a:spAutoFit/>
            </a:bodyPr>
            <a:lstStyle/>
            <a:p>
              <a:r>
                <a:rPr lang="en-GB" sz="7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DDAH2 shRNA 2</a:t>
              </a:r>
            </a:p>
          </p:txBody>
        </p: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D41B7DB5-9D40-0358-E388-7CD0F5AF8ABC}"/>
              </a:ext>
            </a:extLst>
          </p:cNvPr>
          <p:cNvGrpSpPr/>
          <p:nvPr/>
        </p:nvGrpSpPr>
        <p:grpSpPr>
          <a:xfrm>
            <a:off x="1865896" y="2513394"/>
            <a:ext cx="3847829" cy="4829023"/>
            <a:chOff x="1865896" y="2513394"/>
            <a:chExt cx="3847829" cy="4829023"/>
          </a:xfrm>
        </p:grpSpPr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F5B57F8F-9096-7F3A-2580-8CED3B007351}"/>
                </a:ext>
              </a:extLst>
            </p:cNvPr>
            <p:cNvGrpSpPr/>
            <p:nvPr/>
          </p:nvGrpSpPr>
          <p:grpSpPr>
            <a:xfrm>
              <a:off x="1865896" y="2589100"/>
              <a:ext cx="2015689" cy="4162434"/>
              <a:chOff x="1865896" y="2589100"/>
              <a:chExt cx="2015689" cy="4162434"/>
            </a:xfrm>
          </p:grpSpPr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131EBAD2-F3DB-E4BE-67DE-06D4C48D69DF}"/>
                  </a:ext>
                </a:extLst>
              </p:cNvPr>
              <p:cNvGrpSpPr/>
              <p:nvPr/>
            </p:nvGrpSpPr>
            <p:grpSpPr>
              <a:xfrm>
                <a:off x="2124229" y="2589100"/>
                <a:ext cx="1757356" cy="4162434"/>
                <a:chOff x="1848605" y="3134172"/>
                <a:chExt cx="1757356" cy="4162434"/>
              </a:xfrm>
            </p:grpSpPr>
            <p:grpSp>
              <p:nvGrpSpPr>
                <p:cNvPr id="51" name="Group 50">
                  <a:extLst>
                    <a:ext uri="{FF2B5EF4-FFF2-40B4-BE49-F238E27FC236}">
                      <a16:creationId xmlns:a16="http://schemas.microsoft.com/office/drawing/2014/main" id="{A5C76B79-044F-DFC2-831F-7A72C3ECD204}"/>
                    </a:ext>
                  </a:extLst>
                </p:cNvPr>
                <p:cNvGrpSpPr/>
                <p:nvPr/>
              </p:nvGrpSpPr>
              <p:grpSpPr>
                <a:xfrm>
                  <a:off x="1848605" y="3134172"/>
                  <a:ext cx="1289050" cy="4162434"/>
                  <a:chOff x="1848605" y="3134172"/>
                  <a:chExt cx="1289050" cy="4162434"/>
                </a:xfrm>
              </p:grpSpPr>
              <p:graphicFrame>
                <p:nvGraphicFramePr>
                  <p:cNvPr id="2" name="Object 1">
                    <a:extLst>
                      <a:ext uri="{FF2B5EF4-FFF2-40B4-BE49-F238E27FC236}">
                        <a16:creationId xmlns:a16="http://schemas.microsoft.com/office/drawing/2014/main" id="{72BEA04D-76AA-593B-E776-5F6B191EE3F7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122475862"/>
                      </p:ext>
                    </p:extLst>
                  </p:nvPr>
                </p:nvGraphicFramePr>
                <p:xfrm>
                  <a:off x="1999417" y="3134172"/>
                  <a:ext cx="987425" cy="18065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r:id="rId2" imgW="987480" imgH="1807200" progId="">
                          <p:embed/>
                        </p:oleObj>
                      </mc:Choice>
                      <mc:Fallback>
                        <p:oleObj r:id="rId2" imgW="987480" imgH="1807200" progId="">
                          <p:embed/>
                          <p:pic>
                            <p:nvPicPr>
                              <p:cNvPr id="3" name="Object 2">
                                <a:extLst>
                                  <a:ext uri="{FF2B5EF4-FFF2-40B4-BE49-F238E27FC236}">
                                    <a16:creationId xmlns:a16="http://schemas.microsoft.com/office/drawing/2014/main" id="{81F0F720-A418-750A-9BB1-A2783158B21F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999417" y="3134172"/>
                                <a:ext cx="987425" cy="1806575"/>
                              </a:xfrm>
                              <a:prstGeom prst="rect">
                                <a:avLst/>
                              </a:prstGeom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4" name="Object 3">
                    <a:extLst>
                      <a:ext uri="{FF2B5EF4-FFF2-40B4-BE49-F238E27FC236}">
                        <a16:creationId xmlns:a16="http://schemas.microsoft.com/office/drawing/2014/main" id="{56BAECE7-CC5A-BC7E-B782-207C3166FF25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688130883"/>
                      </p:ext>
                    </p:extLst>
                  </p:nvPr>
                </p:nvGraphicFramePr>
                <p:xfrm>
                  <a:off x="1848605" y="5059819"/>
                  <a:ext cx="1289050" cy="2236787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r:id="rId4" imgW="1212840" imgH="2103120" progId="">
                          <p:embed/>
                        </p:oleObj>
                      </mc:Choice>
                      <mc:Fallback>
                        <p:oleObj r:id="rId4" imgW="1212840" imgH="2103120" progId="">
                          <p:embed/>
                          <p:pic>
                            <p:nvPicPr>
                              <p:cNvPr id="6" name="Object 5">
                                <a:extLst>
                                  <a:ext uri="{FF2B5EF4-FFF2-40B4-BE49-F238E27FC236}">
                                    <a16:creationId xmlns:a16="http://schemas.microsoft.com/office/drawing/2014/main" id="{12A8EEE4-49CE-5EF9-117F-E3667246467A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848605" y="5059819"/>
                                <a:ext cx="1289050" cy="2236787"/>
                              </a:xfrm>
                              <a:prstGeom prst="rect">
                                <a:avLst/>
                              </a:prstGeom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grpSp>
              <p:nvGrpSpPr>
                <p:cNvPr id="54" name="Group 53">
                  <a:extLst>
                    <a:ext uri="{FF2B5EF4-FFF2-40B4-BE49-F238E27FC236}">
                      <a16:creationId xmlns:a16="http://schemas.microsoft.com/office/drawing/2014/main" id="{204F1590-19F6-2BF9-D26F-2CA7AB9285F2}"/>
                    </a:ext>
                  </a:extLst>
                </p:cNvPr>
                <p:cNvGrpSpPr/>
                <p:nvPr/>
              </p:nvGrpSpPr>
              <p:grpSpPr>
                <a:xfrm>
                  <a:off x="2962408" y="3946576"/>
                  <a:ext cx="643553" cy="2511648"/>
                  <a:chOff x="2962408" y="3946576"/>
                  <a:chExt cx="643553" cy="2511648"/>
                </a:xfrm>
              </p:grpSpPr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C05BD3A0-1014-E896-DE56-C7F9E34934BD}"/>
                      </a:ext>
                    </a:extLst>
                  </p:cNvPr>
                  <p:cNvSpPr txBox="1"/>
                  <p:nvPr/>
                </p:nvSpPr>
                <p:spPr>
                  <a:xfrm>
                    <a:off x="3092679" y="6227392"/>
                    <a:ext cx="513282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</a:t>
                    </a:r>
                  </a:p>
                </p:txBody>
              </p:sp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9657FFF1-41B1-5FB1-3360-54E6660E80E3}"/>
                      </a:ext>
                    </a:extLst>
                  </p:cNvPr>
                  <p:cNvSpPr txBox="1"/>
                  <p:nvPr/>
                </p:nvSpPr>
                <p:spPr>
                  <a:xfrm>
                    <a:off x="2962408" y="3946576"/>
                    <a:ext cx="495649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l-GR" sz="9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β</a:t>
                    </a:r>
                    <a:r>
                      <a:rPr lang="en-AU" sz="9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-</a:t>
                    </a:r>
                    <a:r>
                      <a:rPr lang="en-US" sz="9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actin</a:t>
                    </a:r>
                  </a:p>
                </p:txBody>
              </p:sp>
            </p:grpSp>
          </p:grpSp>
          <p:grpSp>
            <p:nvGrpSpPr>
              <p:cNvPr id="78" name="Group 77">
                <a:extLst>
                  <a:ext uri="{FF2B5EF4-FFF2-40B4-BE49-F238E27FC236}">
                    <a16:creationId xmlns:a16="http://schemas.microsoft.com/office/drawing/2014/main" id="{34FBAF3E-ED7D-026D-CC93-A5310000631D}"/>
                  </a:ext>
                </a:extLst>
              </p:cNvPr>
              <p:cNvGrpSpPr/>
              <p:nvPr/>
            </p:nvGrpSpPr>
            <p:grpSpPr>
              <a:xfrm>
                <a:off x="1865896" y="4631493"/>
                <a:ext cx="321885" cy="1796715"/>
                <a:chOff x="1865896" y="4631493"/>
                <a:chExt cx="321885" cy="1796715"/>
              </a:xfrm>
            </p:grpSpPr>
            <p:grpSp>
              <p:nvGrpSpPr>
                <p:cNvPr id="24" name="Group 23">
                  <a:extLst>
                    <a:ext uri="{FF2B5EF4-FFF2-40B4-BE49-F238E27FC236}">
                      <a16:creationId xmlns:a16="http://schemas.microsoft.com/office/drawing/2014/main" id="{9F535CEB-C6F8-1D37-3B09-160B56A3596D}"/>
                    </a:ext>
                  </a:extLst>
                </p:cNvPr>
                <p:cNvGrpSpPr/>
                <p:nvPr/>
              </p:nvGrpSpPr>
              <p:grpSpPr>
                <a:xfrm>
                  <a:off x="1865896" y="4872435"/>
                  <a:ext cx="321885" cy="1555773"/>
                  <a:chOff x="529684" y="5019462"/>
                  <a:chExt cx="321885" cy="1203717"/>
                </a:xfrm>
              </p:grpSpPr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F7B06B17-EFF0-6872-5A47-798F0C4A3E03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205881"/>
                    <a:ext cx="277189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7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" name="TextBox 25">
                    <a:extLst>
                      <a:ext uri="{FF2B5EF4-FFF2-40B4-BE49-F238E27FC236}">
                        <a16:creationId xmlns:a16="http://schemas.microsoft.com/office/drawing/2014/main" id="{3D4186FC-C8C6-EFFD-F024-98D1468A44B0}"/>
                      </a:ext>
                    </a:extLst>
                  </p:cNvPr>
                  <p:cNvSpPr txBox="1"/>
                  <p:nvPr/>
                </p:nvSpPr>
                <p:spPr>
                  <a:xfrm>
                    <a:off x="546649" y="5430272"/>
                    <a:ext cx="277189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0853E33D-FE27-83E3-3C3D-1738986E5034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633949"/>
                    <a:ext cx="277189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7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500A4F2E-5E12-725E-5DB2-F63428A7097C}"/>
                      </a:ext>
                    </a:extLst>
                  </p:cNvPr>
                  <p:cNvSpPr txBox="1"/>
                  <p:nvPr/>
                </p:nvSpPr>
                <p:spPr>
                  <a:xfrm>
                    <a:off x="546649" y="6068394"/>
                    <a:ext cx="277189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" name="TextBox 28">
                    <a:extLst>
                      <a:ext uri="{FF2B5EF4-FFF2-40B4-BE49-F238E27FC236}">
                        <a16:creationId xmlns:a16="http://schemas.microsoft.com/office/drawing/2014/main" id="{44DBFE93-D19D-EEB3-1918-DC36DE9BE1AB}"/>
                      </a:ext>
                    </a:extLst>
                  </p:cNvPr>
                  <p:cNvSpPr txBox="1"/>
                  <p:nvPr/>
                </p:nvSpPr>
                <p:spPr>
                  <a:xfrm>
                    <a:off x="531963" y="5122070"/>
                    <a:ext cx="319606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0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0DBAB426-17D2-C654-FB9C-354D61FE9736}"/>
                      </a:ext>
                    </a:extLst>
                  </p:cNvPr>
                  <p:cNvSpPr txBox="1"/>
                  <p:nvPr/>
                </p:nvSpPr>
                <p:spPr>
                  <a:xfrm>
                    <a:off x="529684" y="5019462"/>
                    <a:ext cx="319606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id="{6953044C-D830-F724-23C5-92C0C6446D61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902247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A899EE17-EEC9-ADC4-BE47-A682950EFBF7}"/>
                    </a:ext>
                  </a:extLst>
                </p:cNvPr>
                <p:cNvSpPr txBox="1"/>
                <p:nvPr/>
              </p:nvSpPr>
              <p:spPr>
                <a:xfrm>
                  <a:off x="1865896" y="4631493"/>
                  <a:ext cx="319606" cy="2000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kDa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44D513FF-01F2-7EF3-7360-B624CDA46FE9}"/>
                  </a:ext>
                </a:extLst>
              </p:cNvPr>
              <p:cNvGrpSpPr/>
              <p:nvPr/>
            </p:nvGrpSpPr>
            <p:grpSpPr>
              <a:xfrm>
                <a:off x="2018630" y="2623469"/>
                <a:ext cx="328954" cy="1732981"/>
                <a:chOff x="2018630" y="2623469"/>
                <a:chExt cx="328954" cy="1732981"/>
              </a:xfrm>
            </p:grpSpPr>
            <p:grpSp>
              <p:nvGrpSpPr>
                <p:cNvPr id="70" name="Group 69">
                  <a:extLst>
                    <a:ext uri="{FF2B5EF4-FFF2-40B4-BE49-F238E27FC236}">
                      <a16:creationId xmlns:a16="http://schemas.microsoft.com/office/drawing/2014/main" id="{D3DE1EE6-9693-13DC-0689-761DA2B367CB}"/>
                    </a:ext>
                  </a:extLst>
                </p:cNvPr>
                <p:cNvGrpSpPr/>
                <p:nvPr/>
              </p:nvGrpSpPr>
              <p:grpSpPr>
                <a:xfrm>
                  <a:off x="2025699" y="2800677"/>
                  <a:ext cx="321885" cy="1555773"/>
                  <a:chOff x="529684" y="5019462"/>
                  <a:chExt cx="321885" cy="1203717"/>
                </a:xfrm>
              </p:grpSpPr>
              <p:sp>
                <p:nvSpPr>
                  <p:cNvPr id="71" name="TextBox 70">
                    <a:extLst>
                      <a:ext uri="{FF2B5EF4-FFF2-40B4-BE49-F238E27FC236}">
                        <a16:creationId xmlns:a16="http://schemas.microsoft.com/office/drawing/2014/main" id="{5065BD41-F142-3CD9-6F60-6AFAE4F6F168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205881"/>
                    <a:ext cx="277189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7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6FD158D3-8D2C-6799-3F0E-E66BC06F39BE}"/>
                      </a:ext>
                    </a:extLst>
                  </p:cNvPr>
                  <p:cNvSpPr txBox="1"/>
                  <p:nvPr/>
                </p:nvSpPr>
                <p:spPr>
                  <a:xfrm>
                    <a:off x="546649" y="5430272"/>
                    <a:ext cx="277189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8D029EC7-2748-E7ED-6F49-4F17B5761D74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633949"/>
                    <a:ext cx="277189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7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4" name="TextBox 73">
                    <a:extLst>
                      <a:ext uri="{FF2B5EF4-FFF2-40B4-BE49-F238E27FC236}">
                        <a16:creationId xmlns:a16="http://schemas.microsoft.com/office/drawing/2014/main" id="{0BD1FF9A-E6BD-425E-B1B5-0E95161B961E}"/>
                      </a:ext>
                    </a:extLst>
                  </p:cNvPr>
                  <p:cNvSpPr txBox="1"/>
                  <p:nvPr/>
                </p:nvSpPr>
                <p:spPr>
                  <a:xfrm>
                    <a:off x="546649" y="6068394"/>
                    <a:ext cx="277189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101F655B-23B1-6A5F-95A9-B3A6A42EB5D0}"/>
                      </a:ext>
                    </a:extLst>
                  </p:cNvPr>
                  <p:cNvSpPr txBox="1"/>
                  <p:nvPr/>
                </p:nvSpPr>
                <p:spPr>
                  <a:xfrm>
                    <a:off x="531963" y="5122070"/>
                    <a:ext cx="319606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0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6" name="TextBox 75">
                    <a:extLst>
                      <a:ext uri="{FF2B5EF4-FFF2-40B4-BE49-F238E27FC236}">
                        <a16:creationId xmlns:a16="http://schemas.microsoft.com/office/drawing/2014/main" id="{B156685A-20BC-CCA1-106D-CCB3DF066898}"/>
                      </a:ext>
                    </a:extLst>
                  </p:cNvPr>
                  <p:cNvSpPr txBox="1"/>
                  <p:nvPr/>
                </p:nvSpPr>
                <p:spPr>
                  <a:xfrm>
                    <a:off x="529684" y="5019462"/>
                    <a:ext cx="319606" cy="15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7" name="TextBox 76">
                    <a:extLst>
                      <a:ext uri="{FF2B5EF4-FFF2-40B4-BE49-F238E27FC236}">
                        <a16:creationId xmlns:a16="http://schemas.microsoft.com/office/drawing/2014/main" id="{0E9EB6BB-17CD-0EA4-1CD6-283191BB765D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902247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D5CC168C-75EA-E36F-E2CF-19DD28F48CBA}"/>
                    </a:ext>
                  </a:extLst>
                </p:cNvPr>
                <p:cNvSpPr txBox="1"/>
                <p:nvPr/>
              </p:nvSpPr>
              <p:spPr>
                <a:xfrm>
                  <a:off x="2018630" y="2623469"/>
                  <a:ext cx="319606" cy="2000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kDa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74494155-3556-A0E1-3323-756F50AE5F0B}"/>
                </a:ext>
              </a:extLst>
            </p:cNvPr>
            <p:cNvGrpSpPr/>
            <p:nvPr/>
          </p:nvGrpSpPr>
          <p:grpSpPr>
            <a:xfrm>
              <a:off x="3809230" y="2513394"/>
              <a:ext cx="1904495" cy="4829023"/>
              <a:chOff x="3809230" y="2513394"/>
              <a:chExt cx="1904495" cy="4829023"/>
            </a:xfrm>
          </p:grpSpPr>
          <p:grpSp>
            <p:nvGrpSpPr>
              <p:cNvPr id="92" name="Group 91">
                <a:extLst>
                  <a:ext uri="{FF2B5EF4-FFF2-40B4-BE49-F238E27FC236}">
                    <a16:creationId xmlns:a16="http://schemas.microsoft.com/office/drawing/2014/main" id="{2C2BFBE4-1651-6DB8-A0A8-4F1458E9EC52}"/>
                  </a:ext>
                </a:extLst>
              </p:cNvPr>
              <p:cNvGrpSpPr/>
              <p:nvPr/>
            </p:nvGrpSpPr>
            <p:grpSpPr>
              <a:xfrm>
                <a:off x="4056279" y="2663707"/>
                <a:ext cx="1657446" cy="4678710"/>
                <a:chOff x="4056279" y="2663707"/>
                <a:chExt cx="1657446" cy="4678710"/>
              </a:xfrm>
            </p:grpSpPr>
            <p:grpSp>
              <p:nvGrpSpPr>
                <p:cNvPr id="57" name="Group 56">
                  <a:extLst>
                    <a:ext uri="{FF2B5EF4-FFF2-40B4-BE49-F238E27FC236}">
                      <a16:creationId xmlns:a16="http://schemas.microsoft.com/office/drawing/2014/main" id="{7805853C-C818-8095-34C6-8EC39BC8F006}"/>
                    </a:ext>
                  </a:extLst>
                </p:cNvPr>
                <p:cNvGrpSpPr/>
                <p:nvPr/>
              </p:nvGrpSpPr>
              <p:grpSpPr>
                <a:xfrm>
                  <a:off x="4100511" y="2663707"/>
                  <a:ext cx="1613214" cy="4087827"/>
                  <a:chOff x="3595144" y="3220081"/>
                  <a:chExt cx="1613214" cy="4087827"/>
                </a:xfrm>
              </p:grpSpPr>
              <p:grpSp>
                <p:nvGrpSpPr>
                  <p:cNvPr id="50" name="Group 49">
                    <a:extLst>
                      <a:ext uri="{FF2B5EF4-FFF2-40B4-BE49-F238E27FC236}">
                        <a16:creationId xmlns:a16="http://schemas.microsoft.com/office/drawing/2014/main" id="{B89E04BB-CF65-80C7-5DB3-E63556828AA2}"/>
                      </a:ext>
                    </a:extLst>
                  </p:cNvPr>
                  <p:cNvGrpSpPr/>
                  <p:nvPr/>
                </p:nvGrpSpPr>
                <p:grpSpPr>
                  <a:xfrm>
                    <a:off x="3595144" y="3220081"/>
                    <a:ext cx="1099932" cy="4087827"/>
                    <a:chOff x="3595144" y="3220081"/>
                    <a:chExt cx="1099932" cy="4087827"/>
                  </a:xfrm>
                </p:grpSpPr>
                <p:graphicFrame>
                  <p:nvGraphicFramePr>
                    <p:cNvPr id="19" name="Object 18">
                      <a:extLst>
                        <a:ext uri="{FF2B5EF4-FFF2-40B4-BE49-F238E27FC236}">
                          <a16:creationId xmlns:a16="http://schemas.microsoft.com/office/drawing/2014/main" id="{E18504FF-AEDD-EF17-5C33-FA53C5D2FCCA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3641585196"/>
                        </p:ext>
                      </p:extLst>
                    </p:nvPr>
                  </p:nvGraphicFramePr>
                  <p:xfrm>
                    <a:off x="3595144" y="5071211"/>
                    <a:ext cx="1099932" cy="2236697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r:id="rId6" imgW="1042200" imgH="2121120" progId="">
                            <p:embed/>
                          </p:oleObj>
                        </mc:Choice>
                        <mc:Fallback>
                          <p:oleObj r:id="rId6" imgW="1042200" imgH="2121120" progId="">
                            <p:embed/>
                            <p:pic>
                              <p:nvPicPr>
                                <p:cNvPr id="5" name="Object 4">
                                  <a:extLst>
                                    <a:ext uri="{FF2B5EF4-FFF2-40B4-BE49-F238E27FC236}">
                                      <a16:creationId xmlns:a16="http://schemas.microsoft.com/office/drawing/2014/main" id="{968E5B86-5565-47B1-376A-8DE7180F7404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7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3595144" y="5071211"/>
                                  <a:ext cx="1099932" cy="2236697"/>
                                </a:xfrm>
                                <a:prstGeom prst="rect">
                                  <a:avLst/>
                                </a:prstGeom>
                                <a:ln>
                                  <a:solidFill>
                                    <a:schemeClr val="tx1"/>
                                  </a:solidFill>
                                </a:ln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aphicFrame>
                  <p:nvGraphicFramePr>
                    <p:cNvPr id="20" name="Object 19">
                      <a:extLst>
                        <a:ext uri="{FF2B5EF4-FFF2-40B4-BE49-F238E27FC236}">
                          <a16:creationId xmlns:a16="http://schemas.microsoft.com/office/drawing/2014/main" id="{82DF2725-1B54-0F9D-F413-9453E20E7215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3988177892"/>
                        </p:ext>
                      </p:extLst>
                    </p:nvPr>
                  </p:nvGraphicFramePr>
                  <p:xfrm>
                    <a:off x="3618122" y="3220081"/>
                    <a:ext cx="925513" cy="1758950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r:id="rId8" imgW="926280" imgH="1758600" progId="">
                            <p:embed/>
                          </p:oleObj>
                        </mc:Choice>
                        <mc:Fallback>
                          <p:oleObj r:id="rId8" imgW="926280" imgH="1758600" progId="">
                            <p:embed/>
                            <p:pic>
                              <p:nvPicPr>
                                <p:cNvPr id="8" name="Object 7">
                                  <a:extLst>
                                    <a:ext uri="{FF2B5EF4-FFF2-40B4-BE49-F238E27FC236}">
                                      <a16:creationId xmlns:a16="http://schemas.microsoft.com/office/drawing/2014/main" id="{0C8C0A43-269A-1E07-D98D-5DD66D248C18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9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3618122" y="3220081"/>
                                  <a:ext cx="925513" cy="1758950"/>
                                </a:xfrm>
                                <a:prstGeom prst="rect">
                                  <a:avLst/>
                                </a:prstGeom>
                                <a:ln>
                                  <a:solidFill>
                                    <a:schemeClr val="tx1"/>
                                  </a:solidFill>
                                </a:ln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</p:grpSp>
              <p:grpSp>
                <p:nvGrpSpPr>
                  <p:cNvPr id="56" name="Group 55">
                    <a:extLst>
                      <a:ext uri="{FF2B5EF4-FFF2-40B4-BE49-F238E27FC236}">
                        <a16:creationId xmlns:a16="http://schemas.microsoft.com/office/drawing/2014/main" id="{363BA9DC-42AE-A080-0ACE-366EF47442BC}"/>
                      </a:ext>
                    </a:extLst>
                  </p:cNvPr>
                  <p:cNvGrpSpPr/>
                  <p:nvPr/>
                </p:nvGrpSpPr>
                <p:grpSpPr>
                  <a:xfrm>
                    <a:off x="4695076" y="3959225"/>
                    <a:ext cx="513282" cy="2772127"/>
                    <a:chOff x="4695076" y="3959225"/>
                    <a:chExt cx="513282" cy="2772127"/>
                  </a:xfrm>
                </p:grpSpPr>
                <p:sp>
                  <p:nvSpPr>
                    <p:cNvPr id="47" name="TextBox 46">
                      <a:extLst>
                        <a:ext uri="{FF2B5EF4-FFF2-40B4-BE49-F238E27FC236}">
                          <a16:creationId xmlns:a16="http://schemas.microsoft.com/office/drawing/2014/main" id="{C11B4F4D-4618-5712-64F0-3565D9A358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95076" y="3959225"/>
                      <a:ext cx="49564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l-GR" sz="9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AU" sz="9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9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actin</a:t>
                      </a:r>
                    </a:p>
                  </p:txBody>
                </p: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324AEF1D-2569-9656-C44C-E5040F249D1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95076" y="6500520"/>
                      <a:ext cx="5132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2</a:t>
                      </a:r>
                    </a:p>
                  </p:txBody>
                </p:sp>
              </p:grpSp>
            </p:grpSp>
            <p:grpSp>
              <p:nvGrpSpPr>
                <p:cNvPr id="38" name="Group 37">
                  <a:extLst>
                    <a:ext uri="{FF2B5EF4-FFF2-40B4-BE49-F238E27FC236}">
                      <a16:creationId xmlns:a16="http://schemas.microsoft.com/office/drawing/2014/main" id="{993A6406-A285-61C5-56C4-B178839C4B3A}"/>
                    </a:ext>
                  </a:extLst>
                </p:cNvPr>
                <p:cNvGrpSpPr/>
                <p:nvPr/>
              </p:nvGrpSpPr>
              <p:grpSpPr>
                <a:xfrm>
                  <a:off x="4056279" y="6635181"/>
                  <a:ext cx="872942" cy="707236"/>
                  <a:chOff x="2137339" y="6026741"/>
                  <a:chExt cx="872942" cy="707236"/>
                </a:xfrm>
              </p:grpSpPr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17F1BD81-4557-CC36-26B2-04985078FA6A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2137339" y="6026741"/>
                    <a:ext cx="292388" cy="660725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Control shRNA</a:t>
                    </a:r>
                  </a:p>
                </p:txBody>
              </p:sp>
              <p:sp>
                <p:nvSpPr>
                  <p:cNvPr id="40" name="TextBox 39">
                    <a:extLst>
                      <a:ext uri="{FF2B5EF4-FFF2-40B4-BE49-F238E27FC236}">
                        <a16:creationId xmlns:a16="http://schemas.microsoft.com/office/drawing/2014/main" id="{5A2B7790-F47F-211E-CF2F-CCD7E08E3F32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2347590" y="6034155"/>
                    <a:ext cx="292388" cy="660725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1 shRNA</a:t>
                    </a:r>
                  </a:p>
                </p:txBody>
              </p:sp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4049E958-564D-E940-1E50-E9A8FF8F5913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2526979" y="6055210"/>
                    <a:ext cx="292388" cy="678744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2 shRNA 1</a:t>
                    </a:r>
                  </a:p>
                </p:txBody>
              </p: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7B86345C-9431-9DD1-46DF-89DF98E7D6FD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2717893" y="6055233"/>
                    <a:ext cx="292388" cy="678744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 anchor="b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2 shRNA 2</a:t>
                    </a:r>
                  </a:p>
                </p:txBody>
              </p:sp>
            </p:grpSp>
          </p:grpSp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3458A102-2A4A-EFA3-AAAB-3234A4E8969D}"/>
                  </a:ext>
                </a:extLst>
              </p:cNvPr>
              <p:cNvGrpSpPr/>
              <p:nvPr/>
            </p:nvGrpSpPr>
            <p:grpSpPr>
              <a:xfrm>
                <a:off x="3809230" y="4694285"/>
                <a:ext cx="346494" cy="1771149"/>
                <a:chOff x="3809230" y="4694285"/>
                <a:chExt cx="346494" cy="1771149"/>
              </a:xfrm>
            </p:grpSpPr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A56E8F30-5702-2C07-F1C0-106C926B7501}"/>
                    </a:ext>
                  </a:extLst>
                </p:cNvPr>
                <p:cNvGrpSpPr/>
                <p:nvPr/>
              </p:nvGrpSpPr>
              <p:grpSpPr>
                <a:xfrm>
                  <a:off x="3809230" y="4891285"/>
                  <a:ext cx="320694" cy="1574149"/>
                  <a:chOff x="529684" y="5019462"/>
                  <a:chExt cx="320694" cy="1217934"/>
                </a:xfrm>
              </p:grpSpPr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0027D7C1-C926-F380-6EB3-34210975D179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218164"/>
                    <a:ext cx="277189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7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A894A7ED-8C89-05FE-755F-9752668E7511}"/>
                      </a:ext>
                    </a:extLst>
                  </p:cNvPr>
                  <p:cNvSpPr txBox="1"/>
                  <p:nvPr/>
                </p:nvSpPr>
                <p:spPr>
                  <a:xfrm>
                    <a:off x="546649" y="5440098"/>
                    <a:ext cx="277189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0680C4CF-11A7-AFE4-664E-77D6A619C361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633949"/>
                    <a:ext cx="277189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7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A745B816-5D0C-A09E-B5C4-9FEDBDB9F1E4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2" y="6082612"/>
                    <a:ext cx="277189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89660251-8AAE-3516-6301-564CDCE91067}"/>
                      </a:ext>
                    </a:extLst>
                  </p:cNvPr>
                  <p:cNvSpPr txBox="1"/>
                  <p:nvPr/>
                </p:nvSpPr>
                <p:spPr>
                  <a:xfrm>
                    <a:off x="530772" y="5122070"/>
                    <a:ext cx="319606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0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87D07CCD-D7AE-19C3-81F1-6CF83AFE6F31}"/>
                      </a:ext>
                    </a:extLst>
                  </p:cNvPr>
                  <p:cNvSpPr txBox="1"/>
                  <p:nvPr/>
                </p:nvSpPr>
                <p:spPr>
                  <a:xfrm>
                    <a:off x="529684" y="5019462"/>
                    <a:ext cx="319606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F11C2DC4-776E-C9BB-D380-08839285E0A9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902247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FA2DDA05-5E3E-4426-9F90-20B51F41F02C}"/>
                    </a:ext>
                  </a:extLst>
                </p:cNvPr>
                <p:cNvSpPr txBox="1"/>
                <p:nvPr/>
              </p:nvSpPr>
              <p:spPr>
                <a:xfrm>
                  <a:off x="3836118" y="4694285"/>
                  <a:ext cx="319606" cy="2000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kDa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2" name="Group 81">
                <a:extLst>
                  <a:ext uri="{FF2B5EF4-FFF2-40B4-BE49-F238E27FC236}">
                    <a16:creationId xmlns:a16="http://schemas.microsoft.com/office/drawing/2014/main" id="{09080B27-CC68-18DF-58E2-6C8269DBA99D}"/>
                  </a:ext>
                </a:extLst>
              </p:cNvPr>
              <p:cNvGrpSpPr/>
              <p:nvPr/>
            </p:nvGrpSpPr>
            <p:grpSpPr>
              <a:xfrm>
                <a:off x="3840910" y="2513394"/>
                <a:ext cx="346494" cy="1771149"/>
                <a:chOff x="3809230" y="4694285"/>
                <a:chExt cx="346494" cy="1771149"/>
              </a:xfrm>
            </p:grpSpPr>
            <p:grpSp>
              <p:nvGrpSpPr>
                <p:cNvPr id="83" name="Group 82">
                  <a:extLst>
                    <a:ext uri="{FF2B5EF4-FFF2-40B4-BE49-F238E27FC236}">
                      <a16:creationId xmlns:a16="http://schemas.microsoft.com/office/drawing/2014/main" id="{CC5A95AE-ED62-E58D-93B2-C84AD311AE38}"/>
                    </a:ext>
                  </a:extLst>
                </p:cNvPr>
                <p:cNvGrpSpPr/>
                <p:nvPr/>
              </p:nvGrpSpPr>
              <p:grpSpPr>
                <a:xfrm>
                  <a:off x="3809230" y="4891285"/>
                  <a:ext cx="320694" cy="1574149"/>
                  <a:chOff x="529684" y="5019462"/>
                  <a:chExt cx="320694" cy="1217934"/>
                </a:xfrm>
              </p:grpSpPr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DEF1AD39-4331-E712-C1B4-B01C067EB9D3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218164"/>
                    <a:ext cx="277189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7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D6B0C23C-55A9-D9FC-CDE4-0DDBFB47446D}"/>
                      </a:ext>
                    </a:extLst>
                  </p:cNvPr>
                  <p:cNvSpPr txBox="1"/>
                  <p:nvPr/>
                </p:nvSpPr>
                <p:spPr>
                  <a:xfrm>
                    <a:off x="546649" y="5440098"/>
                    <a:ext cx="277189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7" name="TextBox 86">
                    <a:extLst>
                      <a:ext uri="{FF2B5EF4-FFF2-40B4-BE49-F238E27FC236}">
                        <a16:creationId xmlns:a16="http://schemas.microsoft.com/office/drawing/2014/main" id="{62519FF0-6E09-E81A-1149-E587F09378E4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633949"/>
                    <a:ext cx="277189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7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8" name="TextBox 87">
                    <a:extLst>
                      <a:ext uri="{FF2B5EF4-FFF2-40B4-BE49-F238E27FC236}">
                        <a16:creationId xmlns:a16="http://schemas.microsoft.com/office/drawing/2014/main" id="{AEE34608-38AD-A007-A3A3-31F40C8DD96A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2" y="6082612"/>
                    <a:ext cx="277189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9" name="TextBox 88">
                    <a:extLst>
                      <a:ext uri="{FF2B5EF4-FFF2-40B4-BE49-F238E27FC236}">
                        <a16:creationId xmlns:a16="http://schemas.microsoft.com/office/drawing/2014/main" id="{F02888C5-009D-3871-5318-7E320523DADB}"/>
                      </a:ext>
                    </a:extLst>
                  </p:cNvPr>
                  <p:cNvSpPr txBox="1"/>
                  <p:nvPr/>
                </p:nvSpPr>
                <p:spPr>
                  <a:xfrm>
                    <a:off x="530772" y="5122070"/>
                    <a:ext cx="319606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0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0" name="TextBox 89">
                    <a:extLst>
                      <a:ext uri="{FF2B5EF4-FFF2-40B4-BE49-F238E27FC236}">
                        <a16:creationId xmlns:a16="http://schemas.microsoft.com/office/drawing/2014/main" id="{A3AFC893-92DF-7AFF-C74F-59163253B68F}"/>
                      </a:ext>
                    </a:extLst>
                  </p:cNvPr>
                  <p:cNvSpPr txBox="1"/>
                  <p:nvPr/>
                </p:nvSpPr>
                <p:spPr>
                  <a:xfrm>
                    <a:off x="529684" y="5019462"/>
                    <a:ext cx="319606" cy="154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1" name="TextBox 90">
                    <a:extLst>
                      <a:ext uri="{FF2B5EF4-FFF2-40B4-BE49-F238E27FC236}">
                        <a16:creationId xmlns:a16="http://schemas.microsoft.com/office/drawing/2014/main" id="{A7CD4791-9367-3554-C3A1-0AF94F9A91A1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902247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A517AE59-777C-5B8B-865F-4E2EFF68E9E7}"/>
                    </a:ext>
                  </a:extLst>
                </p:cNvPr>
                <p:cNvSpPr txBox="1"/>
                <p:nvPr/>
              </p:nvSpPr>
              <p:spPr>
                <a:xfrm>
                  <a:off x="3836118" y="4694285"/>
                  <a:ext cx="319606" cy="2000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kDa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8324329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90327D84-78E1-42FD-C5BF-A1886AB6F564}"/>
              </a:ext>
            </a:extLst>
          </p:cNvPr>
          <p:cNvSpPr txBox="1"/>
          <p:nvPr/>
        </p:nvSpPr>
        <p:spPr>
          <a:xfrm>
            <a:off x="584068" y="956912"/>
            <a:ext cx="6443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8c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569FDF5-F019-453F-8446-8B2B1ED26F9D}"/>
              </a:ext>
            </a:extLst>
          </p:cNvPr>
          <p:cNvSpPr txBox="1"/>
          <p:nvPr/>
        </p:nvSpPr>
        <p:spPr>
          <a:xfrm>
            <a:off x="4880799" y="4375065"/>
            <a:ext cx="77346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latin typeface="Arial Narrow" panose="020B0606020202030204" pitchFamily="34" charset="0"/>
                <a:cs typeface="Arial" panose="020B0604020202020204" pitchFamily="34" charset="0"/>
              </a:rPr>
              <a:t>DDAH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391D151-F3C7-0239-E717-CDE34547DA69}"/>
              </a:ext>
            </a:extLst>
          </p:cNvPr>
          <p:cNvSpPr txBox="1"/>
          <p:nvPr/>
        </p:nvSpPr>
        <p:spPr>
          <a:xfrm>
            <a:off x="935036" y="7528743"/>
            <a:ext cx="32427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bodies: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α-tubulin, T5168 – Sigma Aldrich, 1:5000  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1, PA5-52278 – ThermoFisher Scientific, 1:1000 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2, STJ2850 –St John’s Laboratory, 1:100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FAE86BE1-053D-E69B-280C-78F1AAD557D6}"/>
              </a:ext>
            </a:extLst>
          </p:cNvPr>
          <p:cNvGrpSpPr/>
          <p:nvPr/>
        </p:nvGrpSpPr>
        <p:grpSpPr>
          <a:xfrm>
            <a:off x="782958" y="3737082"/>
            <a:ext cx="6015175" cy="2222639"/>
            <a:chOff x="782958" y="3737082"/>
            <a:chExt cx="6015175" cy="2222639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0E6F4989-92B1-F07F-ACDE-B034E1C33E92}"/>
                </a:ext>
              </a:extLst>
            </p:cNvPr>
            <p:cNvGrpSpPr/>
            <p:nvPr/>
          </p:nvGrpSpPr>
          <p:grpSpPr>
            <a:xfrm>
              <a:off x="783768" y="3959225"/>
              <a:ext cx="6014365" cy="2000496"/>
              <a:chOff x="675446" y="3959225"/>
              <a:chExt cx="6014365" cy="2000496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0C7567E8-4800-779A-3698-6340098010B1}"/>
                  </a:ext>
                </a:extLst>
              </p:cNvPr>
              <p:cNvGrpSpPr/>
              <p:nvPr/>
            </p:nvGrpSpPr>
            <p:grpSpPr>
              <a:xfrm>
                <a:off x="892089" y="3976441"/>
                <a:ext cx="5797722" cy="1983280"/>
                <a:chOff x="-400793" y="3311454"/>
                <a:chExt cx="5797722" cy="1983280"/>
              </a:xfrm>
            </p:grpSpPr>
            <p:grpSp>
              <p:nvGrpSpPr>
                <p:cNvPr id="18" name="Group 17">
                  <a:extLst>
                    <a:ext uri="{FF2B5EF4-FFF2-40B4-BE49-F238E27FC236}">
                      <a16:creationId xmlns:a16="http://schemas.microsoft.com/office/drawing/2014/main" id="{86C6758D-C312-F5B2-5ABD-B5385879F59C}"/>
                    </a:ext>
                  </a:extLst>
                </p:cNvPr>
                <p:cNvGrpSpPr/>
                <p:nvPr/>
              </p:nvGrpSpPr>
              <p:grpSpPr>
                <a:xfrm>
                  <a:off x="-400793" y="3343935"/>
                  <a:ext cx="2672643" cy="1950799"/>
                  <a:chOff x="-472988" y="3343935"/>
                  <a:chExt cx="2672643" cy="1950799"/>
                </a:xfrm>
              </p:grpSpPr>
              <p:pic>
                <p:nvPicPr>
                  <p:cNvPr id="4" name="Рисунок 2">
                    <a:extLst>
                      <a:ext uri="{FF2B5EF4-FFF2-40B4-BE49-F238E27FC236}">
                        <a16:creationId xmlns:a16="http://schemas.microsoft.com/office/drawing/2014/main" id="{950F8E34-D2C7-3248-6D1E-29A5A44A930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0155" t="34976" r="16731" b="36261"/>
                  <a:stretch/>
                </p:blipFill>
                <p:spPr>
                  <a:xfrm>
                    <a:off x="-370026" y="4064026"/>
                    <a:ext cx="2569681" cy="958466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3" name="Рисунок 5">
                    <a:extLst>
                      <a:ext uri="{FF2B5EF4-FFF2-40B4-BE49-F238E27FC236}">
                        <a16:creationId xmlns:a16="http://schemas.microsoft.com/office/drawing/2014/main" id="{8C4053FE-B9B2-CF5E-126D-69B5F6EA884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9457" t="22051" r="17139" b="56184"/>
                  <a:stretch/>
                </p:blipFill>
                <p:spPr>
                  <a:xfrm>
                    <a:off x="-363827" y="3343935"/>
                    <a:ext cx="2548800" cy="716125"/>
                  </a:xfrm>
                  <a:prstGeom prst="rect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</p:pic>
              <p:grpSp>
                <p:nvGrpSpPr>
                  <p:cNvPr id="81" name="Group 80">
                    <a:extLst>
                      <a:ext uri="{FF2B5EF4-FFF2-40B4-BE49-F238E27FC236}">
                        <a16:creationId xmlns:a16="http://schemas.microsoft.com/office/drawing/2014/main" id="{AC805096-945D-4B6B-A9E1-FB880B2A3F0F}"/>
                      </a:ext>
                    </a:extLst>
                  </p:cNvPr>
                  <p:cNvGrpSpPr/>
                  <p:nvPr/>
                </p:nvGrpSpPr>
                <p:grpSpPr>
                  <a:xfrm>
                    <a:off x="-472988" y="5066772"/>
                    <a:ext cx="2513844" cy="227962"/>
                    <a:chOff x="1515763" y="6608366"/>
                    <a:chExt cx="2830463" cy="674384"/>
                  </a:xfrm>
                </p:grpSpPr>
                <p:sp>
                  <p:nvSpPr>
                    <p:cNvPr id="82" name="TextBox 81">
                      <a:extLst>
                        <a:ext uri="{FF2B5EF4-FFF2-40B4-BE49-F238E27FC236}">
                          <a16:creationId xmlns:a16="http://schemas.microsoft.com/office/drawing/2014/main" id="{04479705-A7C1-4543-8E70-D15AC0CDFF68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1515763" y="6608366"/>
                      <a:ext cx="561717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liver</a:t>
                      </a:r>
                    </a:p>
                  </p:txBody>
                </p:sp>
                <p:sp>
                  <p:nvSpPr>
                    <p:cNvPr id="83" name="TextBox 82">
                      <a:extLst>
                        <a:ext uri="{FF2B5EF4-FFF2-40B4-BE49-F238E27FC236}">
                          <a16:creationId xmlns:a16="http://schemas.microsoft.com/office/drawing/2014/main" id="{31AD2F96-60F7-48D1-A561-3A26E9D5DC0F}"/>
                        </a:ext>
                      </a:extLst>
                    </p:cNvPr>
                    <p:cNvSpPr txBox="1"/>
                    <p:nvPr/>
                  </p:nvSpPr>
                  <p:spPr>
                    <a:xfrm rot="19162583">
                      <a:off x="1706581" y="6682306"/>
                      <a:ext cx="648044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kidney</a:t>
                      </a:r>
                    </a:p>
                  </p:txBody>
                </p:sp>
                <p:sp>
                  <p:nvSpPr>
                    <p:cNvPr id="84" name="TextBox 83">
                      <a:extLst>
                        <a:ext uri="{FF2B5EF4-FFF2-40B4-BE49-F238E27FC236}">
                          <a16:creationId xmlns:a16="http://schemas.microsoft.com/office/drawing/2014/main" id="{48B2834F-8CC4-424A-9F51-2F748A8AD268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2286200" y="6642257"/>
                      <a:ext cx="562580" cy="58839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lung</a:t>
                      </a:r>
                    </a:p>
                  </p:txBody>
                </p:sp>
                <p:sp>
                  <p:nvSpPr>
                    <p:cNvPr id="85" name="TextBox 84">
                      <a:extLst>
                        <a:ext uri="{FF2B5EF4-FFF2-40B4-BE49-F238E27FC236}">
                          <a16:creationId xmlns:a16="http://schemas.microsoft.com/office/drawing/2014/main" id="{9013E5AC-86CB-4411-93BA-949B221DA2E8}"/>
                        </a:ext>
                      </a:extLst>
                    </p:cNvPr>
                    <p:cNvSpPr txBox="1"/>
                    <p:nvPr/>
                  </p:nvSpPr>
                  <p:spPr>
                    <a:xfrm rot="19162583">
                      <a:off x="2536931" y="6608369"/>
                      <a:ext cx="597503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brain</a:t>
                      </a:r>
                    </a:p>
                  </p:txBody>
                </p:sp>
                <p:sp>
                  <p:nvSpPr>
                    <p:cNvPr id="86" name="TextBox 85">
                      <a:extLst>
                        <a:ext uri="{FF2B5EF4-FFF2-40B4-BE49-F238E27FC236}">
                          <a16:creationId xmlns:a16="http://schemas.microsoft.com/office/drawing/2014/main" id="{DB684ADA-DA5B-4023-981B-98C78CAF9509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3524445" y="6611386"/>
                      <a:ext cx="539935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lung</a:t>
                      </a:r>
                    </a:p>
                  </p:txBody>
                </p:sp>
                <p:sp>
                  <p:nvSpPr>
                    <p:cNvPr id="87" name="TextBox 86">
                      <a:extLst>
                        <a:ext uri="{FF2B5EF4-FFF2-40B4-BE49-F238E27FC236}">
                          <a16:creationId xmlns:a16="http://schemas.microsoft.com/office/drawing/2014/main" id="{30FDACCC-6BB9-49CF-832A-BB51725707CD}"/>
                        </a:ext>
                      </a:extLst>
                    </p:cNvPr>
                    <p:cNvSpPr txBox="1"/>
                    <p:nvPr/>
                  </p:nvSpPr>
                  <p:spPr>
                    <a:xfrm rot="19162583">
                      <a:off x="3247498" y="6648132"/>
                      <a:ext cx="592880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heart</a:t>
                      </a:r>
                    </a:p>
                  </p:txBody>
                </p:sp>
                <p:sp>
                  <p:nvSpPr>
                    <p:cNvPr id="88" name="TextBox 87">
                      <a:extLst>
                        <a:ext uri="{FF2B5EF4-FFF2-40B4-BE49-F238E27FC236}">
                          <a16:creationId xmlns:a16="http://schemas.microsoft.com/office/drawing/2014/main" id="{F840D5B9-72BB-4695-9D95-903AE55CD976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2800908" y="6633994"/>
                      <a:ext cx="530062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liver</a:t>
                      </a:r>
                    </a:p>
                  </p:txBody>
                </p:sp>
                <p:sp>
                  <p:nvSpPr>
                    <p:cNvPr id="89" name="TextBox 88">
                      <a:extLst>
                        <a:ext uri="{FF2B5EF4-FFF2-40B4-BE49-F238E27FC236}">
                          <a16:creationId xmlns:a16="http://schemas.microsoft.com/office/drawing/2014/main" id="{A63A6DB1-0982-451F-8B9F-17C030850E4F}"/>
                        </a:ext>
                      </a:extLst>
                    </p:cNvPr>
                    <p:cNvSpPr txBox="1"/>
                    <p:nvPr/>
                  </p:nvSpPr>
                  <p:spPr>
                    <a:xfrm rot="19162583">
                      <a:off x="2952727" y="6690924"/>
                      <a:ext cx="624883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kidney</a:t>
                      </a:r>
                    </a:p>
                  </p:txBody>
                </p:sp>
                <p:sp>
                  <p:nvSpPr>
                    <p:cNvPr id="90" name="TextBox 89">
                      <a:extLst>
                        <a:ext uri="{FF2B5EF4-FFF2-40B4-BE49-F238E27FC236}">
                          <a16:creationId xmlns:a16="http://schemas.microsoft.com/office/drawing/2014/main" id="{1334175D-7F14-489D-9944-FC729231C53D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3779616" y="6632355"/>
                      <a:ext cx="566610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brain</a:t>
                      </a:r>
                    </a:p>
                  </p:txBody>
                </p:sp>
                <p:sp>
                  <p:nvSpPr>
                    <p:cNvPr id="91" name="TextBox 90">
                      <a:extLst>
                        <a:ext uri="{FF2B5EF4-FFF2-40B4-BE49-F238E27FC236}">
                          <a16:creationId xmlns:a16="http://schemas.microsoft.com/office/drawing/2014/main" id="{B7FC4EA4-BB0E-4328-A051-47539E149A7D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2016427" y="6667571"/>
                      <a:ext cx="579794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heart</a:t>
                      </a:r>
                    </a:p>
                  </p:txBody>
                </p:sp>
              </p:grpSp>
            </p:grpSp>
            <p:grpSp>
              <p:nvGrpSpPr>
                <p:cNvPr id="19" name="Group 18">
                  <a:extLst>
                    <a:ext uri="{FF2B5EF4-FFF2-40B4-BE49-F238E27FC236}">
                      <a16:creationId xmlns:a16="http://schemas.microsoft.com/office/drawing/2014/main" id="{C2430A85-E2BF-9344-D34F-D69182A83D68}"/>
                    </a:ext>
                  </a:extLst>
                </p:cNvPr>
                <p:cNvGrpSpPr/>
                <p:nvPr/>
              </p:nvGrpSpPr>
              <p:grpSpPr>
                <a:xfrm>
                  <a:off x="2174175" y="3311454"/>
                  <a:ext cx="3222754" cy="1969327"/>
                  <a:chOff x="2174175" y="3311454"/>
                  <a:chExt cx="3222754" cy="1969327"/>
                </a:xfrm>
              </p:grpSpPr>
              <p:grpSp>
                <p:nvGrpSpPr>
                  <p:cNvPr id="43" name="Group 42">
                    <a:extLst>
                      <a:ext uri="{FF2B5EF4-FFF2-40B4-BE49-F238E27FC236}">
                        <a16:creationId xmlns:a16="http://schemas.microsoft.com/office/drawing/2014/main" id="{E264D15B-2C90-32B5-2065-986650EE0279}"/>
                      </a:ext>
                    </a:extLst>
                  </p:cNvPr>
                  <p:cNvGrpSpPr/>
                  <p:nvPr/>
                </p:nvGrpSpPr>
                <p:grpSpPr>
                  <a:xfrm>
                    <a:off x="2327570" y="3311454"/>
                    <a:ext cx="2574898" cy="1725726"/>
                    <a:chOff x="4900636" y="1947228"/>
                    <a:chExt cx="2574898" cy="1725726"/>
                  </a:xfrm>
                </p:grpSpPr>
                <p:pic>
                  <p:nvPicPr>
                    <p:cNvPr id="36" name="Picture 35" descr="A picture containing text&#10;&#10;Description automatically generated">
                      <a:extLst>
                        <a:ext uri="{FF2B5EF4-FFF2-40B4-BE49-F238E27FC236}">
                          <a16:creationId xmlns:a16="http://schemas.microsoft.com/office/drawing/2014/main" id="{FC7BCADE-3A20-AB56-6B5F-565EB50CB81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 cstate="print">
                      <a:alphaModFix/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9612" t="27217" r="16396" b="54901"/>
                    <a:stretch/>
                  </p:blipFill>
                  <p:spPr>
                    <a:xfrm>
                      <a:off x="4905853" y="1947228"/>
                      <a:ext cx="2569681" cy="752278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42" name="Picture 41" descr="A picture containing screenshot&#10;&#10;Description automatically generated">
                      <a:extLst>
                        <a:ext uri="{FF2B5EF4-FFF2-40B4-BE49-F238E27FC236}">
                          <a16:creationId xmlns:a16="http://schemas.microsoft.com/office/drawing/2014/main" id="{14A7E1F1-5B24-9C55-2A1E-004C5D0E9B4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 cstate="print">
                      <a:alphaModFix/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0549" t="36624" r="17288" b="38499"/>
                    <a:stretch/>
                  </p:blipFill>
                  <p:spPr>
                    <a:xfrm>
                      <a:off x="4900636" y="2714488"/>
                      <a:ext cx="2569681" cy="958466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  <p:grpSp>
                <p:nvGrpSpPr>
                  <p:cNvPr id="79" name="Group 78">
                    <a:extLst>
                      <a:ext uri="{FF2B5EF4-FFF2-40B4-BE49-F238E27FC236}">
                        <a16:creationId xmlns:a16="http://schemas.microsoft.com/office/drawing/2014/main" id="{C2FCE00C-7961-4F41-BD1F-CFF5BA16AF9C}"/>
                      </a:ext>
                    </a:extLst>
                  </p:cNvPr>
                  <p:cNvGrpSpPr/>
                  <p:nvPr/>
                </p:nvGrpSpPr>
                <p:grpSpPr>
                  <a:xfrm>
                    <a:off x="4880779" y="3782172"/>
                    <a:ext cx="516150" cy="643788"/>
                    <a:chOff x="4649025" y="2846986"/>
                    <a:chExt cx="879168" cy="1904536"/>
                  </a:xfrm>
                </p:grpSpPr>
                <p:sp>
                  <p:nvSpPr>
                    <p:cNvPr id="95" name="TextBox 94">
                      <a:extLst>
                        <a:ext uri="{FF2B5EF4-FFF2-40B4-BE49-F238E27FC236}">
                          <a16:creationId xmlns:a16="http://schemas.microsoft.com/office/drawing/2014/main" id="{2DF3D038-A550-4E4A-B960-B5976FE6980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57305" y="2846986"/>
                      <a:ext cx="870888" cy="2167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l-GR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-tubulin</a:t>
                      </a:r>
                    </a:p>
                  </p:txBody>
                </p:sp>
                <p:sp>
                  <p:nvSpPr>
                    <p:cNvPr id="96" name="TextBox 95">
                      <a:extLst>
                        <a:ext uri="{FF2B5EF4-FFF2-40B4-BE49-F238E27FC236}">
                          <a16:creationId xmlns:a16="http://schemas.microsoft.com/office/drawing/2014/main" id="{1030DA53-C3B9-443E-AAA9-5770EC80649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49025" y="4159694"/>
                      <a:ext cx="870899" cy="59182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</a:t>
                      </a:r>
                    </a:p>
                  </p:txBody>
                </p:sp>
              </p:grpSp>
              <p:grpSp>
                <p:nvGrpSpPr>
                  <p:cNvPr id="7" name="Group 6">
                    <a:extLst>
                      <a:ext uri="{FF2B5EF4-FFF2-40B4-BE49-F238E27FC236}">
                        <a16:creationId xmlns:a16="http://schemas.microsoft.com/office/drawing/2014/main" id="{95871B87-8DD7-19E9-BDAB-5394A4567FC2}"/>
                      </a:ext>
                    </a:extLst>
                  </p:cNvPr>
                  <p:cNvGrpSpPr/>
                  <p:nvPr/>
                </p:nvGrpSpPr>
                <p:grpSpPr>
                  <a:xfrm>
                    <a:off x="2174175" y="5052819"/>
                    <a:ext cx="2513844" cy="227962"/>
                    <a:chOff x="1515763" y="6608366"/>
                    <a:chExt cx="2830463" cy="674384"/>
                  </a:xfrm>
                </p:grpSpPr>
                <p:sp>
                  <p:nvSpPr>
                    <p:cNvPr id="8" name="TextBox 7">
                      <a:extLst>
                        <a:ext uri="{FF2B5EF4-FFF2-40B4-BE49-F238E27FC236}">
                          <a16:creationId xmlns:a16="http://schemas.microsoft.com/office/drawing/2014/main" id="{5EFB8507-C6AB-B70C-356D-1C42FB0A19C2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1515763" y="6608366"/>
                      <a:ext cx="561717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liver</a:t>
                      </a:r>
                    </a:p>
                  </p:txBody>
                </p:sp>
                <p:sp>
                  <p:nvSpPr>
                    <p:cNvPr id="9" name="TextBox 8">
                      <a:extLst>
                        <a:ext uri="{FF2B5EF4-FFF2-40B4-BE49-F238E27FC236}">
                          <a16:creationId xmlns:a16="http://schemas.microsoft.com/office/drawing/2014/main" id="{E321174A-CE2D-A81F-2245-6930A209D2CD}"/>
                        </a:ext>
                      </a:extLst>
                    </p:cNvPr>
                    <p:cNvSpPr txBox="1"/>
                    <p:nvPr/>
                  </p:nvSpPr>
                  <p:spPr>
                    <a:xfrm rot="19162583">
                      <a:off x="1706581" y="6682306"/>
                      <a:ext cx="648044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kidney</a:t>
                      </a:r>
                    </a:p>
                  </p:txBody>
                </p:sp>
                <p:sp>
                  <p:nvSpPr>
                    <p:cNvPr id="10" name="TextBox 9">
                      <a:extLst>
                        <a:ext uri="{FF2B5EF4-FFF2-40B4-BE49-F238E27FC236}">
                          <a16:creationId xmlns:a16="http://schemas.microsoft.com/office/drawing/2014/main" id="{834032FC-A7F9-5830-ECD9-26CE314F412B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2286200" y="6642257"/>
                      <a:ext cx="562580" cy="58839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lung</a:t>
                      </a:r>
                    </a:p>
                  </p:txBody>
                </p:sp>
                <p:sp>
                  <p:nvSpPr>
                    <p:cNvPr id="11" name="TextBox 10">
                      <a:extLst>
                        <a:ext uri="{FF2B5EF4-FFF2-40B4-BE49-F238E27FC236}">
                          <a16:creationId xmlns:a16="http://schemas.microsoft.com/office/drawing/2014/main" id="{F5A85F3D-BFF0-4A74-3BE0-C8552B6A1343}"/>
                        </a:ext>
                      </a:extLst>
                    </p:cNvPr>
                    <p:cNvSpPr txBox="1"/>
                    <p:nvPr/>
                  </p:nvSpPr>
                  <p:spPr>
                    <a:xfrm rot="19162583">
                      <a:off x="2536931" y="6608369"/>
                      <a:ext cx="597503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brain</a:t>
                      </a:r>
                    </a:p>
                  </p:txBody>
                </p:sp>
                <p:sp>
                  <p:nvSpPr>
                    <p:cNvPr id="12" name="TextBox 11">
                      <a:extLst>
                        <a:ext uri="{FF2B5EF4-FFF2-40B4-BE49-F238E27FC236}">
                          <a16:creationId xmlns:a16="http://schemas.microsoft.com/office/drawing/2014/main" id="{5DA14D23-B224-5869-A215-8BA457A7D08B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3524445" y="6611386"/>
                      <a:ext cx="539935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lung</a:t>
                      </a:r>
                    </a:p>
                  </p:txBody>
                </p:sp>
                <p:sp>
                  <p:nvSpPr>
                    <p:cNvPr id="13" name="TextBox 12">
                      <a:extLst>
                        <a:ext uri="{FF2B5EF4-FFF2-40B4-BE49-F238E27FC236}">
                          <a16:creationId xmlns:a16="http://schemas.microsoft.com/office/drawing/2014/main" id="{5235D689-BE51-A911-080C-B6004DFBBBD6}"/>
                        </a:ext>
                      </a:extLst>
                    </p:cNvPr>
                    <p:cNvSpPr txBox="1"/>
                    <p:nvPr/>
                  </p:nvSpPr>
                  <p:spPr>
                    <a:xfrm rot="19162583">
                      <a:off x="3247498" y="6648132"/>
                      <a:ext cx="592880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heart</a:t>
                      </a:r>
                    </a:p>
                  </p:txBody>
                </p:sp>
                <p:sp>
                  <p:nvSpPr>
                    <p:cNvPr id="14" name="TextBox 13">
                      <a:extLst>
                        <a:ext uri="{FF2B5EF4-FFF2-40B4-BE49-F238E27FC236}">
                          <a16:creationId xmlns:a16="http://schemas.microsoft.com/office/drawing/2014/main" id="{3CFAD8A4-D74F-B8AE-F557-3D5CA583D24C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2800908" y="6633994"/>
                      <a:ext cx="530062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liver</a:t>
                      </a:r>
                    </a:p>
                  </p:txBody>
                </p:sp>
                <p:sp>
                  <p:nvSpPr>
                    <p:cNvPr id="15" name="TextBox 14">
                      <a:extLst>
                        <a:ext uri="{FF2B5EF4-FFF2-40B4-BE49-F238E27FC236}">
                          <a16:creationId xmlns:a16="http://schemas.microsoft.com/office/drawing/2014/main" id="{C224D1BA-8780-1319-EE63-096B5C91E577}"/>
                        </a:ext>
                      </a:extLst>
                    </p:cNvPr>
                    <p:cNvSpPr txBox="1"/>
                    <p:nvPr/>
                  </p:nvSpPr>
                  <p:spPr>
                    <a:xfrm rot="19162583">
                      <a:off x="2952727" y="6690924"/>
                      <a:ext cx="624883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kidney</a:t>
                      </a:r>
                    </a:p>
                  </p:txBody>
                </p:sp>
                <p:sp>
                  <p:nvSpPr>
                    <p:cNvPr id="16" name="TextBox 15">
                      <a:extLst>
                        <a:ext uri="{FF2B5EF4-FFF2-40B4-BE49-F238E27FC236}">
                          <a16:creationId xmlns:a16="http://schemas.microsoft.com/office/drawing/2014/main" id="{CFBB548C-AB16-DB81-D004-B235CD7A3EAE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3779616" y="6632355"/>
                      <a:ext cx="566610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KO brain</a:t>
                      </a:r>
                    </a:p>
                  </p:txBody>
                </p:sp>
                <p:sp>
                  <p:nvSpPr>
                    <p:cNvPr id="17" name="TextBox 16">
                      <a:extLst>
                        <a:ext uri="{FF2B5EF4-FFF2-40B4-BE49-F238E27FC236}">
                          <a16:creationId xmlns:a16="http://schemas.microsoft.com/office/drawing/2014/main" id="{FE32AA55-EA98-1B30-85EF-137534FA6458}"/>
                        </a:ext>
                      </a:extLst>
                    </p:cNvPr>
                    <p:cNvSpPr txBox="1"/>
                    <p:nvPr/>
                  </p:nvSpPr>
                  <p:spPr>
                    <a:xfrm rot="19139913">
                      <a:off x="2016427" y="6667571"/>
                      <a:ext cx="579794" cy="5918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 heart</a:t>
                      </a:r>
                    </a:p>
                  </p:txBody>
                </p:sp>
              </p:grpSp>
            </p:grpSp>
          </p:grp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22343E0C-6676-3E7E-FA61-D26D513FCF16}"/>
                  </a:ext>
                </a:extLst>
              </p:cNvPr>
              <p:cNvGrpSpPr/>
              <p:nvPr/>
            </p:nvGrpSpPr>
            <p:grpSpPr>
              <a:xfrm>
                <a:off x="675446" y="3959225"/>
                <a:ext cx="340366" cy="1770398"/>
                <a:chOff x="675446" y="3959225"/>
                <a:chExt cx="340366" cy="1770398"/>
              </a:xfrm>
            </p:grpSpPr>
            <p:grpSp>
              <p:nvGrpSpPr>
                <p:cNvPr id="5" name="Group 4">
                  <a:extLst>
                    <a:ext uri="{FF2B5EF4-FFF2-40B4-BE49-F238E27FC236}">
                      <a16:creationId xmlns:a16="http://schemas.microsoft.com/office/drawing/2014/main" id="{C19D3A2E-7848-7AC3-E247-22981602ED99}"/>
                    </a:ext>
                  </a:extLst>
                </p:cNvPr>
                <p:cNvGrpSpPr/>
                <p:nvPr/>
              </p:nvGrpSpPr>
              <p:grpSpPr>
                <a:xfrm>
                  <a:off x="675446" y="3959225"/>
                  <a:ext cx="340366" cy="1770398"/>
                  <a:chOff x="526585" y="5043635"/>
                  <a:chExt cx="340366" cy="1770398"/>
                </a:xfrm>
              </p:grpSpPr>
              <p:sp>
                <p:nvSpPr>
                  <p:cNvPr id="6" name="TextBox 5">
                    <a:extLst>
                      <a:ext uri="{FF2B5EF4-FFF2-40B4-BE49-F238E27FC236}">
                        <a16:creationId xmlns:a16="http://schemas.microsoft.com/office/drawing/2014/main" id="{B13D78F9-DE48-BB35-95CD-D6BBE0D8C7D4}"/>
                      </a:ext>
                    </a:extLst>
                  </p:cNvPr>
                  <p:cNvSpPr txBox="1"/>
                  <p:nvPr/>
                </p:nvSpPr>
                <p:spPr>
                  <a:xfrm>
                    <a:off x="529922" y="5302084"/>
                    <a:ext cx="31960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0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457B0DD0-7D43-9DCC-ABD8-C00388249354}"/>
                      </a:ext>
                    </a:extLst>
                  </p:cNvPr>
                  <p:cNvSpPr txBox="1"/>
                  <p:nvPr/>
                </p:nvSpPr>
                <p:spPr>
                  <a:xfrm>
                    <a:off x="560518" y="5425595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7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798F3685-A03C-4F30-7AC3-91A842535A87}"/>
                      </a:ext>
                    </a:extLst>
                  </p:cNvPr>
                  <p:cNvSpPr txBox="1"/>
                  <p:nvPr/>
                </p:nvSpPr>
                <p:spPr>
                  <a:xfrm>
                    <a:off x="566434" y="5629896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B22DE8D9-C742-A991-DCF9-90328158ED58}"/>
                      </a:ext>
                    </a:extLst>
                  </p:cNvPr>
                  <p:cNvSpPr txBox="1"/>
                  <p:nvPr/>
                </p:nvSpPr>
                <p:spPr>
                  <a:xfrm>
                    <a:off x="547413" y="6609732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0DF8FD18-0D67-5474-4A80-4D7035CE84D1}"/>
                      </a:ext>
                    </a:extLst>
                  </p:cNvPr>
                  <p:cNvSpPr txBox="1"/>
                  <p:nvPr/>
                </p:nvSpPr>
                <p:spPr>
                  <a:xfrm>
                    <a:off x="526585" y="5165750"/>
                    <a:ext cx="340366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4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1AD0CEEA-5951-8488-949E-7EBEF15CB477}"/>
                      </a:ext>
                    </a:extLst>
                  </p:cNvPr>
                  <p:cNvSpPr txBox="1"/>
                  <p:nvPr/>
                </p:nvSpPr>
                <p:spPr>
                  <a:xfrm>
                    <a:off x="529684" y="5043635"/>
                    <a:ext cx="319606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6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" name="TextBox 25">
                    <a:extLst>
                      <a:ext uri="{FF2B5EF4-FFF2-40B4-BE49-F238E27FC236}">
                        <a16:creationId xmlns:a16="http://schemas.microsoft.com/office/drawing/2014/main" id="{2A85F30A-1E44-B456-34AA-79A2658568DF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847476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4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60DAFE18-4E22-493B-7618-19C7A8534387}"/>
                    </a:ext>
                  </a:extLst>
                </p:cNvPr>
                <p:cNvSpPr txBox="1"/>
                <p:nvPr/>
              </p:nvSpPr>
              <p:spPr>
                <a:xfrm>
                  <a:off x="705700" y="4919668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35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8D65A46E-930F-02C0-C9E4-98DDAD0C3314}"/>
                    </a:ext>
                  </a:extLst>
                </p:cNvPr>
                <p:cNvSpPr txBox="1"/>
                <p:nvPr/>
              </p:nvSpPr>
              <p:spPr>
                <a:xfrm>
                  <a:off x="705700" y="5151140"/>
                  <a:ext cx="277189" cy="2043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F0C88A4-F469-1CDC-68D7-0D9D2E7D4742}"/>
                </a:ext>
              </a:extLst>
            </p:cNvPr>
            <p:cNvSpPr txBox="1"/>
            <p:nvPr/>
          </p:nvSpPr>
          <p:spPr>
            <a:xfrm>
              <a:off x="782958" y="3737082"/>
              <a:ext cx="3196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7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kDa</a:t>
              </a:r>
              <a:endParaRPr lang="en-GB" sz="7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178349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>
            <a:extLst>
              <a:ext uri="{FF2B5EF4-FFF2-40B4-BE49-F238E27FC236}">
                <a16:creationId xmlns:a16="http://schemas.microsoft.com/office/drawing/2014/main" id="{247EC289-DDE7-EE5A-E93E-4B60E9512151}"/>
              </a:ext>
            </a:extLst>
          </p:cNvPr>
          <p:cNvSpPr txBox="1"/>
          <p:nvPr/>
        </p:nvSpPr>
        <p:spPr>
          <a:xfrm>
            <a:off x="584068" y="956912"/>
            <a:ext cx="6443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9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BEDDD08-DE52-524C-80EB-E2993C387634}"/>
              </a:ext>
            </a:extLst>
          </p:cNvPr>
          <p:cNvSpPr txBox="1"/>
          <p:nvPr/>
        </p:nvSpPr>
        <p:spPr>
          <a:xfrm>
            <a:off x="935035" y="7528743"/>
            <a:ext cx="363812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bodies: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α-tubulin, T5168 – Sigma Aldrich, 1:5000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1, monoclonal antibody previously described in Reference 89, 1:5000 </a:t>
            </a:r>
          </a:p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nti-DDAH2, ab184199 – Abcam, 1:100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0F43EA65-0451-27B5-C5D0-8E50DB3BE20B}"/>
              </a:ext>
            </a:extLst>
          </p:cNvPr>
          <p:cNvGrpSpPr/>
          <p:nvPr/>
        </p:nvGrpSpPr>
        <p:grpSpPr>
          <a:xfrm>
            <a:off x="795064" y="3429313"/>
            <a:ext cx="5988828" cy="2998852"/>
            <a:chOff x="795064" y="3429313"/>
            <a:chExt cx="5988828" cy="2998852"/>
          </a:xfrm>
        </p:grpSpPr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F9DF7B07-0EA6-2A10-D820-4BADBEF1DD3A}"/>
                </a:ext>
              </a:extLst>
            </p:cNvPr>
            <p:cNvGrpSpPr/>
            <p:nvPr/>
          </p:nvGrpSpPr>
          <p:grpSpPr>
            <a:xfrm>
              <a:off x="798009" y="3507997"/>
              <a:ext cx="5985883" cy="2920168"/>
              <a:chOff x="627494" y="3507997"/>
              <a:chExt cx="5985883" cy="2920168"/>
            </a:xfrm>
          </p:grpSpPr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91E1C32A-F3EB-6041-EA86-35DB73A24E22}"/>
                  </a:ext>
                </a:extLst>
              </p:cNvPr>
              <p:cNvGrpSpPr/>
              <p:nvPr/>
            </p:nvGrpSpPr>
            <p:grpSpPr>
              <a:xfrm>
                <a:off x="895498" y="3507997"/>
                <a:ext cx="5717879" cy="2920168"/>
                <a:chOff x="932011" y="3754896"/>
                <a:chExt cx="5717879" cy="2920168"/>
              </a:xfrm>
            </p:grpSpPr>
            <p:grpSp>
              <p:nvGrpSpPr>
                <p:cNvPr id="83" name="Group 82">
                  <a:extLst>
                    <a:ext uri="{FF2B5EF4-FFF2-40B4-BE49-F238E27FC236}">
                      <a16:creationId xmlns:a16="http://schemas.microsoft.com/office/drawing/2014/main" id="{79839255-0EE5-1655-82BC-2D72F4362F88}"/>
                    </a:ext>
                  </a:extLst>
                </p:cNvPr>
                <p:cNvGrpSpPr/>
                <p:nvPr/>
              </p:nvGrpSpPr>
              <p:grpSpPr>
                <a:xfrm>
                  <a:off x="3476293" y="6271125"/>
                  <a:ext cx="2679253" cy="383068"/>
                  <a:chOff x="1543927" y="6411572"/>
                  <a:chExt cx="3016701" cy="415097"/>
                </a:xfrm>
              </p:grpSpPr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E71C2F99-7779-F329-1A0F-EC4AFAA7BD0F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1543927" y="6411572"/>
                    <a:ext cx="1151477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liver</a:t>
                    </a:r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53195B66-651A-0FA5-BE82-B0CBDB679866}"/>
                      </a:ext>
                    </a:extLst>
                  </p:cNvPr>
                  <p:cNvSpPr txBox="1"/>
                  <p:nvPr/>
                </p:nvSpPr>
                <p:spPr>
                  <a:xfrm rot="19162583">
                    <a:off x="1720887" y="6456722"/>
                    <a:ext cx="1173835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kidney</a:t>
                    </a:r>
                  </a:p>
                </p:txBody>
              </p: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070E8EF6-F715-4A07-DD41-E879E9A4C829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2269618" y="6411800"/>
                    <a:ext cx="1151474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lung</a:t>
                    </a:r>
                  </a:p>
                </p:txBody>
              </p:sp>
              <p:sp>
                <p:nvSpPr>
                  <p:cNvPr id="87" name="TextBox 86">
                    <a:extLst>
                      <a:ext uri="{FF2B5EF4-FFF2-40B4-BE49-F238E27FC236}">
                        <a16:creationId xmlns:a16="http://schemas.microsoft.com/office/drawing/2014/main" id="{74D5C850-403C-93E9-6E93-33040D5945A6}"/>
                      </a:ext>
                    </a:extLst>
                  </p:cNvPr>
                  <p:cNvSpPr txBox="1"/>
                  <p:nvPr/>
                </p:nvSpPr>
                <p:spPr>
                  <a:xfrm rot="19162583">
                    <a:off x="2507207" y="6421439"/>
                    <a:ext cx="1173835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brain</a:t>
                    </a:r>
                  </a:p>
                </p:txBody>
              </p:sp>
              <p:sp>
                <p:nvSpPr>
                  <p:cNvPr id="88" name="TextBox 87">
                    <a:extLst>
                      <a:ext uri="{FF2B5EF4-FFF2-40B4-BE49-F238E27FC236}">
                        <a16:creationId xmlns:a16="http://schemas.microsoft.com/office/drawing/2014/main" id="{C8E37F80-4D80-9150-4322-FE0B244778BE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3496512" y="6509222"/>
                    <a:ext cx="825423" cy="2167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lung</a:t>
                    </a:r>
                  </a:p>
                </p:txBody>
              </p:sp>
              <p:sp>
                <p:nvSpPr>
                  <p:cNvPr id="89" name="TextBox 88">
                    <a:extLst>
                      <a:ext uri="{FF2B5EF4-FFF2-40B4-BE49-F238E27FC236}">
                        <a16:creationId xmlns:a16="http://schemas.microsoft.com/office/drawing/2014/main" id="{22AF33ED-9E64-78AE-8FDB-05DC8C27507E}"/>
                      </a:ext>
                    </a:extLst>
                  </p:cNvPr>
                  <p:cNvSpPr txBox="1"/>
                  <p:nvPr/>
                </p:nvSpPr>
                <p:spPr>
                  <a:xfrm rot="19162583">
                    <a:off x="3230906" y="6577363"/>
                    <a:ext cx="718302" cy="2167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heart</a:t>
                    </a:r>
                  </a:p>
                </p:txBody>
              </p:sp>
              <p:sp>
                <p:nvSpPr>
                  <p:cNvPr id="90" name="TextBox 89">
                    <a:extLst>
                      <a:ext uri="{FF2B5EF4-FFF2-40B4-BE49-F238E27FC236}">
                        <a16:creationId xmlns:a16="http://schemas.microsoft.com/office/drawing/2014/main" id="{7D2B3752-397A-E6D3-7883-54FD03D75CC6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2802002" y="6525175"/>
                    <a:ext cx="770026" cy="2167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liver</a:t>
                    </a:r>
                  </a:p>
                </p:txBody>
              </p:sp>
              <p:sp>
                <p:nvSpPr>
                  <p:cNvPr id="91" name="TextBox 90">
                    <a:extLst>
                      <a:ext uri="{FF2B5EF4-FFF2-40B4-BE49-F238E27FC236}">
                        <a16:creationId xmlns:a16="http://schemas.microsoft.com/office/drawing/2014/main" id="{2698128B-C0A4-5372-0485-0FC52A10C509}"/>
                      </a:ext>
                    </a:extLst>
                  </p:cNvPr>
                  <p:cNvSpPr txBox="1"/>
                  <p:nvPr/>
                </p:nvSpPr>
                <p:spPr>
                  <a:xfrm rot="19162583">
                    <a:off x="2979198" y="6609889"/>
                    <a:ext cx="682184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kidney</a:t>
                    </a:r>
                  </a:p>
                </p:txBody>
              </p:sp>
              <p:sp>
                <p:nvSpPr>
                  <p:cNvPr id="92" name="TextBox 91">
                    <a:extLst>
                      <a:ext uri="{FF2B5EF4-FFF2-40B4-BE49-F238E27FC236}">
                        <a16:creationId xmlns:a16="http://schemas.microsoft.com/office/drawing/2014/main" id="{3032FA2F-1034-5579-DCE1-FD27BB57C282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3731214" y="6525792"/>
                    <a:ext cx="829414" cy="2167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brain</a:t>
                    </a:r>
                  </a:p>
                </p:txBody>
              </p:sp>
              <p:sp>
                <p:nvSpPr>
                  <p:cNvPr id="93" name="TextBox 92">
                    <a:extLst>
                      <a:ext uri="{FF2B5EF4-FFF2-40B4-BE49-F238E27FC236}">
                        <a16:creationId xmlns:a16="http://schemas.microsoft.com/office/drawing/2014/main" id="{5D1818D1-3CFF-AFC5-778B-E8B50AB07E0C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2009580" y="6435636"/>
                    <a:ext cx="1151474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heart</a:t>
                    </a:r>
                  </a:p>
                </p:txBody>
              </p:sp>
            </p:grpSp>
            <p:grpSp>
              <p:nvGrpSpPr>
                <p:cNvPr id="35" name="Group 34">
                  <a:extLst>
                    <a:ext uri="{FF2B5EF4-FFF2-40B4-BE49-F238E27FC236}">
                      <a16:creationId xmlns:a16="http://schemas.microsoft.com/office/drawing/2014/main" id="{1D670758-33E0-952A-4C13-F018B62705F4}"/>
                    </a:ext>
                  </a:extLst>
                </p:cNvPr>
                <p:cNvGrpSpPr/>
                <p:nvPr/>
              </p:nvGrpSpPr>
              <p:grpSpPr>
                <a:xfrm>
                  <a:off x="932011" y="3754896"/>
                  <a:ext cx="5717879" cy="2689066"/>
                  <a:chOff x="-192978" y="3754896"/>
                  <a:chExt cx="5717879" cy="2689066"/>
                </a:xfrm>
              </p:grpSpPr>
              <p:grpSp>
                <p:nvGrpSpPr>
                  <p:cNvPr id="16" name="Group 15">
                    <a:extLst>
                      <a:ext uri="{FF2B5EF4-FFF2-40B4-BE49-F238E27FC236}">
                        <a16:creationId xmlns:a16="http://schemas.microsoft.com/office/drawing/2014/main" id="{841FE432-27E4-7EE4-B7B6-EB9F1EC3599F}"/>
                      </a:ext>
                    </a:extLst>
                  </p:cNvPr>
                  <p:cNvGrpSpPr/>
                  <p:nvPr/>
                </p:nvGrpSpPr>
                <p:grpSpPr>
                  <a:xfrm>
                    <a:off x="4931250" y="4352427"/>
                    <a:ext cx="593651" cy="1597953"/>
                    <a:chOff x="4996582" y="882779"/>
                    <a:chExt cx="687184" cy="1597953"/>
                  </a:xfrm>
                </p:grpSpPr>
                <p:grpSp>
                  <p:nvGrpSpPr>
                    <p:cNvPr id="82" name="Group 81">
                      <a:extLst>
                        <a:ext uri="{FF2B5EF4-FFF2-40B4-BE49-F238E27FC236}">
                          <a16:creationId xmlns:a16="http://schemas.microsoft.com/office/drawing/2014/main" id="{BF46D3E0-6A1D-4159-F941-22441A7D0AB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996582" y="882779"/>
                      <a:ext cx="687184" cy="1597953"/>
                      <a:chOff x="2405304" y="5239197"/>
                      <a:chExt cx="773733" cy="1731559"/>
                    </a:xfrm>
                  </p:grpSpPr>
                  <p:sp>
                    <p:nvSpPr>
                      <p:cNvPr id="94" name="TextBox 93">
                        <a:extLst>
                          <a:ext uri="{FF2B5EF4-FFF2-40B4-BE49-F238E27FC236}">
                            <a16:creationId xmlns:a16="http://schemas.microsoft.com/office/drawing/2014/main" id="{A517AD99-150B-172A-AE2F-F0646D066A7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405304" y="5239197"/>
                        <a:ext cx="655895" cy="21678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l-GR" sz="700" b="1" dirty="0">
                            <a:latin typeface="Arial Narrow" panose="020B0606020202030204" pitchFamily="34" charset="0"/>
                            <a:cs typeface="Arial" panose="020B0604020202020204" pitchFamily="34" charset="0"/>
                          </a:rPr>
                          <a:t>α</a:t>
                        </a:r>
                        <a:r>
                          <a:rPr lang="en-GB" sz="700" b="1" dirty="0">
                            <a:latin typeface="Arial Narrow" panose="020B0606020202030204" pitchFamily="34" charset="0"/>
                            <a:cs typeface="Arial" panose="020B0604020202020204" pitchFamily="34" charset="0"/>
                          </a:rPr>
                          <a:t>-tubulin</a:t>
                        </a:r>
                      </a:p>
                    </p:txBody>
                  </p:sp>
                  <p:sp>
                    <p:nvSpPr>
                      <p:cNvPr id="95" name="TextBox 94">
                        <a:extLst>
                          <a:ext uri="{FF2B5EF4-FFF2-40B4-BE49-F238E27FC236}">
                            <a16:creationId xmlns:a16="http://schemas.microsoft.com/office/drawing/2014/main" id="{889A4E58-E571-B291-D134-6C7FF05EADC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405304" y="6753974"/>
                        <a:ext cx="773733" cy="21678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700" b="1" dirty="0">
                            <a:latin typeface="Arial Narrow" panose="020B0606020202030204" pitchFamily="34" charset="0"/>
                            <a:cs typeface="Arial" panose="020B0604020202020204" pitchFamily="34" charset="0"/>
                          </a:rPr>
                          <a:t>DDAH2</a:t>
                        </a:r>
                      </a:p>
                    </p:txBody>
                  </p:sp>
                </p:grpSp>
                <p:sp>
                  <p:nvSpPr>
                    <p:cNvPr id="79" name="TextBox 78">
                      <a:extLst>
                        <a:ext uri="{FF2B5EF4-FFF2-40B4-BE49-F238E27FC236}">
                          <a16:creationId xmlns:a16="http://schemas.microsoft.com/office/drawing/2014/main" id="{BDAC29B9-8F5B-043D-BAC1-2CDF233D206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96590" y="1300627"/>
                      <a:ext cx="582519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</a:t>
                      </a:r>
                    </a:p>
                  </p:txBody>
                </p:sp>
              </p:grpSp>
              <p:grpSp>
                <p:nvGrpSpPr>
                  <p:cNvPr id="34" name="Group 33">
                    <a:extLst>
                      <a:ext uri="{FF2B5EF4-FFF2-40B4-BE49-F238E27FC236}">
                        <a16:creationId xmlns:a16="http://schemas.microsoft.com/office/drawing/2014/main" id="{06A55BA3-65E0-1ECF-7808-2B54621459CE}"/>
                      </a:ext>
                    </a:extLst>
                  </p:cNvPr>
                  <p:cNvGrpSpPr/>
                  <p:nvPr/>
                </p:nvGrpSpPr>
                <p:grpSpPr>
                  <a:xfrm>
                    <a:off x="2417797" y="3754896"/>
                    <a:ext cx="2479832" cy="2650659"/>
                    <a:chOff x="2417797" y="3754896"/>
                    <a:chExt cx="2479832" cy="2650659"/>
                  </a:xfrm>
                </p:grpSpPr>
                <p:pic>
                  <p:nvPicPr>
                    <p:cNvPr id="135" name="Picture 134" descr="A picture containing screenshot&#10;&#10;Description automatically generated">
                      <a:extLst>
                        <a:ext uri="{FF2B5EF4-FFF2-40B4-BE49-F238E27FC236}">
                          <a16:creationId xmlns:a16="http://schemas.microsoft.com/office/drawing/2014/main" id="{0660DEC8-5DA2-4ABD-B81A-221633648C5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1675" t="38274" r="23320" b="33100"/>
                    <a:stretch/>
                  </p:blipFill>
                  <p:spPr>
                    <a:xfrm>
                      <a:off x="2426186" y="5480123"/>
                      <a:ext cx="2471443" cy="925432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24" name="Picture 23" descr="A close-up of a pen&#10;&#10;Description automatically generated with medium confidence">
                      <a:extLst>
                        <a:ext uri="{FF2B5EF4-FFF2-40B4-BE49-F238E27FC236}">
                          <a16:creationId xmlns:a16="http://schemas.microsoft.com/office/drawing/2014/main" id="{977EADF1-BFC6-AE3E-8CD3-A8CC079F0C9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2932" t="14268" r="23752" b="58681"/>
                    <a:stretch/>
                  </p:blipFill>
                  <p:spPr>
                    <a:xfrm>
                      <a:off x="2417797" y="3754896"/>
                      <a:ext cx="2471443" cy="884454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28" name="Picture 27" descr="A picture containing text&#10;&#10;Description automatically generated">
                      <a:extLst>
                        <a:ext uri="{FF2B5EF4-FFF2-40B4-BE49-F238E27FC236}">
                          <a16:creationId xmlns:a16="http://schemas.microsoft.com/office/drawing/2014/main" id="{F8038689-B537-9367-27BF-84CCA72C7E5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9565" t="34622" r="16806" b="41834"/>
                    <a:stretch/>
                  </p:blipFill>
                  <p:spPr>
                    <a:xfrm>
                      <a:off x="2426186" y="4684406"/>
                      <a:ext cx="2463054" cy="745946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  <p:grpSp>
                <p:nvGrpSpPr>
                  <p:cNvPr id="33" name="Group 32">
                    <a:extLst>
                      <a:ext uri="{FF2B5EF4-FFF2-40B4-BE49-F238E27FC236}">
                        <a16:creationId xmlns:a16="http://schemas.microsoft.com/office/drawing/2014/main" id="{1E1AECB4-DFC2-5FA7-0282-0CC4F278AE33}"/>
                      </a:ext>
                    </a:extLst>
                  </p:cNvPr>
                  <p:cNvGrpSpPr/>
                  <p:nvPr/>
                </p:nvGrpSpPr>
                <p:grpSpPr>
                  <a:xfrm>
                    <a:off x="-192978" y="3764233"/>
                    <a:ext cx="2551168" cy="2679729"/>
                    <a:chOff x="-192978" y="3773859"/>
                    <a:chExt cx="2551168" cy="2679729"/>
                  </a:xfrm>
                </p:grpSpPr>
                <p:pic>
                  <p:nvPicPr>
                    <p:cNvPr id="11" name="Picture 10" descr="A white rectangular object on a black surface&#10;&#10;Description automatically generated with low confidence">
                      <a:extLst>
                        <a:ext uri="{FF2B5EF4-FFF2-40B4-BE49-F238E27FC236}">
                          <a16:creationId xmlns:a16="http://schemas.microsoft.com/office/drawing/2014/main" id="{2F93C682-6348-0D3F-A1D6-6166B578204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5012" t="31945" r="18971" b="38837"/>
                    <a:stretch/>
                  </p:blipFill>
                  <p:spPr>
                    <a:xfrm>
                      <a:off x="-192977" y="4633392"/>
                      <a:ext cx="2544282" cy="921605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13" name="Picture 12" descr="A white rectangular object on a black surface&#10;&#10;Description automatically generated with low confidence">
                      <a:extLst>
                        <a:ext uri="{FF2B5EF4-FFF2-40B4-BE49-F238E27FC236}">
                          <a16:creationId xmlns:a16="http://schemas.microsoft.com/office/drawing/2014/main" id="{978BCA0F-0700-F80D-CF99-97AD2A4CE1B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9542" t="17094" r="23265" b="54979"/>
                    <a:stretch/>
                  </p:blipFill>
                  <p:spPr>
                    <a:xfrm>
                      <a:off x="-192978" y="3773859"/>
                      <a:ext cx="2544282" cy="865491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32" name="Picture 31" descr="A picture containing electronics&#10;&#10;Description automatically generated">
                      <a:extLst>
                        <a:ext uri="{FF2B5EF4-FFF2-40B4-BE49-F238E27FC236}">
                          <a16:creationId xmlns:a16="http://schemas.microsoft.com/office/drawing/2014/main" id="{314A46D5-E668-3DCF-8617-737B49AEB52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4461" t="26319" r="19392" b="44313"/>
                    <a:stretch/>
                  </p:blipFill>
                  <p:spPr>
                    <a:xfrm>
                      <a:off x="-188528" y="5528156"/>
                      <a:ext cx="2546718" cy="925432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</p:grpSp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0AED081A-A208-566F-DA70-1466B4E77C05}"/>
                    </a:ext>
                  </a:extLst>
                </p:cNvPr>
                <p:cNvGrpSpPr/>
                <p:nvPr/>
              </p:nvGrpSpPr>
              <p:grpSpPr>
                <a:xfrm>
                  <a:off x="963170" y="6291996"/>
                  <a:ext cx="2679253" cy="383068"/>
                  <a:chOff x="1543927" y="6411572"/>
                  <a:chExt cx="3016701" cy="415097"/>
                </a:xfrm>
              </p:grpSpPr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82EED155-5517-74BF-B51A-34C5267992C5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1543927" y="6411572"/>
                    <a:ext cx="1151477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liver</a:t>
                    </a:r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A9DA7EB8-3945-6049-0AB5-81E9E0CE5C64}"/>
                      </a:ext>
                    </a:extLst>
                  </p:cNvPr>
                  <p:cNvSpPr txBox="1"/>
                  <p:nvPr/>
                </p:nvSpPr>
                <p:spPr>
                  <a:xfrm rot="19162583">
                    <a:off x="1720887" y="6456722"/>
                    <a:ext cx="1173835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kidney</a:t>
                    </a:r>
                  </a:p>
                </p:txBody>
              </p:sp>
              <p:sp>
                <p:nvSpPr>
                  <p:cNvPr id="40" name="TextBox 39">
                    <a:extLst>
                      <a:ext uri="{FF2B5EF4-FFF2-40B4-BE49-F238E27FC236}">
                        <a16:creationId xmlns:a16="http://schemas.microsoft.com/office/drawing/2014/main" id="{7800FBE0-36C5-B91E-E93F-47ED5C553DDF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2269618" y="6411800"/>
                    <a:ext cx="1151474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lung</a:t>
                    </a:r>
                  </a:p>
                </p:txBody>
              </p: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F921D409-734E-AB57-1877-BB5CC18F8ECB}"/>
                      </a:ext>
                    </a:extLst>
                  </p:cNvPr>
                  <p:cNvSpPr txBox="1"/>
                  <p:nvPr/>
                </p:nvSpPr>
                <p:spPr>
                  <a:xfrm rot="19162583">
                    <a:off x="2507207" y="6421439"/>
                    <a:ext cx="1173835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brain</a:t>
                    </a:r>
                  </a:p>
                </p:txBody>
              </p: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A6F1303F-F024-A01E-DB54-5AA50FA82D48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3496512" y="6509222"/>
                    <a:ext cx="825423" cy="2167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lung</a:t>
                    </a:r>
                  </a:p>
                </p:txBody>
              </p:sp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498CE096-5EB8-0BED-9D1F-43C10CA21913}"/>
                      </a:ext>
                    </a:extLst>
                  </p:cNvPr>
                  <p:cNvSpPr txBox="1"/>
                  <p:nvPr/>
                </p:nvSpPr>
                <p:spPr>
                  <a:xfrm rot="19162583">
                    <a:off x="3230906" y="6577363"/>
                    <a:ext cx="718302" cy="2167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heart</a:t>
                    </a:r>
                  </a:p>
                </p:txBody>
              </p:sp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0E8D2C04-2E3A-FA45-D5CA-F1846FCD95B4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2802002" y="6525175"/>
                    <a:ext cx="770026" cy="2167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liver</a:t>
                    </a:r>
                  </a:p>
                </p:txBody>
              </p: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F237EE7E-07EE-84D1-7F72-9AB50E2DE954}"/>
                      </a:ext>
                    </a:extLst>
                  </p:cNvPr>
                  <p:cNvSpPr txBox="1"/>
                  <p:nvPr/>
                </p:nvSpPr>
                <p:spPr>
                  <a:xfrm rot="19162583">
                    <a:off x="2979198" y="6609889"/>
                    <a:ext cx="682184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kidney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D5BE7873-AB90-D48E-30DC-980EC76B8ADB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3731214" y="6525792"/>
                    <a:ext cx="829414" cy="2167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KO brain</a:t>
                    </a:r>
                  </a:p>
                </p:txBody>
              </p:sp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9B02C871-78BB-0ABD-1081-0BA533DA0214}"/>
                      </a:ext>
                    </a:extLst>
                  </p:cNvPr>
                  <p:cNvSpPr txBox="1"/>
                  <p:nvPr/>
                </p:nvSpPr>
                <p:spPr>
                  <a:xfrm rot="19139913">
                    <a:off x="2009580" y="6435636"/>
                    <a:ext cx="1151474" cy="2167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WT heart</a:t>
                    </a:r>
                  </a:p>
                </p:txBody>
              </p:sp>
            </p:grpSp>
          </p:grpSp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F0550815-3D69-9914-1365-C0BC3C3068DD}"/>
                  </a:ext>
                </a:extLst>
              </p:cNvPr>
              <p:cNvGrpSpPr/>
              <p:nvPr/>
            </p:nvGrpSpPr>
            <p:grpSpPr>
              <a:xfrm>
                <a:off x="627494" y="3594826"/>
                <a:ext cx="321349" cy="2679257"/>
                <a:chOff x="627494" y="3594826"/>
                <a:chExt cx="321349" cy="2679257"/>
              </a:xfrm>
            </p:grpSpPr>
            <p:grpSp>
              <p:nvGrpSpPr>
                <p:cNvPr id="3" name="Group 2">
                  <a:extLst>
                    <a:ext uri="{FF2B5EF4-FFF2-40B4-BE49-F238E27FC236}">
                      <a16:creationId xmlns:a16="http://schemas.microsoft.com/office/drawing/2014/main" id="{B506A5C6-9F86-9731-1F9C-74FBA043E89B}"/>
                    </a:ext>
                  </a:extLst>
                </p:cNvPr>
                <p:cNvGrpSpPr/>
                <p:nvPr/>
              </p:nvGrpSpPr>
              <p:grpSpPr>
                <a:xfrm>
                  <a:off x="651242" y="5355478"/>
                  <a:ext cx="287783" cy="918605"/>
                  <a:chOff x="540299" y="5516028"/>
                  <a:chExt cx="287783" cy="918605"/>
                </a:xfrm>
              </p:grpSpPr>
              <p:sp>
                <p:nvSpPr>
                  <p:cNvPr id="5" name="TextBox 4">
                    <a:extLst>
                      <a:ext uri="{FF2B5EF4-FFF2-40B4-BE49-F238E27FC236}">
                        <a16:creationId xmlns:a16="http://schemas.microsoft.com/office/drawing/2014/main" id="{7C12DF10-8560-48BA-58B6-DB6E5D163659}"/>
                      </a:ext>
                    </a:extLst>
                  </p:cNvPr>
                  <p:cNvSpPr txBox="1"/>
                  <p:nvPr/>
                </p:nvSpPr>
                <p:spPr>
                  <a:xfrm>
                    <a:off x="540299" y="5516028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4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" name="TextBox 5">
                    <a:extLst>
                      <a:ext uri="{FF2B5EF4-FFF2-40B4-BE49-F238E27FC236}">
                        <a16:creationId xmlns:a16="http://schemas.microsoft.com/office/drawing/2014/main" id="{BC594971-9644-51F9-D43B-CEC74223EAD9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672434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" name="TextBox 6">
                    <a:extLst>
                      <a:ext uri="{FF2B5EF4-FFF2-40B4-BE49-F238E27FC236}">
                        <a16:creationId xmlns:a16="http://schemas.microsoft.com/office/drawing/2014/main" id="{8F7506E0-5621-B322-EF94-ACBF9A079848}"/>
                      </a:ext>
                    </a:extLst>
                  </p:cNvPr>
                  <p:cNvSpPr txBox="1"/>
                  <p:nvPr/>
                </p:nvSpPr>
                <p:spPr>
                  <a:xfrm>
                    <a:off x="540300" y="6230332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52E338D6-FD83-6154-242F-020A3FF6C37F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890341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2" name="Group 11">
                  <a:extLst>
                    <a:ext uri="{FF2B5EF4-FFF2-40B4-BE49-F238E27FC236}">
                      <a16:creationId xmlns:a16="http://schemas.microsoft.com/office/drawing/2014/main" id="{F0C14BED-554A-D7CF-F784-360DBF65A645}"/>
                    </a:ext>
                  </a:extLst>
                </p:cNvPr>
                <p:cNvGrpSpPr/>
                <p:nvPr/>
              </p:nvGrpSpPr>
              <p:grpSpPr>
                <a:xfrm>
                  <a:off x="645925" y="4461148"/>
                  <a:ext cx="287783" cy="597662"/>
                  <a:chOff x="540299" y="5516028"/>
                  <a:chExt cx="287783" cy="597662"/>
                </a:xfrm>
              </p:grpSpPr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DBBD49FF-BF65-C643-320B-500652624876}"/>
                      </a:ext>
                    </a:extLst>
                  </p:cNvPr>
                  <p:cNvSpPr txBox="1"/>
                  <p:nvPr/>
                </p:nvSpPr>
                <p:spPr>
                  <a:xfrm>
                    <a:off x="540299" y="5516028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4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D9C19F49-DED8-87D0-7B6C-25810BAA424F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24" y="5692681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DC44CD58-65F0-59D6-2165-4CDB59E8E188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93" y="5909389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7" name="Group 56">
                  <a:extLst>
                    <a:ext uri="{FF2B5EF4-FFF2-40B4-BE49-F238E27FC236}">
                      <a16:creationId xmlns:a16="http://schemas.microsoft.com/office/drawing/2014/main" id="{9C7F3640-5451-8FE6-EDA3-5114BECA1A17}"/>
                    </a:ext>
                  </a:extLst>
                </p:cNvPr>
                <p:cNvGrpSpPr/>
                <p:nvPr/>
              </p:nvGrpSpPr>
              <p:grpSpPr>
                <a:xfrm>
                  <a:off x="627494" y="3594826"/>
                  <a:ext cx="321349" cy="777146"/>
                  <a:chOff x="527941" y="5043635"/>
                  <a:chExt cx="321349" cy="777146"/>
                </a:xfrm>
              </p:grpSpPr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A44C8DCD-04F2-6BF0-D9CD-636D2E936314}"/>
                      </a:ext>
                    </a:extLst>
                  </p:cNvPr>
                  <p:cNvSpPr txBox="1"/>
                  <p:nvPr/>
                </p:nvSpPr>
                <p:spPr>
                  <a:xfrm>
                    <a:off x="527941" y="5307593"/>
                    <a:ext cx="319606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0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03D59587-4952-783A-F239-6841357495EC}"/>
                      </a:ext>
                    </a:extLst>
                  </p:cNvPr>
                  <p:cNvSpPr txBox="1"/>
                  <p:nvPr/>
                </p:nvSpPr>
                <p:spPr>
                  <a:xfrm>
                    <a:off x="556966" y="5394583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7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1F91FBEB-D0FE-4AF8-ADF9-300A75C14C6C}"/>
                      </a:ext>
                    </a:extLst>
                  </p:cNvPr>
                  <p:cNvSpPr txBox="1"/>
                  <p:nvPr/>
                </p:nvSpPr>
                <p:spPr>
                  <a:xfrm>
                    <a:off x="546205" y="5616480"/>
                    <a:ext cx="277189" cy="2043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836B13D7-DF26-FF4C-E58A-5CBC42DB8556}"/>
                      </a:ext>
                    </a:extLst>
                  </p:cNvPr>
                  <p:cNvSpPr txBox="1"/>
                  <p:nvPr/>
                </p:nvSpPr>
                <p:spPr>
                  <a:xfrm>
                    <a:off x="528395" y="5166789"/>
                    <a:ext cx="319606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14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5C37D43E-0D13-B310-2759-0E1430C7F0D8}"/>
                      </a:ext>
                    </a:extLst>
                  </p:cNvPr>
                  <p:cNvSpPr txBox="1"/>
                  <p:nvPr/>
                </p:nvSpPr>
                <p:spPr>
                  <a:xfrm>
                    <a:off x="529684" y="5043635"/>
                    <a:ext cx="319606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260</a:t>
                    </a:r>
                    <a:endPara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1D2B5C2-4F8A-B882-FCD5-12B4443777B3}"/>
                </a:ext>
              </a:extLst>
            </p:cNvPr>
            <p:cNvSpPr txBox="1"/>
            <p:nvPr/>
          </p:nvSpPr>
          <p:spPr>
            <a:xfrm>
              <a:off x="795064" y="3429313"/>
              <a:ext cx="3196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7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kDa</a:t>
              </a:r>
              <a:endParaRPr lang="en-GB" sz="7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417375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1EE0FBB-F83E-2768-E1E4-AA4170EEAB27}"/>
              </a:ext>
            </a:extLst>
          </p:cNvPr>
          <p:cNvSpPr txBox="1"/>
          <p:nvPr/>
        </p:nvSpPr>
        <p:spPr>
          <a:xfrm>
            <a:off x="584068" y="956912"/>
            <a:ext cx="6443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98235E8-5F34-E00A-2931-A47EAF147435}"/>
              </a:ext>
            </a:extLst>
          </p:cNvPr>
          <p:cNvGrpSpPr/>
          <p:nvPr/>
        </p:nvGrpSpPr>
        <p:grpSpPr>
          <a:xfrm>
            <a:off x="1622963" y="3266089"/>
            <a:ext cx="4335975" cy="3403984"/>
            <a:chOff x="1622963" y="3266089"/>
            <a:chExt cx="4335975" cy="3403984"/>
          </a:xfrm>
        </p:grpSpPr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4D72D5D1-BE3C-3C86-6194-17E16D08A417}"/>
                </a:ext>
              </a:extLst>
            </p:cNvPr>
            <p:cNvGrpSpPr/>
            <p:nvPr/>
          </p:nvGrpSpPr>
          <p:grpSpPr>
            <a:xfrm>
              <a:off x="1622963" y="3266089"/>
              <a:ext cx="4335975" cy="3403984"/>
              <a:chOff x="1661560" y="3266089"/>
              <a:chExt cx="4335975" cy="3403984"/>
            </a:xfrm>
          </p:grpSpPr>
          <p:pic>
            <p:nvPicPr>
              <p:cNvPr id="6" name="Picture 5" descr="A picture containing text, monitor, indoor, screen&#10;&#10;Description automatically generated">
                <a:extLst>
                  <a:ext uri="{FF2B5EF4-FFF2-40B4-BE49-F238E27FC236}">
                    <a16:creationId xmlns:a16="http://schemas.microsoft.com/office/drawing/2014/main" id="{4DA41FF0-4F38-D6C3-204C-FD5E544832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309" t="28803" r="21087" b="22949"/>
              <a:stretch/>
            </p:blipFill>
            <p:spPr>
              <a:xfrm>
                <a:off x="1930763" y="3505596"/>
                <a:ext cx="3573297" cy="25375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26857BC-2A3A-6B6A-2DE4-6F7C6DBB8ACF}"/>
                  </a:ext>
                </a:extLst>
              </p:cNvPr>
              <p:cNvSpPr txBox="1"/>
              <p:nvPr/>
            </p:nvSpPr>
            <p:spPr>
              <a:xfrm>
                <a:off x="2489610" y="3268403"/>
                <a:ext cx="147215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b="1" i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DDAH1</a:t>
                </a:r>
                <a:r>
                  <a: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 KO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4FFBDA0C-3855-19FE-975D-11286FF8F056}"/>
                  </a:ext>
                </a:extLst>
              </p:cNvPr>
              <p:cNvSpPr txBox="1"/>
              <p:nvPr/>
            </p:nvSpPr>
            <p:spPr>
              <a:xfrm>
                <a:off x="4251129" y="3266089"/>
                <a:ext cx="11093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b="1" i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DDAH2</a:t>
                </a:r>
                <a:r>
                  <a:rPr lang="en-GB" sz="7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 KO</a:t>
                </a:r>
              </a:p>
            </p:txBody>
          </p: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DFA9FEB5-32D6-D01E-C474-09FDA2B9D9CD}"/>
                  </a:ext>
                </a:extLst>
              </p:cNvPr>
              <p:cNvGrpSpPr/>
              <p:nvPr/>
            </p:nvGrpSpPr>
            <p:grpSpPr>
              <a:xfrm>
                <a:off x="2089431" y="6012416"/>
                <a:ext cx="3082911" cy="657657"/>
                <a:chOff x="1424637" y="2660820"/>
                <a:chExt cx="3082911" cy="657657"/>
              </a:xfrm>
            </p:grpSpPr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1A36DE5E-57C6-8548-860A-56059E7512EE}"/>
                    </a:ext>
                  </a:extLst>
                </p:cNvPr>
                <p:cNvGrpSpPr/>
                <p:nvPr/>
              </p:nvGrpSpPr>
              <p:grpSpPr>
                <a:xfrm>
                  <a:off x="1424637" y="2664304"/>
                  <a:ext cx="1353553" cy="654173"/>
                  <a:chOff x="1424637" y="2664304"/>
                  <a:chExt cx="1353553" cy="654173"/>
                </a:xfrm>
              </p:grpSpPr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D651F0F2-3D50-DF51-73A1-36B9F36A9C7A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1831074" y="2667275"/>
                    <a:ext cx="292388" cy="574962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2 KO 3</a:t>
                    </a:r>
                  </a:p>
                </p:txBody>
              </p:sp>
              <p:grpSp>
                <p:nvGrpSpPr>
                  <p:cNvPr id="25" name="Group 24">
                    <a:extLst>
                      <a:ext uri="{FF2B5EF4-FFF2-40B4-BE49-F238E27FC236}">
                        <a16:creationId xmlns:a16="http://schemas.microsoft.com/office/drawing/2014/main" id="{4F289651-7477-DF7B-D016-890415445EFC}"/>
                      </a:ext>
                    </a:extLst>
                  </p:cNvPr>
                  <p:cNvGrpSpPr/>
                  <p:nvPr/>
                </p:nvGrpSpPr>
                <p:grpSpPr>
                  <a:xfrm>
                    <a:off x="1424637" y="2664304"/>
                    <a:ext cx="1353553" cy="654173"/>
                    <a:chOff x="2462046" y="2205472"/>
                    <a:chExt cx="1474873" cy="712804"/>
                  </a:xfrm>
                </p:grpSpPr>
                <p:sp>
                  <p:nvSpPr>
                    <p:cNvPr id="26" name="TextBox 25">
                      <a:extLst>
                        <a:ext uri="{FF2B5EF4-FFF2-40B4-BE49-F238E27FC236}">
                          <a16:creationId xmlns:a16="http://schemas.microsoft.com/office/drawing/2014/main" id="{B851FB14-6A2A-AB8B-2478-5FBA2505513A}"/>
                        </a:ext>
                      </a:extLst>
                    </p:cNvPr>
                    <p:cNvSpPr txBox="1"/>
                    <p:nvPr/>
                  </p:nvSpPr>
                  <p:spPr>
                    <a:xfrm rot="2477009">
                      <a:off x="2462046" y="2236633"/>
                      <a:ext cx="318595" cy="299871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 anchor="b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p:txBody>
                </p:sp>
                <p:sp>
                  <p:nvSpPr>
                    <p:cNvPr id="27" name="TextBox 26">
                      <a:extLst>
                        <a:ext uri="{FF2B5EF4-FFF2-40B4-BE49-F238E27FC236}">
                          <a16:creationId xmlns:a16="http://schemas.microsoft.com/office/drawing/2014/main" id="{755F2C7C-C7D1-B344-1D3B-223B96562453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2504711" y="2234369"/>
                      <a:ext cx="318595" cy="597143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 anchor="b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2 KO 1</a:t>
                      </a:r>
                    </a:p>
                  </p:txBody>
                </p:sp>
                <p:sp>
                  <p:nvSpPr>
                    <p:cNvPr id="28" name="TextBox 27">
                      <a:extLst>
                        <a:ext uri="{FF2B5EF4-FFF2-40B4-BE49-F238E27FC236}">
                          <a16:creationId xmlns:a16="http://schemas.microsoft.com/office/drawing/2014/main" id="{B64014C3-4453-87E4-A33A-7C068929353D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2705586" y="2205472"/>
                      <a:ext cx="318595" cy="63193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2 KO 2</a:t>
                      </a:r>
                    </a:p>
                  </p:txBody>
                </p:sp>
                <p:sp>
                  <p:nvSpPr>
                    <p:cNvPr id="29" name="TextBox 28">
                      <a:extLst>
                        <a:ext uri="{FF2B5EF4-FFF2-40B4-BE49-F238E27FC236}">
                          <a16:creationId xmlns:a16="http://schemas.microsoft.com/office/drawing/2014/main" id="{CD56E283-1C34-286C-FC1A-ECE752225AF1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3067561" y="2231589"/>
                      <a:ext cx="318595" cy="603325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 KO 1</a:t>
                      </a:r>
                    </a:p>
                  </p:txBody>
                </p:sp>
                <p:sp>
                  <p:nvSpPr>
                    <p:cNvPr id="30" name="TextBox 29">
                      <a:extLst>
                        <a:ext uri="{FF2B5EF4-FFF2-40B4-BE49-F238E27FC236}">
                          <a16:creationId xmlns:a16="http://schemas.microsoft.com/office/drawing/2014/main" id="{A6537391-AE52-6ECD-5974-44F2D4CAD369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3261035" y="2221925"/>
                      <a:ext cx="318595" cy="610631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 anchor="b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 KO 2</a:t>
                      </a:r>
                    </a:p>
                  </p:txBody>
                </p:sp>
                <p:sp>
                  <p:nvSpPr>
                    <p:cNvPr id="31" name="TextBox 30">
                      <a:extLst>
                        <a:ext uri="{FF2B5EF4-FFF2-40B4-BE49-F238E27FC236}">
                          <a16:creationId xmlns:a16="http://schemas.microsoft.com/office/drawing/2014/main" id="{36BBD209-6E63-B875-5E80-F3090C00C8C2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3419434" y="2222029"/>
                      <a:ext cx="318595" cy="696247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+2 KO 1</a:t>
                      </a:r>
                    </a:p>
                  </p:txBody>
                </p:sp>
                <p:sp>
                  <p:nvSpPr>
                    <p:cNvPr id="32" name="TextBox 31">
                      <a:extLst>
                        <a:ext uri="{FF2B5EF4-FFF2-40B4-BE49-F238E27FC236}">
                          <a16:creationId xmlns:a16="http://schemas.microsoft.com/office/drawing/2014/main" id="{8E7AA7FA-45AE-F300-BEAE-E99A123D360D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3618324" y="2232377"/>
                      <a:ext cx="318595" cy="683162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+2 KO 2</a:t>
                      </a:r>
                    </a:p>
                  </p:txBody>
                </p:sp>
              </p:grpSp>
            </p:grpSp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E4C1CE17-11F2-FDBF-75F1-B5831B3CF4CB}"/>
                    </a:ext>
                  </a:extLst>
                </p:cNvPr>
                <p:cNvGrpSpPr/>
                <p:nvPr/>
              </p:nvGrpSpPr>
              <p:grpSpPr>
                <a:xfrm>
                  <a:off x="3150211" y="2660820"/>
                  <a:ext cx="1357337" cy="655597"/>
                  <a:chOff x="1417031" y="2660446"/>
                  <a:chExt cx="1357337" cy="655597"/>
                </a:xfrm>
              </p:grpSpPr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3EC0CDBC-BE79-DECA-9B06-F8378B222BED}"/>
                      </a:ext>
                    </a:extLst>
                  </p:cNvPr>
                  <p:cNvSpPr txBox="1"/>
                  <p:nvPr/>
                </p:nvSpPr>
                <p:spPr>
                  <a:xfrm rot="2496685">
                    <a:off x="1814534" y="2684894"/>
                    <a:ext cx="292388" cy="555727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DDAH2 KO 3</a:t>
                    </a:r>
                  </a:p>
                </p:txBody>
              </p:sp>
              <p:grpSp>
                <p:nvGrpSpPr>
                  <p:cNvPr id="16" name="Group 15">
                    <a:extLst>
                      <a:ext uri="{FF2B5EF4-FFF2-40B4-BE49-F238E27FC236}">
                        <a16:creationId xmlns:a16="http://schemas.microsoft.com/office/drawing/2014/main" id="{558EA02A-CD47-257D-E432-FCDD3B99AA7F}"/>
                      </a:ext>
                    </a:extLst>
                  </p:cNvPr>
                  <p:cNvGrpSpPr/>
                  <p:nvPr/>
                </p:nvGrpSpPr>
                <p:grpSpPr>
                  <a:xfrm>
                    <a:off x="1417031" y="2660446"/>
                    <a:ext cx="1357337" cy="655597"/>
                    <a:chOff x="2453758" y="2201289"/>
                    <a:chExt cx="1478996" cy="714360"/>
                  </a:xfrm>
                </p:grpSpPr>
                <p:sp>
                  <p:nvSpPr>
                    <p:cNvPr id="17" name="TextBox 16">
                      <a:extLst>
                        <a:ext uri="{FF2B5EF4-FFF2-40B4-BE49-F238E27FC236}">
                          <a16:creationId xmlns:a16="http://schemas.microsoft.com/office/drawing/2014/main" id="{E3DB4677-DD68-DC50-3E05-7849FFB682B4}"/>
                        </a:ext>
                      </a:extLst>
                    </p:cNvPr>
                    <p:cNvSpPr txBox="1"/>
                    <p:nvPr/>
                  </p:nvSpPr>
                  <p:spPr>
                    <a:xfrm rot="2477009">
                      <a:off x="2453758" y="2280444"/>
                      <a:ext cx="318595" cy="249042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 anchor="b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p:txBody>
                </p:sp>
                <p:sp>
                  <p:nvSpPr>
                    <p:cNvPr id="18" name="TextBox 17">
                      <a:extLst>
                        <a:ext uri="{FF2B5EF4-FFF2-40B4-BE49-F238E27FC236}">
                          <a16:creationId xmlns:a16="http://schemas.microsoft.com/office/drawing/2014/main" id="{57DA0EB6-17CD-1F95-D789-EDBA98D00E46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2521752" y="2224714"/>
                      <a:ext cx="318594" cy="608347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 anchor="b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2 KO 1</a:t>
                      </a:r>
                    </a:p>
                  </p:txBody>
                </p:sp>
                <p:sp>
                  <p:nvSpPr>
                    <p:cNvPr id="19" name="TextBox 18">
                      <a:extLst>
                        <a:ext uri="{FF2B5EF4-FFF2-40B4-BE49-F238E27FC236}">
                          <a16:creationId xmlns:a16="http://schemas.microsoft.com/office/drawing/2014/main" id="{4D7CE5F6-61C7-B32E-23DA-704D484C47D7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2708538" y="2201289"/>
                      <a:ext cx="318595" cy="637545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2 KO 2</a:t>
                      </a:r>
                    </a:p>
                  </p:txBody>
                </p:sp>
                <p:sp>
                  <p:nvSpPr>
                    <p:cNvPr id="20" name="TextBox 19">
                      <a:extLst>
                        <a:ext uri="{FF2B5EF4-FFF2-40B4-BE49-F238E27FC236}">
                          <a16:creationId xmlns:a16="http://schemas.microsoft.com/office/drawing/2014/main" id="{030EB7B2-AA9C-E7E4-5FF5-FDEF880F51E0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3078467" y="2232223"/>
                      <a:ext cx="318595" cy="601897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 KO 1</a:t>
                      </a:r>
                    </a:p>
                  </p:txBody>
                </p:sp>
                <p:sp>
                  <p:nvSpPr>
                    <p:cNvPr id="21" name="TextBox 20">
                      <a:extLst>
                        <a:ext uri="{FF2B5EF4-FFF2-40B4-BE49-F238E27FC236}">
                          <a16:creationId xmlns:a16="http://schemas.microsoft.com/office/drawing/2014/main" id="{6310BAB6-FC33-EC02-DF25-09D1AA2BF19C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3271852" y="2231185"/>
                      <a:ext cx="318595" cy="603081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 anchor="b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 KO 2</a:t>
                      </a:r>
                    </a:p>
                  </p:txBody>
                </p:sp>
                <p:sp>
                  <p:nvSpPr>
                    <p:cNvPr id="22" name="TextBox 21">
                      <a:extLst>
                        <a:ext uri="{FF2B5EF4-FFF2-40B4-BE49-F238E27FC236}">
                          <a16:creationId xmlns:a16="http://schemas.microsoft.com/office/drawing/2014/main" id="{15F8E9D7-A446-3707-ADE7-BEF7EFC64616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3425854" y="2240178"/>
                      <a:ext cx="318595" cy="675471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+2 KO 1</a:t>
                      </a:r>
                    </a:p>
                  </p:txBody>
                </p:sp>
                <p:sp>
                  <p:nvSpPr>
                    <p:cNvPr id="23" name="TextBox 22">
                      <a:extLst>
                        <a:ext uri="{FF2B5EF4-FFF2-40B4-BE49-F238E27FC236}">
                          <a16:creationId xmlns:a16="http://schemas.microsoft.com/office/drawing/2014/main" id="{E0C5546C-2DBD-28A1-9B48-120BA7D72EBB}"/>
                        </a:ext>
                      </a:extLst>
                    </p:cNvPr>
                    <p:cNvSpPr txBox="1"/>
                    <p:nvPr/>
                  </p:nvSpPr>
                  <p:spPr>
                    <a:xfrm rot="2496685">
                      <a:off x="3614159" y="2226660"/>
                      <a:ext cx="318595" cy="686647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GB" sz="70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DDAH1+2 KO 2</a:t>
                      </a:r>
                    </a:p>
                  </p:txBody>
                </p:sp>
              </p:grpSp>
            </p:grpSp>
          </p:grpSp>
          <p:grpSp>
            <p:nvGrpSpPr>
              <p:cNvPr id="51" name="Group 50">
                <a:extLst>
                  <a:ext uri="{FF2B5EF4-FFF2-40B4-BE49-F238E27FC236}">
                    <a16:creationId xmlns:a16="http://schemas.microsoft.com/office/drawing/2014/main" id="{DEAEEBEA-65D6-6745-3BE5-3BF26CAEEF35}"/>
                  </a:ext>
                </a:extLst>
              </p:cNvPr>
              <p:cNvGrpSpPr/>
              <p:nvPr/>
            </p:nvGrpSpPr>
            <p:grpSpPr>
              <a:xfrm>
                <a:off x="1661560" y="4513565"/>
                <a:ext cx="401597" cy="894078"/>
                <a:chOff x="1661560" y="4513565"/>
                <a:chExt cx="401597" cy="894078"/>
              </a:xfrm>
            </p:grpSpPr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D3A8996C-D427-B8C5-6FA5-DC633A751428}"/>
                    </a:ext>
                  </a:extLst>
                </p:cNvPr>
                <p:cNvGrpSpPr/>
                <p:nvPr/>
              </p:nvGrpSpPr>
              <p:grpSpPr>
                <a:xfrm>
                  <a:off x="1661560" y="4513565"/>
                  <a:ext cx="400089" cy="448250"/>
                  <a:chOff x="1072272" y="1232845"/>
                  <a:chExt cx="400089" cy="448250"/>
                </a:xfrm>
              </p:grpSpPr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F1786A75-CF0C-944B-6890-11D2773F1D81}"/>
                      </a:ext>
                    </a:extLst>
                  </p:cNvPr>
                  <p:cNvSpPr txBox="1"/>
                  <p:nvPr/>
                </p:nvSpPr>
                <p:spPr>
                  <a:xfrm>
                    <a:off x="1079098" y="1481040"/>
                    <a:ext cx="39326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00</a:t>
                    </a: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F0A89F4B-59D1-3C3F-F91E-79C9EFEF3A76}"/>
                      </a:ext>
                    </a:extLst>
                  </p:cNvPr>
                  <p:cNvSpPr txBox="1"/>
                  <p:nvPr/>
                </p:nvSpPr>
                <p:spPr>
                  <a:xfrm>
                    <a:off x="1072272" y="1232845"/>
                    <a:ext cx="32063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500</a:t>
                    </a:r>
                  </a:p>
                </p:txBody>
              </p:sp>
            </p:grp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DDFEF27E-37FE-6E03-71EB-089DD7578DAB}"/>
                    </a:ext>
                  </a:extLst>
                </p:cNvPr>
                <p:cNvSpPr txBox="1"/>
                <p:nvPr/>
              </p:nvSpPr>
              <p:spPr>
                <a:xfrm>
                  <a:off x="1661560" y="4968081"/>
                  <a:ext cx="39326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200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9FF0B3E2-267A-D97A-DF8F-8D7670816A77}"/>
                    </a:ext>
                  </a:extLst>
                </p:cNvPr>
                <p:cNvSpPr txBox="1"/>
                <p:nvPr/>
              </p:nvSpPr>
              <p:spPr>
                <a:xfrm>
                  <a:off x="1669894" y="5207588"/>
                  <a:ext cx="39326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106B4C5E-BBD4-B8C6-DE58-DFB1B992EE21}"/>
                    </a:ext>
                  </a:extLst>
                </p:cNvPr>
                <p:cNvSpPr txBox="1"/>
                <p:nvPr/>
              </p:nvSpPr>
              <p:spPr>
                <a:xfrm>
                  <a:off x="1661560" y="4606198"/>
                  <a:ext cx="39326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400</a:t>
                  </a:r>
                </a:p>
              </p:txBody>
            </p:sp>
          </p:grp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6AF5085E-2EEF-9A10-D5E4-E95B28C81350}"/>
                  </a:ext>
                </a:extLst>
              </p:cNvPr>
              <p:cNvGrpSpPr/>
              <p:nvPr/>
            </p:nvGrpSpPr>
            <p:grpSpPr>
              <a:xfrm>
                <a:off x="5473617" y="4574312"/>
                <a:ext cx="523918" cy="901345"/>
                <a:chOff x="5473617" y="4574312"/>
                <a:chExt cx="523918" cy="901345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B12A0452-F6B4-B8FB-DA29-E19E64555D75}"/>
                    </a:ext>
                  </a:extLst>
                </p:cNvPr>
                <p:cNvGrpSpPr/>
                <p:nvPr/>
              </p:nvGrpSpPr>
              <p:grpSpPr>
                <a:xfrm>
                  <a:off x="5473617" y="4674339"/>
                  <a:ext cx="523918" cy="331969"/>
                  <a:chOff x="4860476" y="1393619"/>
                  <a:chExt cx="523918" cy="331969"/>
                </a:xfrm>
              </p:grpSpPr>
              <p:sp>
                <p:nvSpPr>
                  <p:cNvPr id="37" name="TextBox 36">
                    <a:extLst>
                      <a:ext uri="{FF2B5EF4-FFF2-40B4-BE49-F238E27FC236}">
                        <a16:creationId xmlns:a16="http://schemas.microsoft.com/office/drawing/2014/main" id="{2F3362B6-A079-BAC9-4EB7-79D9796DCCDD}"/>
                      </a:ext>
                    </a:extLst>
                  </p:cNvPr>
                  <p:cNvSpPr txBox="1"/>
                  <p:nvPr/>
                </p:nvSpPr>
                <p:spPr>
                  <a:xfrm>
                    <a:off x="4860476" y="1393619"/>
                    <a:ext cx="523918" cy="2000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400</a:t>
                    </a:r>
                  </a:p>
                </p:txBody>
              </p:sp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7BB804C8-9B8E-3341-DF06-CF44B4B620AA}"/>
                      </a:ext>
                    </a:extLst>
                  </p:cNvPr>
                  <p:cNvSpPr txBox="1"/>
                  <p:nvPr/>
                </p:nvSpPr>
                <p:spPr>
                  <a:xfrm>
                    <a:off x="4867302" y="1525533"/>
                    <a:ext cx="42731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dirty="0">
                        <a:latin typeface="Arial Narrow" panose="020B0606020202030204" pitchFamily="34" charset="0"/>
                        <a:cs typeface="Arial" panose="020B0604020202020204" pitchFamily="34" charset="0"/>
                      </a:rPr>
                      <a:t>300</a:t>
                    </a:r>
                  </a:p>
                </p:txBody>
              </p:sp>
            </p:grp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3DB4BCDE-AC91-5749-AA9F-8C5A061A0E81}"/>
                    </a:ext>
                  </a:extLst>
                </p:cNvPr>
                <p:cNvSpPr txBox="1"/>
                <p:nvPr/>
              </p:nvSpPr>
              <p:spPr>
                <a:xfrm>
                  <a:off x="5473617" y="4574312"/>
                  <a:ext cx="523918" cy="2000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500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8FDC3F35-6774-93FE-A59C-3A38F0255EAC}"/>
                    </a:ext>
                  </a:extLst>
                </p:cNvPr>
                <p:cNvSpPr txBox="1"/>
                <p:nvPr/>
              </p:nvSpPr>
              <p:spPr>
                <a:xfrm>
                  <a:off x="5487269" y="5006308"/>
                  <a:ext cx="42731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200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CCE6EB90-4AFE-2EF8-73AF-CED4E6ADBEC0}"/>
                    </a:ext>
                  </a:extLst>
                </p:cNvPr>
                <p:cNvSpPr txBox="1"/>
                <p:nvPr/>
              </p:nvSpPr>
              <p:spPr>
                <a:xfrm>
                  <a:off x="5473617" y="5275602"/>
                  <a:ext cx="42731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</p:grp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7D60F34-7BCF-80E3-C3CF-643C7923987D}"/>
                </a:ext>
              </a:extLst>
            </p:cNvPr>
            <p:cNvSpPr txBox="1"/>
            <p:nvPr/>
          </p:nvSpPr>
          <p:spPr>
            <a:xfrm>
              <a:off x="1629788" y="4359826"/>
              <a:ext cx="3932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bp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57CF5798-911A-5E15-DA03-BFD67A3007C7}"/>
                </a:ext>
              </a:extLst>
            </p:cNvPr>
            <p:cNvSpPr txBox="1"/>
            <p:nvPr/>
          </p:nvSpPr>
          <p:spPr>
            <a:xfrm>
              <a:off x="5426346" y="4433141"/>
              <a:ext cx="3932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b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64037088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24</Words>
  <Application>Microsoft Office PowerPoint</Application>
  <PresentationFormat>Custom</PresentationFormat>
  <Paragraphs>237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Arial Narrow</vt:lpstr>
      <vt:lpstr>Calibri</vt:lpstr>
      <vt:lpstr>Calibri Light</vt:lpstr>
      <vt:lpstr>Тема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Алёна Козлова</dc:creator>
  <cp:lastModifiedBy>Vinitha Ragavan</cp:lastModifiedBy>
  <cp:revision>245</cp:revision>
  <dcterms:created xsi:type="dcterms:W3CDTF">2020-03-08T12:04:22Z</dcterms:created>
  <dcterms:modified xsi:type="dcterms:W3CDTF">2023-04-13T11:25:13Z</dcterms:modified>
</cp:coreProperties>
</file>